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5"/>
  </p:sldMasterIdLst>
  <p:notesMasterIdLst>
    <p:notesMasterId r:id="rId14"/>
  </p:notesMasterIdLst>
  <p:sldIdLst>
    <p:sldId id="257" r:id="rId6"/>
    <p:sldId id="280" r:id="rId7"/>
    <p:sldId id="273" r:id="rId8"/>
    <p:sldId id="281" r:id="rId9"/>
    <p:sldId id="279" r:id="rId10"/>
    <p:sldId id="282" r:id="rId11"/>
    <p:sldId id="272" r:id="rId12"/>
    <p:sldId id="283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F2B7F8B-8944-C990-0E18-12D304222145}" name="Yuan Liang" initials="YL" userId="S::qfm804@ku.dk::5c6f0a5c-df2b-438b-aca9-b90d06e7dc90" providerId="AD"/>
  <p188:author id="{7851CBB3-869B-67BA-6493-C39BAE0AD02B}" name="Amanda Seekings" initials="AS" userId="S::Amanda.Seekings@apha.gov.uk::6b110c03-99d0-4cce-a9d3-75045aa72821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eekings, Amanda" initials="SA" lastIdx="1" clrIdx="0">
    <p:extLst>
      <p:ext uri="{19B8F6BF-5375-455C-9EA6-DF929625EA0E}">
        <p15:presenceInfo xmlns:p15="http://schemas.microsoft.com/office/powerpoint/2012/main" userId="S::Amanda.Seekings@apha.gov.uk::6b110c03-99d0-4cce-a9d3-75045aa7282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D104C41-A6E1-4B32-8F5F-E264042463CE}" v="2" dt="2023-09-21T21:50:20.77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7013" autoAdjust="0"/>
  </p:normalViewPr>
  <p:slideViewPr>
    <p:cSldViewPr snapToGrid="0">
      <p:cViewPr>
        <p:scale>
          <a:sx n="60" d="100"/>
          <a:sy n="60" d="100"/>
        </p:scale>
        <p:origin x="1116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66" d="100"/>
          <a:sy n="66" d="100"/>
        </p:scale>
        <p:origin x="0" y="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21" Type="http://schemas.microsoft.com/office/2015/10/relationships/revisionInfo" Target="revisionInfo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1.xml"/><Relationship Id="rId15" Type="http://schemas.openxmlformats.org/officeDocument/2006/relationships/commentAuthors" Target="commentAuthors.xml"/><Relationship Id="rId10" Type="http://schemas.openxmlformats.org/officeDocument/2006/relationships/slide" Target="slides/slide5.xml"/><Relationship Id="rId19" Type="http://schemas.openxmlformats.org/officeDocument/2006/relationships/tableStyles" Target="tableStyles.xml"/><Relationship Id="rId4" Type="http://schemas.openxmlformats.org/officeDocument/2006/relationships/customXml" Target="../customXml/item4.xml"/><Relationship Id="rId9" Type="http://schemas.openxmlformats.org/officeDocument/2006/relationships/slide" Target="slides/slide4.xml"/><Relationship Id="rId14" Type="http://schemas.openxmlformats.org/officeDocument/2006/relationships/notesMaster" Target="notesMasters/notesMaster1.xml"/><Relationship Id="rId22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eekings, Amanda" userId="6b110c03-99d0-4cce-a9d3-75045aa72821" providerId="ADAL" clId="{64EE14C7-E102-4A22-8A02-45F51E9D6E3F}"/>
    <pc:docChg chg="undo custSel addSld delSld modSld sldOrd">
      <pc:chgData name="Seekings, Amanda" userId="6b110c03-99d0-4cce-a9d3-75045aa72821" providerId="ADAL" clId="{64EE14C7-E102-4A22-8A02-45F51E9D6E3F}" dt="2023-06-27T14:20:40.755" v="2282" actId="47"/>
      <pc:docMkLst>
        <pc:docMk/>
      </pc:docMkLst>
      <pc:sldChg chg="addSp delSp modSp del mod modNotesTx">
        <pc:chgData name="Seekings, Amanda" userId="6b110c03-99d0-4cce-a9d3-75045aa72821" providerId="ADAL" clId="{64EE14C7-E102-4A22-8A02-45F51E9D6E3F}" dt="2023-06-25T20:53:45.164" v="1821" actId="47"/>
        <pc:sldMkLst>
          <pc:docMk/>
          <pc:sldMk cId="2916354879" sldId="256"/>
        </pc:sldMkLst>
        <pc:graphicFrameChg chg="add mod">
          <ac:chgData name="Seekings, Amanda" userId="6b110c03-99d0-4cce-a9d3-75045aa72821" providerId="ADAL" clId="{64EE14C7-E102-4A22-8A02-45F51E9D6E3F}" dt="2023-06-21T09:53:08.185" v="216" actId="1076"/>
          <ac:graphicFrameMkLst>
            <pc:docMk/>
            <pc:sldMk cId="2916354879" sldId="256"/>
            <ac:graphicFrameMk id="3" creationId="{AB2F027F-5004-AC23-2E90-FA9E84C2348B}"/>
          </ac:graphicFrameMkLst>
        </pc:graphicFrameChg>
        <pc:graphicFrameChg chg="del">
          <ac:chgData name="Seekings, Amanda" userId="6b110c03-99d0-4cce-a9d3-75045aa72821" providerId="ADAL" clId="{64EE14C7-E102-4A22-8A02-45F51E9D6E3F}" dt="2023-06-21T09:53:00.770" v="214" actId="478"/>
          <ac:graphicFrameMkLst>
            <pc:docMk/>
            <pc:sldMk cId="2916354879" sldId="256"/>
            <ac:graphicFrameMk id="5" creationId="{38E64A6B-753E-495F-9CE9-29C5EE624DBF}"/>
          </ac:graphicFrameMkLst>
        </pc:graphicFrameChg>
      </pc:sldChg>
      <pc:sldChg chg="modNotesTx">
        <pc:chgData name="Seekings, Amanda" userId="6b110c03-99d0-4cce-a9d3-75045aa72821" providerId="ADAL" clId="{64EE14C7-E102-4A22-8A02-45F51E9D6E3F}" dt="2023-06-21T13:06:00.729" v="793" actId="20577"/>
        <pc:sldMkLst>
          <pc:docMk/>
          <pc:sldMk cId="1209839087" sldId="257"/>
        </pc:sldMkLst>
      </pc:sldChg>
      <pc:sldChg chg="modSp del modNotesTx">
        <pc:chgData name="Seekings, Amanda" userId="6b110c03-99d0-4cce-a9d3-75045aa72821" providerId="ADAL" clId="{64EE14C7-E102-4A22-8A02-45F51E9D6E3F}" dt="2023-06-25T20:53:47.018" v="1822" actId="47"/>
        <pc:sldMkLst>
          <pc:docMk/>
          <pc:sldMk cId="646656544" sldId="258"/>
        </pc:sldMkLst>
        <pc:graphicFrameChg chg="mod">
          <ac:chgData name="Seekings, Amanda" userId="6b110c03-99d0-4cce-a9d3-75045aa72821" providerId="ADAL" clId="{64EE14C7-E102-4A22-8A02-45F51E9D6E3F}" dt="2023-06-21T09:53:47.270" v="220"/>
          <ac:graphicFrameMkLst>
            <pc:docMk/>
            <pc:sldMk cId="646656544" sldId="258"/>
            <ac:graphicFrameMk id="4" creationId="{7B456E8A-043D-45D8-A55C-5B3515D685DE}"/>
          </ac:graphicFrameMkLst>
        </pc:graphicFrameChg>
        <pc:graphicFrameChg chg="mod">
          <ac:chgData name="Seekings, Amanda" userId="6b110c03-99d0-4cce-a9d3-75045aa72821" providerId="ADAL" clId="{64EE14C7-E102-4A22-8A02-45F51E9D6E3F}" dt="2023-06-21T09:47:33.261" v="177"/>
          <ac:graphicFrameMkLst>
            <pc:docMk/>
            <pc:sldMk cId="646656544" sldId="258"/>
            <ac:graphicFrameMk id="7" creationId="{F9356F77-A241-445F-B5A1-77323FF3FBFE}"/>
          </ac:graphicFrameMkLst>
        </pc:graphicFrameChg>
      </pc:sldChg>
      <pc:sldChg chg="addSp modSp mod modNotesTx">
        <pc:chgData name="Seekings, Amanda" userId="6b110c03-99d0-4cce-a9d3-75045aa72821" providerId="ADAL" clId="{64EE14C7-E102-4A22-8A02-45F51E9D6E3F}" dt="2023-06-25T20:53:59.577" v="1828" actId="20577"/>
        <pc:sldMkLst>
          <pc:docMk/>
          <pc:sldMk cId="1506255048" sldId="262"/>
        </pc:sldMkLst>
        <pc:picChg chg="mod">
          <ac:chgData name="Seekings, Amanda" userId="6b110c03-99d0-4cce-a9d3-75045aa72821" providerId="ADAL" clId="{64EE14C7-E102-4A22-8A02-45F51E9D6E3F}" dt="2023-06-21T10:30:29.025" v="515" actId="1076"/>
          <ac:picMkLst>
            <pc:docMk/>
            <pc:sldMk cId="1506255048" sldId="262"/>
            <ac:picMk id="12" creationId="{00000000-0000-0000-0000-000000000000}"/>
          </ac:picMkLst>
        </pc:picChg>
        <pc:picChg chg="mod modCrop">
          <ac:chgData name="Seekings, Amanda" userId="6b110c03-99d0-4cce-a9d3-75045aa72821" providerId="ADAL" clId="{64EE14C7-E102-4A22-8A02-45F51E9D6E3F}" dt="2023-06-21T10:31:02.749" v="523" actId="1076"/>
          <ac:picMkLst>
            <pc:docMk/>
            <pc:sldMk cId="1506255048" sldId="262"/>
            <ac:picMk id="13" creationId="{00000000-0000-0000-0000-000000000000}"/>
          </ac:picMkLst>
        </pc:picChg>
        <pc:picChg chg="add mod modCrop">
          <ac:chgData name="Seekings, Amanda" userId="6b110c03-99d0-4cce-a9d3-75045aa72821" providerId="ADAL" clId="{64EE14C7-E102-4A22-8A02-45F51E9D6E3F}" dt="2023-06-21T10:30:42.195" v="519" actId="732"/>
          <ac:picMkLst>
            <pc:docMk/>
            <pc:sldMk cId="1506255048" sldId="262"/>
            <ac:picMk id="14" creationId="{AADA6DC1-B87A-DB3B-3D60-7B99765F90A6}"/>
          </ac:picMkLst>
        </pc:picChg>
        <pc:picChg chg="add mod">
          <ac:chgData name="Seekings, Amanda" userId="6b110c03-99d0-4cce-a9d3-75045aa72821" providerId="ADAL" clId="{64EE14C7-E102-4A22-8A02-45F51E9D6E3F}" dt="2023-06-21T10:30:50.556" v="521" actId="1076"/>
          <ac:picMkLst>
            <pc:docMk/>
            <pc:sldMk cId="1506255048" sldId="262"/>
            <ac:picMk id="15" creationId="{8A4C2037-975F-7B2D-E4EC-24DEC121787A}"/>
          </ac:picMkLst>
        </pc:picChg>
      </pc:sldChg>
      <pc:sldChg chg="modNotesTx">
        <pc:chgData name="Seekings, Amanda" userId="6b110c03-99d0-4cce-a9d3-75045aa72821" providerId="ADAL" clId="{64EE14C7-E102-4A22-8A02-45F51E9D6E3F}" dt="2023-06-25T20:53:55.837" v="1826" actId="20577"/>
        <pc:sldMkLst>
          <pc:docMk/>
          <pc:sldMk cId="3646838560" sldId="264"/>
        </pc:sldMkLst>
      </pc:sldChg>
      <pc:sldChg chg="addSp modSp mod modNotesTx">
        <pc:chgData name="Seekings, Amanda" userId="6b110c03-99d0-4cce-a9d3-75045aa72821" providerId="ADAL" clId="{64EE14C7-E102-4A22-8A02-45F51E9D6E3F}" dt="2023-06-25T20:54:02.798" v="1830" actId="20577"/>
        <pc:sldMkLst>
          <pc:docMk/>
          <pc:sldMk cId="3612318088" sldId="266"/>
        </pc:sldMkLst>
        <pc:picChg chg="add mod">
          <ac:chgData name="Seekings, Amanda" userId="6b110c03-99d0-4cce-a9d3-75045aa72821" providerId="ADAL" clId="{64EE14C7-E102-4A22-8A02-45F51E9D6E3F}" dt="2023-06-21T10:31:11.237" v="525" actId="1076"/>
          <ac:picMkLst>
            <pc:docMk/>
            <pc:sldMk cId="3612318088" sldId="266"/>
            <ac:picMk id="8" creationId="{9D61DE35-093A-BBF5-B04C-D05B4E3C70A1}"/>
          </ac:picMkLst>
        </pc:picChg>
        <pc:picChg chg="mod modCrop">
          <ac:chgData name="Seekings, Amanda" userId="6b110c03-99d0-4cce-a9d3-75045aa72821" providerId="ADAL" clId="{64EE14C7-E102-4A22-8A02-45F51E9D6E3F}" dt="2023-06-21T10:31:35.880" v="532" actId="1076"/>
          <ac:picMkLst>
            <pc:docMk/>
            <pc:sldMk cId="3612318088" sldId="266"/>
            <ac:picMk id="15" creationId="{00000000-0000-0000-0000-000000000000}"/>
          </ac:picMkLst>
        </pc:picChg>
        <pc:picChg chg="mod modCrop">
          <ac:chgData name="Seekings, Amanda" userId="6b110c03-99d0-4cce-a9d3-75045aa72821" providerId="ADAL" clId="{64EE14C7-E102-4A22-8A02-45F51E9D6E3F}" dt="2023-06-21T10:31:34.100" v="531" actId="1076"/>
          <ac:picMkLst>
            <pc:docMk/>
            <pc:sldMk cId="3612318088" sldId="266"/>
            <ac:picMk id="16" creationId="{00000000-0000-0000-0000-000000000000}"/>
          </ac:picMkLst>
        </pc:picChg>
        <pc:picChg chg="add mod">
          <ac:chgData name="Seekings, Amanda" userId="6b110c03-99d0-4cce-a9d3-75045aa72821" providerId="ADAL" clId="{64EE14C7-E102-4A22-8A02-45F51E9D6E3F}" dt="2023-06-21T10:31:25.232" v="529" actId="1076"/>
          <ac:picMkLst>
            <pc:docMk/>
            <pc:sldMk cId="3612318088" sldId="266"/>
            <ac:picMk id="17" creationId="{D0865505-8D8A-7865-D52D-B4AED090F115}"/>
          </ac:picMkLst>
        </pc:picChg>
      </pc:sldChg>
      <pc:sldChg chg="addSp delSp modSp del mod">
        <pc:chgData name="Seekings, Amanda" userId="6b110c03-99d0-4cce-a9d3-75045aa72821" providerId="ADAL" clId="{64EE14C7-E102-4A22-8A02-45F51E9D6E3F}" dt="2023-06-25T20:43:22.420" v="1802" actId="47"/>
        <pc:sldMkLst>
          <pc:docMk/>
          <pc:sldMk cId="1324013386" sldId="267"/>
        </pc:sldMkLst>
        <pc:spChg chg="mod">
          <ac:chgData name="Seekings, Amanda" userId="6b110c03-99d0-4cce-a9d3-75045aa72821" providerId="ADAL" clId="{64EE14C7-E102-4A22-8A02-45F51E9D6E3F}" dt="2023-06-25T20:38:04.643" v="1703" actId="1076"/>
          <ac:spMkLst>
            <pc:docMk/>
            <pc:sldMk cId="1324013386" sldId="267"/>
            <ac:spMk id="2" creationId="{8BDD44AA-39F7-40D6-48C8-C30DAF1D35F7}"/>
          </ac:spMkLst>
        </pc:spChg>
        <pc:spChg chg="mod">
          <ac:chgData name="Seekings, Amanda" userId="6b110c03-99d0-4cce-a9d3-75045aa72821" providerId="ADAL" clId="{64EE14C7-E102-4A22-8A02-45F51E9D6E3F}" dt="2023-06-25T20:38:04.643" v="1703" actId="1076"/>
          <ac:spMkLst>
            <pc:docMk/>
            <pc:sldMk cId="1324013386" sldId="267"/>
            <ac:spMk id="3" creationId="{6E9F5AC0-F1C4-B4E6-635F-7A2229FAB3A8}"/>
          </ac:spMkLst>
        </pc:spChg>
        <pc:spChg chg="mod">
          <ac:chgData name="Seekings, Amanda" userId="6b110c03-99d0-4cce-a9d3-75045aa72821" providerId="ADAL" clId="{64EE14C7-E102-4A22-8A02-45F51E9D6E3F}" dt="2023-06-25T20:38:04.643" v="1703" actId="1076"/>
          <ac:spMkLst>
            <pc:docMk/>
            <pc:sldMk cId="1324013386" sldId="267"/>
            <ac:spMk id="4" creationId="{4A0BD38A-0B81-A6E0-8B6A-09C1323FE6CB}"/>
          </ac:spMkLst>
        </pc:spChg>
        <pc:spChg chg="mod">
          <ac:chgData name="Seekings, Amanda" userId="6b110c03-99d0-4cce-a9d3-75045aa72821" providerId="ADAL" clId="{64EE14C7-E102-4A22-8A02-45F51E9D6E3F}" dt="2023-06-25T20:38:04.643" v="1703" actId="1076"/>
          <ac:spMkLst>
            <pc:docMk/>
            <pc:sldMk cId="1324013386" sldId="267"/>
            <ac:spMk id="6" creationId="{F5F2C722-93B7-ABCE-509B-D5AC5D4CE9F6}"/>
          </ac:spMkLst>
        </pc:spChg>
        <pc:picChg chg="mod">
          <ac:chgData name="Seekings, Amanda" userId="6b110c03-99d0-4cce-a9d3-75045aa72821" providerId="ADAL" clId="{64EE14C7-E102-4A22-8A02-45F51E9D6E3F}" dt="2023-06-25T20:38:04.643" v="1703" actId="1076"/>
          <ac:picMkLst>
            <pc:docMk/>
            <pc:sldMk cId="1324013386" sldId="267"/>
            <ac:picMk id="5" creationId="{7DA9C366-2DF3-4326-AC19-BC916A7BBC16}"/>
          </ac:picMkLst>
        </pc:picChg>
        <pc:picChg chg="mod">
          <ac:chgData name="Seekings, Amanda" userId="6b110c03-99d0-4cce-a9d3-75045aa72821" providerId="ADAL" clId="{64EE14C7-E102-4A22-8A02-45F51E9D6E3F}" dt="2023-06-25T20:38:04.643" v="1703" actId="1076"/>
          <ac:picMkLst>
            <pc:docMk/>
            <pc:sldMk cId="1324013386" sldId="267"/>
            <ac:picMk id="7" creationId="{BE668DA5-1187-4705-9B7F-3EBA44AB4A68}"/>
          </ac:picMkLst>
        </pc:picChg>
        <pc:picChg chg="add del mod">
          <ac:chgData name="Seekings, Amanda" userId="6b110c03-99d0-4cce-a9d3-75045aa72821" providerId="ADAL" clId="{64EE14C7-E102-4A22-8A02-45F51E9D6E3F}" dt="2023-06-25T20:38:03.473" v="1702"/>
          <ac:picMkLst>
            <pc:docMk/>
            <pc:sldMk cId="1324013386" sldId="267"/>
            <ac:picMk id="8" creationId="{70E84D97-3CAB-A27F-7B42-D1E39687DE10}"/>
          </ac:picMkLst>
        </pc:picChg>
      </pc:sldChg>
      <pc:sldChg chg="del ord modNotesTx">
        <pc:chgData name="Seekings, Amanda" userId="6b110c03-99d0-4cce-a9d3-75045aa72821" providerId="ADAL" clId="{64EE14C7-E102-4A22-8A02-45F51E9D6E3F}" dt="2023-06-27T08:23:57.808" v="2137" actId="47"/>
        <pc:sldMkLst>
          <pc:docMk/>
          <pc:sldMk cId="3891349692" sldId="269"/>
        </pc:sldMkLst>
      </pc:sldChg>
      <pc:sldChg chg="modNotesTx">
        <pc:chgData name="Seekings, Amanda" userId="6b110c03-99d0-4cce-a9d3-75045aa72821" providerId="ADAL" clId="{64EE14C7-E102-4A22-8A02-45F51E9D6E3F}" dt="2023-06-26T16:43:41.101" v="2044" actId="20577"/>
        <pc:sldMkLst>
          <pc:docMk/>
          <pc:sldMk cId="1557565970" sldId="272"/>
        </pc:sldMkLst>
      </pc:sldChg>
      <pc:sldChg chg="addSp modSp mod modNotesTx">
        <pc:chgData name="Seekings, Amanda" userId="6b110c03-99d0-4cce-a9d3-75045aa72821" providerId="ADAL" clId="{64EE14C7-E102-4A22-8A02-45F51E9D6E3F}" dt="2023-06-27T14:20:20.358" v="2281" actId="20577"/>
        <pc:sldMkLst>
          <pc:docMk/>
          <pc:sldMk cId="354898960" sldId="273"/>
        </pc:sldMkLst>
        <pc:spChg chg="add mod">
          <ac:chgData name="Seekings, Amanda" userId="6b110c03-99d0-4cce-a9d3-75045aa72821" providerId="ADAL" clId="{64EE14C7-E102-4A22-8A02-45F51E9D6E3F}" dt="2023-06-27T08:44:46.036" v="2231" actId="1076"/>
          <ac:spMkLst>
            <pc:docMk/>
            <pc:sldMk cId="354898960" sldId="273"/>
            <ac:spMk id="2" creationId="{F714E8B2-AEB6-48CE-43E3-C7CB8A1E22D5}"/>
          </ac:spMkLst>
        </pc:spChg>
        <pc:spChg chg="add mod">
          <ac:chgData name="Seekings, Amanda" userId="6b110c03-99d0-4cce-a9d3-75045aa72821" providerId="ADAL" clId="{64EE14C7-E102-4A22-8A02-45F51E9D6E3F}" dt="2023-06-27T08:44:33.074" v="2218" actId="1076"/>
          <ac:spMkLst>
            <pc:docMk/>
            <pc:sldMk cId="354898960" sldId="273"/>
            <ac:spMk id="3" creationId="{16DC1167-866C-E6CF-23CB-D2705AA42B19}"/>
          </ac:spMkLst>
        </pc:spChg>
        <pc:spChg chg="mod">
          <ac:chgData name="Seekings, Amanda" userId="6b110c03-99d0-4cce-a9d3-75045aa72821" providerId="ADAL" clId="{64EE14C7-E102-4A22-8A02-45F51E9D6E3F}" dt="2023-06-27T08:44:41.827" v="2230" actId="1038"/>
          <ac:spMkLst>
            <pc:docMk/>
            <pc:sldMk cId="354898960" sldId="273"/>
            <ac:spMk id="7" creationId="{E3BBDE6A-5AB7-BC9F-3270-35D9C9590ECF}"/>
          </ac:spMkLst>
        </pc:spChg>
        <pc:spChg chg="mod">
          <ac:chgData name="Seekings, Amanda" userId="6b110c03-99d0-4cce-a9d3-75045aa72821" providerId="ADAL" clId="{64EE14C7-E102-4A22-8A02-45F51E9D6E3F}" dt="2023-06-27T08:44:41.827" v="2230" actId="1038"/>
          <ac:spMkLst>
            <pc:docMk/>
            <pc:sldMk cId="354898960" sldId="273"/>
            <ac:spMk id="9" creationId="{3D4147AE-D002-E7D7-B8F4-73F49924E8D0}"/>
          </ac:spMkLst>
        </pc:spChg>
        <pc:spChg chg="mod">
          <ac:chgData name="Seekings, Amanda" userId="6b110c03-99d0-4cce-a9d3-75045aa72821" providerId="ADAL" clId="{64EE14C7-E102-4A22-8A02-45F51E9D6E3F}" dt="2023-06-27T08:44:59.121" v="2251" actId="1037"/>
          <ac:spMkLst>
            <pc:docMk/>
            <pc:sldMk cId="354898960" sldId="273"/>
            <ac:spMk id="11" creationId="{C4CDED69-8C28-D9C4-1AE3-17C952652E7D}"/>
          </ac:spMkLst>
        </pc:spChg>
        <pc:spChg chg="mod">
          <ac:chgData name="Seekings, Amanda" userId="6b110c03-99d0-4cce-a9d3-75045aa72821" providerId="ADAL" clId="{64EE14C7-E102-4A22-8A02-45F51E9D6E3F}" dt="2023-06-27T08:44:59.121" v="2251" actId="1037"/>
          <ac:spMkLst>
            <pc:docMk/>
            <pc:sldMk cId="354898960" sldId="273"/>
            <ac:spMk id="13" creationId="{9B6CCE99-F4BA-B3D8-9F03-D7C00355D2C4}"/>
          </ac:spMkLst>
        </pc:spChg>
        <pc:spChg chg="mod">
          <ac:chgData name="Seekings, Amanda" userId="6b110c03-99d0-4cce-a9d3-75045aa72821" providerId="ADAL" clId="{64EE14C7-E102-4A22-8A02-45F51E9D6E3F}" dt="2023-06-27T08:44:59.121" v="2251" actId="1037"/>
          <ac:spMkLst>
            <pc:docMk/>
            <pc:sldMk cId="354898960" sldId="273"/>
            <ac:spMk id="16" creationId="{16BB22C4-A13F-EDA2-608A-7A871D6A821A}"/>
          </ac:spMkLst>
        </pc:spChg>
        <pc:spChg chg="add mod">
          <ac:chgData name="Seekings, Amanda" userId="6b110c03-99d0-4cce-a9d3-75045aa72821" providerId="ADAL" clId="{64EE14C7-E102-4A22-8A02-45F51E9D6E3F}" dt="2023-06-27T09:01:37.365" v="2273" actId="1076"/>
          <ac:spMkLst>
            <pc:docMk/>
            <pc:sldMk cId="354898960" sldId="273"/>
            <ac:spMk id="18" creationId="{2AA77D4F-FA6B-2CF6-17B3-2732D392C078}"/>
          </ac:spMkLst>
        </pc:spChg>
        <pc:grpChg chg="add mod">
          <ac:chgData name="Seekings, Amanda" userId="6b110c03-99d0-4cce-a9d3-75045aa72821" providerId="ADAL" clId="{64EE14C7-E102-4A22-8A02-45F51E9D6E3F}" dt="2023-06-27T08:44:35.411" v="2219" actId="1076"/>
          <ac:grpSpMkLst>
            <pc:docMk/>
            <pc:sldMk cId="354898960" sldId="273"/>
            <ac:grpSpMk id="5" creationId="{5E987FCD-A44C-0D49-5936-EC194E7B562F}"/>
          </ac:grpSpMkLst>
        </pc:grpChg>
        <pc:grpChg chg="add mod">
          <ac:chgData name="Seekings, Amanda" userId="6b110c03-99d0-4cce-a9d3-75045aa72821" providerId="ADAL" clId="{64EE14C7-E102-4A22-8A02-45F51E9D6E3F}" dt="2023-06-27T09:01:08.555" v="2255" actId="1038"/>
          <ac:grpSpMkLst>
            <pc:docMk/>
            <pc:sldMk cId="354898960" sldId="273"/>
            <ac:grpSpMk id="10" creationId="{AF652DF3-099B-E123-1430-38B8750414D7}"/>
          </ac:grpSpMkLst>
        </pc:grpChg>
        <pc:picChg chg="mod modCrop">
          <ac:chgData name="Seekings, Amanda" userId="6b110c03-99d0-4cce-a9d3-75045aa72821" providerId="ADAL" clId="{64EE14C7-E102-4A22-8A02-45F51E9D6E3F}" dt="2023-06-27T09:01:37.365" v="2273" actId="1076"/>
          <ac:picMkLst>
            <pc:docMk/>
            <pc:sldMk cId="354898960" sldId="273"/>
            <ac:picMk id="4" creationId="{5B8F2B01-764C-20EA-98B2-DD4E69642E06}"/>
          </ac:picMkLst>
        </pc:picChg>
        <pc:picChg chg="mod">
          <ac:chgData name="Seekings, Amanda" userId="6b110c03-99d0-4cce-a9d3-75045aa72821" providerId="ADAL" clId="{64EE14C7-E102-4A22-8A02-45F51E9D6E3F}" dt="2023-06-27T08:42:32.127" v="2142"/>
          <ac:picMkLst>
            <pc:docMk/>
            <pc:sldMk cId="354898960" sldId="273"/>
            <ac:picMk id="6" creationId="{3A770CA1-7CA0-E40D-84AE-858D236C3650}"/>
          </ac:picMkLst>
        </pc:picChg>
        <pc:picChg chg="mod">
          <ac:chgData name="Seekings, Amanda" userId="6b110c03-99d0-4cce-a9d3-75045aa72821" providerId="ADAL" clId="{64EE14C7-E102-4A22-8A02-45F51E9D6E3F}" dt="2023-06-27T08:42:32.127" v="2142"/>
          <ac:picMkLst>
            <pc:docMk/>
            <pc:sldMk cId="354898960" sldId="273"/>
            <ac:picMk id="8" creationId="{3DD2EBE2-0C55-11A9-7E99-1C541742D452}"/>
          </ac:picMkLst>
        </pc:picChg>
        <pc:picChg chg="mod">
          <ac:chgData name="Seekings, Amanda" userId="6b110c03-99d0-4cce-a9d3-75045aa72821" providerId="ADAL" clId="{64EE14C7-E102-4A22-8A02-45F51E9D6E3F}" dt="2023-06-27T08:42:32.127" v="2142"/>
          <ac:picMkLst>
            <pc:docMk/>
            <pc:sldMk cId="354898960" sldId="273"/>
            <ac:picMk id="12" creationId="{C1914BFB-786C-DA42-BD17-430246A0F760}"/>
          </ac:picMkLst>
        </pc:picChg>
        <pc:picChg chg="mod">
          <ac:chgData name="Seekings, Amanda" userId="6b110c03-99d0-4cce-a9d3-75045aa72821" providerId="ADAL" clId="{64EE14C7-E102-4A22-8A02-45F51E9D6E3F}" dt="2023-06-27T08:42:32.127" v="2142"/>
          <ac:picMkLst>
            <pc:docMk/>
            <pc:sldMk cId="354898960" sldId="273"/>
            <ac:picMk id="14" creationId="{964C6CE1-598D-63E7-EFE3-31C921AF0592}"/>
          </ac:picMkLst>
        </pc:picChg>
        <pc:picChg chg="mod">
          <ac:chgData name="Seekings, Amanda" userId="6b110c03-99d0-4cce-a9d3-75045aa72821" providerId="ADAL" clId="{64EE14C7-E102-4A22-8A02-45F51E9D6E3F}" dt="2023-06-27T08:42:32.127" v="2142"/>
          <ac:picMkLst>
            <pc:docMk/>
            <pc:sldMk cId="354898960" sldId="273"/>
            <ac:picMk id="15" creationId="{6D903488-D6ED-54C8-6EFA-02FFFC955964}"/>
          </ac:picMkLst>
        </pc:picChg>
      </pc:sldChg>
      <pc:sldChg chg="delSp del mod ord modNotesTx">
        <pc:chgData name="Seekings, Amanda" userId="6b110c03-99d0-4cce-a9d3-75045aa72821" providerId="ADAL" clId="{64EE14C7-E102-4A22-8A02-45F51E9D6E3F}" dt="2023-06-25T20:43:27.785" v="1803" actId="47"/>
        <pc:sldMkLst>
          <pc:docMk/>
          <pc:sldMk cId="560265744" sldId="274"/>
        </pc:sldMkLst>
        <pc:spChg chg="del">
          <ac:chgData name="Seekings, Amanda" userId="6b110c03-99d0-4cce-a9d3-75045aa72821" providerId="ADAL" clId="{64EE14C7-E102-4A22-8A02-45F51E9D6E3F}" dt="2023-06-25T20:30:54.732" v="1404" actId="478"/>
          <ac:spMkLst>
            <pc:docMk/>
            <pc:sldMk cId="560265744" sldId="274"/>
            <ac:spMk id="5" creationId="{CCAD3194-6055-0ABB-9304-AA6293E975B8}"/>
          </ac:spMkLst>
        </pc:spChg>
      </pc:sldChg>
      <pc:sldChg chg="addSp delSp modSp del mod addCm modCm modNotesTx">
        <pc:chgData name="Seekings, Amanda" userId="6b110c03-99d0-4cce-a9d3-75045aa72821" providerId="ADAL" clId="{64EE14C7-E102-4A22-8A02-45F51E9D6E3F}" dt="2023-06-27T14:20:40.755" v="2282" actId="47"/>
        <pc:sldMkLst>
          <pc:docMk/>
          <pc:sldMk cId="3220592849" sldId="275"/>
        </pc:sldMkLst>
        <pc:spChg chg="add mod">
          <ac:chgData name="Seekings, Amanda" userId="6b110c03-99d0-4cce-a9d3-75045aa72821" providerId="ADAL" clId="{64EE14C7-E102-4A22-8A02-45F51E9D6E3F}" dt="2023-06-25T20:31:42.275" v="1479" actId="20577"/>
          <ac:spMkLst>
            <pc:docMk/>
            <pc:sldMk cId="3220592849" sldId="275"/>
            <ac:spMk id="3" creationId="{BA0A2C41-9B9A-6F02-100A-552B4FA9733E}"/>
          </ac:spMkLst>
        </pc:spChg>
        <pc:spChg chg="mod">
          <ac:chgData name="Seekings, Amanda" userId="6b110c03-99d0-4cce-a9d3-75045aa72821" providerId="ADAL" clId="{64EE14C7-E102-4A22-8A02-45F51E9D6E3F}" dt="2023-06-27T08:16:11.650" v="2078"/>
          <ac:spMkLst>
            <pc:docMk/>
            <pc:sldMk cId="3220592849" sldId="275"/>
            <ac:spMk id="4" creationId="{78253CD3-4990-20E3-F48A-705CFA53CFD3}"/>
          </ac:spMkLst>
        </pc:spChg>
        <pc:spChg chg="mod">
          <ac:chgData name="Seekings, Amanda" userId="6b110c03-99d0-4cce-a9d3-75045aa72821" providerId="ADAL" clId="{64EE14C7-E102-4A22-8A02-45F51E9D6E3F}" dt="2023-06-25T20:31:48.131" v="1480" actId="1076"/>
          <ac:spMkLst>
            <pc:docMk/>
            <pc:sldMk cId="3220592849" sldId="275"/>
            <ac:spMk id="5" creationId="{4F6A0BF2-C891-C9E8-72D8-6C8CBBE9ED96}"/>
          </ac:spMkLst>
        </pc:spChg>
        <pc:spChg chg="mod topLvl">
          <ac:chgData name="Seekings, Amanda" userId="6b110c03-99d0-4cce-a9d3-75045aa72821" providerId="ADAL" clId="{64EE14C7-E102-4A22-8A02-45F51E9D6E3F}" dt="2023-06-27T08:42:28.229" v="2141" actId="164"/>
          <ac:spMkLst>
            <pc:docMk/>
            <pc:sldMk cId="3220592849" sldId="275"/>
            <ac:spMk id="8" creationId="{33456F21-E6F6-2FD4-8B4B-B0253FAA7098}"/>
          </ac:spMkLst>
        </pc:spChg>
        <pc:spChg chg="del mod topLvl">
          <ac:chgData name="Seekings, Amanda" userId="6b110c03-99d0-4cce-a9d3-75045aa72821" providerId="ADAL" clId="{64EE14C7-E102-4A22-8A02-45F51E9D6E3F}" dt="2023-06-27T08:18:23.814" v="2102" actId="478"/>
          <ac:spMkLst>
            <pc:docMk/>
            <pc:sldMk cId="3220592849" sldId="275"/>
            <ac:spMk id="9" creationId="{FFD8268F-970B-4C18-B19D-4E6CD89B01DB}"/>
          </ac:spMkLst>
        </pc:spChg>
        <pc:spChg chg="del mod topLvl">
          <ac:chgData name="Seekings, Amanda" userId="6b110c03-99d0-4cce-a9d3-75045aa72821" providerId="ADAL" clId="{64EE14C7-E102-4A22-8A02-45F51E9D6E3F}" dt="2023-06-27T08:18:25.198" v="2103" actId="478"/>
          <ac:spMkLst>
            <pc:docMk/>
            <pc:sldMk cId="3220592849" sldId="275"/>
            <ac:spMk id="10" creationId="{E22E5DC1-36C2-380A-1D6B-3193BDC8BF27}"/>
          </ac:spMkLst>
        </pc:spChg>
        <pc:spChg chg="mod topLvl">
          <ac:chgData name="Seekings, Amanda" userId="6b110c03-99d0-4cce-a9d3-75045aa72821" providerId="ADAL" clId="{64EE14C7-E102-4A22-8A02-45F51E9D6E3F}" dt="2023-06-27T08:42:21.196" v="2140" actId="164"/>
          <ac:spMkLst>
            <pc:docMk/>
            <pc:sldMk cId="3220592849" sldId="275"/>
            <ac:spMk id="12" creationId="{5A59A654-B613-3122-CD46-F2A2B01CC549}"/>
          </ac:spMkLst>
        </pc:spChg>
        <pc:spChg chg="del mod topLvl">
          <ac:chgData name="Seekings, Amanda" userId="6b110c03-99d0-4cce-a9d3-75045aa72821" providerId="ADAL" clId="{64EE14C7-E102-4A22-8A02-45F51E9D6E3F}" dt="2023-06-27T08:21:06.471" v="2115" actId="478"/>
          <ac:spMkLst>
            <pc:docMk/>
            <pc:sldMk cId="3220592849" sldId="275"/>
            <ac:spMk id="13" creationId="{27957F2E-2815-0F40-6D2E-F0E38B7690AD}"/>
          </ac:spMkLst>
        </pc:spChg>
        <pc:spChg chg="del mod topLvl">
          <ac:chgData name="Seekings, Amanda" userId="6b110c03-99d0-4cce-a9d3-75045aa72821" providerId="ADAL" clId="{64EE14C7-E102-4A22-8A02-45F51E9D6E3F}" dt="2023-06-27T08:21:08.114" v="2117" actId="478"/>
          <ac:spMkLst>
            <pc:docMk/>
            <pc:sldMk cId="3220592849" sldId="275"/>
            <ac:spMk id="14" creationId="{8EF56FA4-A9C4-3DBE-33BB-F5B2D011B423}"/>
          </ac:spMkLst>
        </pc:spChg>
        <pc:spChg chg="mod">
          <ac:chgData name="Seekings, Amanda" userId="6b110c03-99d0-4cce-a9d3-75045aa72821" providerId="ADAL" clId="{64EE14C7-E102-4A22-8A02-45F51E9D6E3F}" dt="2023-06-27T08:16:11.650" v="2078"/>
          <ac:spMkLst>
            <pc:docMk/>
            <pc:sldMk cId="3220592849" sldId="275"/>
            <ac:spMk id="16" creationId="{F065EDAF-A7F5-56C9-B1E2-DCB5D7B7F800}"/>
          </ac:spMkLst>
        </pc:spChg>
        <pc:spChg chg="mod">
          <ac:chgData name="Seekings, Amanda" userId="6b110c03-99d0-4cce-a9d3-75045aa72821" providerId="ADAL" clId="{64EE14C7-E102-4A22-8A02-45F51E9D6E3F}" dt="2023-06-27T08:16:11.650" v="2078"/>
          <ac:spMkLst>
            <pc:docMk/>
            <pc:sldMk cId="3220592849" sldId="275"/>
            <ac:spMk id="17" creationId="{30AD00BE-7D7F-65B7-7367-E4E2CDA30D90}"/>
          </ac:spMkLst>
        </pc:spChg>
        <pc:spChg chg="add mod">
          <ac:chgData name="Seekings, Amanda" userId="6b110c03-99d0-4cce-a9d3-75045aa72821" providerId="ADAL" clId="{64EE14C7-E102-4A22-8A02-45F51E9D6E3F}" dt="2023-06-27T08:42:28.229" v="2141" actId="164"/>
          <ac:spMkLst>
            <pc:docMk/>
            <pc:sldMk cId="3220592849" sldId="275"/>
            <ac:spMk id="20" creationId="{8C628333-A8B4-E5AD-BAA0-E859B06E19D6}"/>
          </ac:spMkLst>
        </pc:spChg>
        <pc:spChg chg="add del mod">
          <ac:chgData name="Seekings, Amanda" userId="6b110c03-99d0-4cce-a9d3-75045aa72821" providerId="ADAL" clId="{64EE14C7-E102-4A22-8A02-45F51E9D6E3F}" dt="2023-06-27T08:21:34.794" v="2128"/>
          <ac:spMkLst>
            <pc:docMk/>
            <pc:sldMk cId="3220592849" sldId="275"/>
            <ac:spMk id="22" creationId="{C9C6CA51-A78A-9122-8658-DC750502143E}"/>
          </ac:spMkLst>
        </pc:spChg>
        <pc:spChg chg="add del mod">
          <ac:chgData name="Seekings, Amanda" userId="6b110c03-99d0-4cce-a9d3-75045aa72821" providerId="ADAL" clId="{64EE14C7-E102-4A22-8A02-45F51E9D6E3F}" dt="2023-06-27T08:21:33.002" v="2125"/>
          <ac:spMkLst>
            <pc:docMk/>
            <pc:sldMk cId="3220592849" sldId="275"/>
            <ac:spMk id="23" creationId="{C45CF134-28D5-3945-C2CE-C30D95EB2D33}"/>
          </ac:spMkLst>
        </pc:spChg>
        <pc:spChg chg="add mod">
          <ac:chgData name="Seekings, Amanda" userId="6b110c03-99d0-4cce-a9d3-75045aa72821" providerId="ADAL" clId="{64EE14C7-E102-4A22-8A02-45F51E9D6E3F}" dt="2023-06-27T08:42:21.196" v="2140" actId="164"/>
          <ac:spMkLst>
            <pc:docMk/>
            <pc:sldMk cId="3220592849" sldId="275"/>
            <ac:spMk id="25" creationId="{9BC682A6-701B-5B56-A6FD-5154FFB73C6E}"/>
          </ac:spMkLst>
        </pc:spChg>
        <pc:spChg chg="add mod">
          <ac:chgData name="Seekings, Amanda" userId="6b110c03-99d0-4cce-a9d3-75045aa72821" providerId="ADAL" clId="{64EE14C7-E102-4A22-8A02-45F51E9D6E3F}" dt="2023-06-27T08:42:21.196" v="2140" actId="164"/>
          <ac:spMkLst>
            <pc:docMk/>
            <pc:sldMk cId="3220592849" sldId="275"/>
            <ac:spMk id="28" creationId="{7F326D1A-1EA8-402D-6523-A128FD8A9B3F}"/>
          </ac:spMkLst>
        </pc:spChg>
        <pc:grpChg chg="add del mod">
          <ac:chgData name="Seekings, Amanda" userId="6b110c03-99d0-4cce-a9d3-75045aa72821" providerId="ADAL" clId="{64EE14C7-E102-4A22-8A02-45F51E9D6E3F}" dt="2023-06-27T08:16:22.599" v="2081" actId="478"/>
          <ac:grpSpMkLst>
            <pc:docMk/>
            <pc:sldMk cId="3220592849" sldId="275"/>
            <ac:grpSpMk id="2" creationId="{05A46125-835F-4E16-4173-419DAD1049E0}"/>
          </ac:grpSpMkLst>
        </pc:grpChg>
        <pc:grpChg chg="add del mod">
          <ac:chgData name="Seekings, Amanda" userId="6b110c03-99d0-4cce-a9d3-75045aa72821" providerId="ADAL" clId="{64EE14C7-E102-4A22-8A02-45F51E9D6E3F}" dt="2023-06-27T08:18:21.045" v="2101" actId="165"/>
          <ac:grpSpMkLst>
            <pc:docMk/>
            <pc:sldMk cId="3220592849" sldId="275"/>
            <ac:grpSpMk id="6" creationId="{0786869C-8E51-6887-ACA9-1BFA599EB825}"/>
          </ac:grpSpMkLst>
        </pc:grpChg>
        <pc:grpChg chg="add del mod">
          <ac:chgData name="Seekings, Amanda" userId="6b110c03-99d0-4cce-a9d3-75045aa72821" providerId="ADAL" clId="{64EE14C7-E102-4A22-8A02-45F51E9D6E3F}" dt="2023-06-27T08:20:46.537" v="2113" actId="165"/>
          <ac:grpSpMkLst>
            <pc:docMk/>
            <pc:sldMk cId="3220592849" sldId="275"/>
            <ac:grpSpMk id="11" creationId="{6E603B54-2CE9-8329-30CE-CE584D2B9B23}"/>
          </ac:grpSpMkLst>
        </pc:grpChg>
        <pc:grpChg chg="add mod">
          <ac:chgData name="Seekings, Amanda" userId="6b110c03-99d0-4cce-a9d3-75045aa72821" providerId="ADAL" clId="{64EE14C7-E102-4A22-8A02-45F51E9D6E3F}" dt="2023-06-27T08:42:21.196" v="2140" actId="164"/>
          <ac:grpSpMkLst>
            <pc:docMk/>
            <pc:sldMk cId="3220592849" sldId="275"/>
            <ac:grpSpMk id="29" creationId="{7D6EDBBC-59ED-4F9A-A874-452C9B7ECDB1}"/>
          </ac:grpSpMkLst>
        </pc:grpChg>
        <pc:grpChg chg="add mod">
          <ac:chgData name="Seekings, Amanda" userId="6b110c03-99d0-4cce-a9d3-75045aa72821" providerId="ADAL" clId="{64EE14C7-E102-4A22-8A02-45F51E9D6E3F}" dt="2023-06-27T08:42:28.229" v="2141" actId="164"/>
          <ac:grpSpMkLst>
            <pc:docMk/>
            <pc:sldMk cId="3220592849" sldId="275"/>
            <ac:grpSpMk id="30" creationId="{2F67038D-EBBC-5968-83E9-CF68B1500876}"/>
          </ac:grpSpMkLst>
        </pc:grpChg>
        <pc:picChg chg="add del mod">
          <ac:chgData name="Seekings, Amanda" userId="6b110c03-99d0-4cce-a9d3-75045aa72821" providerId="ADAL" clId="{64EE14C7-E102-4A22-8A02-45F51E9D6E3F}" dt="2023-06-26T16:28:50.374" v="2007" actId="478"/>
          <ac:picMkLst>
            <pc:docMk/>
            <pc:sldMk cId="3220592849" sldId="275"/>
            <ac:picMk id="2" creationId="{815B8355-129D-EC2A-FF7A-C204579D3A42}"/>
          </ac:picMkLst>
        </pc:picChg>
        <pc:picChg chg="del mod">
          <ac:chgData name="Seekings, Amanda" userId="6b110c03-99d0-4cce-a9d3-75045aa72821" providerId="ADAL" clId="{64EE14C7-E102-4A22-8A02-45F51E9D6E3F}" dt="2023-06-26T16:30:13.462" v="2036" actId="478"/>
          <ac:picMkLst>
            <pc:docMk/>
            <pc:sldMk cId="3220592849" sldId="275"/>
            <ac:picMk id="4" creationId="{8D48DEFB-F0C0-BCC9-3C0A-7333A7B58A9D}"/>
          </ac:picMkLst>
        </pc:picChg>
        <pc:picChg chg="mod topLvl modCrop">
          <ac:chgData name="Seekings, Amanda" userId="6b110c03-99d0-4cce-a9d3-75045aa72821" providerId="ADAL" clId="{64EE14C7-E102-4A22-8A02-45F51E9D6E3F}" dt="2023-06-27T08:42:28.229" v="2141" actId="164"/>
          <ac:picMkLst>
            <pc:docMk/>
            <pc:sldMk cId="3220592849" sldId="275"/>
            <ac:picMk id="7" creationId="{BB27EE85-916E-5B6D-59A4-BC7E613C0235}"/>
          </ac:picMkLst>
        </pc:picChg>
        <pc:picChg chg="mod topLvl modCrop">
          <ac:chgData name="Seekings, Amanda" userId="6b110c03-99d0-4cce-a9d3-75045aa72821" providerId="ADAL" clId="{64EE14C7-E102-4A22-8A02-45F51E9D6E3F}" dt="2023-06-27T08:42:21.196" v="2140" actId="164"/>
          <ac:picMkLst>
            <pc:docMk/>
            <pc:sldMk cId="3220592849" sldId="275"/>
            <ac:picMk id="15" creationId="{5C1BC6FD-E4C1-AA29-21D3-0C150532FEED}"/>
          </ac:picMkLst>
        </pc:picChg>
        <pc:picChg chg="mod">
          <ac:chgData name="Seekings, Amanda" userId="6b110c03-99d0-4cce-a9d3-75045aa72821" providerId="ADAL" clId="{64EE14C7-E102-4A22-8A02-45F51E9D6E3F}" dt="2023-06-27T08:16:11.650" v="2078"/>
          <ac:picMkLst>
            <pc:docMk/>
            <pc:sldMk cId="3220592849" sldId="275"/>
            <ac:picMk id="18" creationId="{4B4833E1-DA09-C573-690D-CD1F9548FBA8}"/>
          </ac:picMkLst>
        </pc:picChg>
        <pc:picChg chg="add mod">
          <ac:chgData name="Seekings, Amanda" userId="6b110c03-99d0-4cce-a9d3-75045aa72821" providerId="ADAL" clId="{64EE14C7-E102-4A22-8A02-45F51E9D6E3F}" dt="2023-06-27T08:42:28.229" v="2141" actId="164"/>
          <ac:picMkLst>
            <pc:docMk/>
            <pc:sldMk cId="3220592849" sldId="275"/>
            <ac:picMk id="19" creationId="{6A2F93C0-BBC4-AC05-6E4E-23C52B0A5962}"/>
          </ac:picMkLst>
        </pc:picChg>
        <pc:picChg chg="add del mod">
          <ac:chgData name="Seekings, Amanda" userId="6b110c03-99d0-4cce-a9d3-75045aa72821" providerId="ADAL" clId="{64EE14C7-E102-4A22-8A02-45F51E9D6E3F}" dt="2023-06-27T08:21:34.794" v="2128"/>
          <ac:picMkLst>
            <pc:docMk/>
            <pc:sldMk cId="3220592849" sldId="275"/>
            <ac:picMk id="21" creationId="{68376E16-9860-D8F6-17D2-329B265ACF68}"/>
          </ac:picMkLst>
        </pc:picChg>
        <pc:picChg chg="add del mod">
          <ac:chgData name="Seekings, Amanda" userId="6b110c03-99d0-4cce-a9d3-75045aa72821" providerId="ADAL" clId="{64EE14C7-E102-4A22-8A02-45F51E9D6E3F}" dt="2023-06-27T08:21:33.002" v="2125"/>
          <ac:picMkLst>
            <pc:docMk/>
            <pc:sldMk cId="3220592849" sldId="275"/>
            <ac:picMk id="24" creationId="{5C8E90DF-EFBF-725F-1915-C0A77EAAF95C}"/>
          </ac:picMkLst>
        </pc:picChg>
        <pc:picChg chg="add mod">
          <ac:chgData name="Seekings, Amanda" userId="6b110c03-99d0-4cce-a9d3-75045aa72821" providerId="ADAL" clId="{64EE14C7-E102-4A22-8A02-45F51E9D6E3F}" dt="2023-06-27T08:42:21.196" v="2140" actId="164"/>
          <ac:picMkLst>
            <pc:docMk/>
            <pc:sldMk cId="3220592849" sldId="275"/>
            <ac:picMk id="26" creationId="{08DAEEB7-0C92-A78B-1E79-3F56E02FBBAF}"/>
          </ac:picMkLst>
        </pc:picChg>
        <pc:picChg chg="add mod">
          <ac:chgData name="Seekings, Amanda" userId="6b110c03-99d0-4cce-a9d3-75045aa72821" providerId="ADAL" clId="{64EE14C7-E102-4A22-8A02-45F51E9D6E3F}" dt="2023-06-27T08:42:21.196" v="2140" actId="164"/>
          <ac:picMkLst>
            <pc:docMk/>
            <pc:sldMk cId="3220592849" sldId="275"/>
            <ac:picMk id="27" creationId="{CA3C3B7E-364D-3F9F-B79F-6D0AA5C6DC15}"/>
          </ac:picMkLst>
        </pc:picChg>
      </pc:sldChg>
      <pc:sldChg chg="del modNotesTx">
        <pc:chgData name="Seekings, Amanda" userId="6b110c03-99d0-4cce-a9d3-75045aa72821" providerId="ADAL" clId="{64EE14C7-E102-4A22-8A02-45F51E9D6E3F}" dt="2023-06-23T15:31:09.046" v="810" actId="47"/>
        <pc:sldMkLst>
          <pc:docMk/>
          <pc:sldMk cId="1348938306" sldId="276"/>
        </pc:sldMkLst>
      </pc:sldChg>
      <pc:sldChg chg="new del modNotesTx">
        <pc:chgData name="Seekings, Amanda" userId="6b110c03-99d0-4cce-a9d3-75045aa72821" providerId="ADAL" clId="{64EE14C7-E102-4A22-8A02-45F51E9D6E3F}" dt="2023-06-21T09:40:32.687" v="174" actId="47"/>
        <pc:sldMkLst>
          <pc:docMk/>
          <pc:sldMk cId="3653402385" sldId="277"/>
        </pc:sldMkLst>
      </pc:sldChg>
      <pc:sldChg chg="addSp delSp modSp add mod ord modNotesTx">
        <pc:chgData name="Seekings, Amanda" userId="6b110c03-99d0-4cce-a9d3-75045aa72821" providerId="ADAL" clId="{64EE14C7-E102-4A22-8A02-45F51E9D6E3F}" dt="2023-06-25T20:53:51.345" v="1824" actId="6549"/>
        <pc:sldMkLst>
          <pc:docMk/>
          <pc:sldMk cId="3335504776" sldId="278"/>
        </pc:sldMkLst>
        <pc:spChg chg="mod">
          <ac:chgData name="Seekings, Amanda" userId="6b110c03-99d0-4cce-a9d3-75045aa72821" providerId="ADAL" clId="{64EE14C7-E102-4A22-8A02-45F51E9D6E3F}" dt="2023-06-21T09:40:04.059" v="167" actId="1038"/>
          <ac:spMkLst>
            <pc:docMk/>
            <pc:sldMk cId="3335504776" sldId="278"/>
            <ac:spMk id="2" creationId="{8E6DC6A9-BF62-479A-98C5-54925B383E65}"/>
          </ac:spMkLst>
        </pc:spChg>
        <pc:spChg chg="mod">
          <ac:chgData name="Seekings, Amanda" userId="6b110c03-99d0-4cce-a9d3-75045aa72821" providerId="ADAL" clId="{64EE14C7-E102-4A22-8A02-45F51E9D6E3F}" dt="2023-06-21T09:40:04.059" v="167" actId="1038"/>
          <ac:spMkLst>
            <pc:docMk/>
            <pc:sldMk cId="3335504776" sldId="278"/>
            <ac:spMk id="6" creationId="{22983CC2-BC1C-48A0-9ACA-8B0CE30331DC}"/>
          </ac:spMkLst>
        </pc:spChg>
        <pc:spChg chg="add mod">
          <ac:chgData name="Seekings, Amanda" userId="6b110c03-99d0-4cce-a9d3-75045aa72821" providerId="ADAL" clId="{64EE14C7-E102-4A22-8A02-45F51E9D6E3F}" dt="2023-06-21T10:02:05.671" v="307" actId="1076"/>
          <ac:spMkLst>
            <pc:docMk/>
            <pc:sldMk cId="3335504776" sldId="278"/>
            <ac:spMk id="11" creationId="{44CB2E73-6A1D-5165-5658-92D5F77D6CE9}"/>
          </ac:spMkLst>
        </pc:spChg>
        <pc:spChg chg="add mod">
          <ac:chgData name="Seekings, Amanda" userId="6b110c03-99d0-4cce-a9d3-75045aa72821" providerId="ADAL" clId="{64EE14C7-E102-4A22-8A02-45F51E9D6E3F}" dt="2023-06-21T10:04:50.493" v="314" actId="1076"/>
          <ac:spMkLst>
            <pc:docMk/>
            <pc:sldMk cId="3335504776" sldId="278"/>
            <ac:spMk id="12" creationId="{466C5283-AF8C-41FB-8628-930B459976BB}"/>
          </ac:spMkLst>
        </pc:spChg>
        <pc:graphicFrameChg chg="add del mod">
          <ac:chgData name="Seekings, Amanda" userId="6b110c03-99d0-4cce-a9d3-75045aa72821" providerId="ADAL" clId="{64EE14C7-E102-4A22-8A02-45F51E9D6E3F}" dt="2023-06-21T09:39:42.458" v="119"/>
          <ac:graphicFrameMkLst>
            <pc:docMk/>
            <pc:sldMk cId="3335504776" sldId="278"/>
            <ac:graphicFrameMk id="3" creationId="{51A48749-DF46-7CA0-A9B6-23A5793CA895}"/>
          </ac:graphicFrameMkLst>
        </pc:graphicFrameChg>
        <pc:graphicFrameChg chg="mod">
          <ac:chgData name="Seekings, Amanda" userId="6b110c03-99d0-4cce-a9d3-75045aa72821" providerId="ADAL" clId="{64EE14C7-E102-4A22-8A02-45F51E9D6E3F}" dt="2023-06-21T10:04:42.376" v="313"/>
          <ac:graphicFrameMkLst>
            <pc:docMk/>
            <pc:sldMk cId="3335504776" sldId="278"/>
            <ac:graphicFrameMk id="4" creationId="{AF3AD0A0-FBF9-40AC-99B2-689E22FF800F}"/>
          </ac:graphicFrameMkLst>
        </pc:graphicFrameChg>
        <pc:graphicFrameChg chg="mod">
          <ac:chgData name="Seekings, Amanda" userId="6b110c03-99d0-4cce-a9d3-75045aa72821" providerId="ADAL" clId="{64EE14C7-E102-4A22-8A02-45F51E9D6E3F}" dt="2023-06-21T10:01:24.423" v="303"/>
          <ac:graphicFrameMkLst>
            <pc:docMk/>
            <pc:sldMk cId="3335504776" sldId="278"/>
            <ac:graphicFrameMk id="5" creationId="{38E64A6B-753E-495F-9CE9-29C5EE624DBF}"/>
          </ac:graphicFrameMkLst>
        </pc:graphicFrameChg>
        <pc:graphicFrameChg chg="add del mod">
          <ac:chgData name="Seekings, Amanda" userId="6b110c03-99d0-4cce-a9d3-75045aa72821" providerId="ADAL" clId="{64EE14C7-E102-4A22-8A02-45F51E9D6E3F}" dt="2023-06-21T09:39:42.458" v="119"/>
          <ac:graphicFrameMkLst>
            <pc:docMk/>
            <pc:sldMk cId="3335504776" sldId="278"/>
            <ac:graphicFrameMk id="7" creationId="{79E9AAF6-9E25-D381-8F6E-147E0D482261}"/>
          </ac:graphicFrameMkLst>
        </pc:graphicFrameChg>
        <pc:graphicFrameChg chg="add del mod">
          <ac:chgData name="Seekings, Amanda" userId="6b110c03-99d0-4cce-a9d3-75045aa72821" providerId="ADAL" clId="{64EE14C7-E102-4A22-8A02-45F51E9D6E3F}" dt="2023-06-21T09:47:57.626" v="181"/>
          <ac:graphicFrameMkLst>
            <pc:docMk/>
            <pc:sldMk cId="3335504776" sldId="278"/>
            <ac:graphicFrameMk id="9" creationId="{24AF75F1-2EA5-EC37-E1D4-0093DFFB67A2}"/>
          </ac:graphicFrameMkLst>
        </pc:graphicFrameChg>
        <pc:graphicFrameChg chg="add mod">
          <ac:chgData name="Seekings, Amanda" userId="6b110c03-99d0-4cce-a9d3-75045aa72821" providerId="ADAL" clId="{64EE14C7-E102-4A22-8A02-45F51E9D6E3F}" dt="2023-06-21T10:02:01.683" v="306" actId="1076"/>
          <ac:graphicFrameMkLst>
            <pc:docMk/>
            <pc:sldMk cId="3335504776" sldId="278"/>
            <ac:graphicFrameMk id="10" creationId="{18EE5314-6189-4F48-3678-1C50607402AD}"/>
          </ac:graphicFrameMkLst>
        </pc:graphicFrameChg>
        <pc:graphicFrameChg chg="add del mod">
          <ac:chgData name="Seekings, Amanda" userId="6b110c03-99d0-4cce-a9d3-75045aa72821" providerId="ADAL" clId="{64EE14C7-E102-4A22-8A02-45F51E9D6E3F}" dt="2023-06-21T09:53:55.992" v="223" actId="478"/>
          <ac:graphicFrameMkLst>
            <pc:docMk/>
            <pc:sldMk cId="3335504776" sldId="278"/>
            <ac:graphicFrameMk id="13" creationId="{32D02048-A2E7-C17A-4A17-E2CA0731FFD1}"/>
          </ac:graphicFrameMkLst>
        </pc:graphicFrameChg>
        <pc:graphicFrameChg chg="add mod">
          <ac:chgData name="Seekings, Amanda" userId="6b110c03-99d0-4cce-a9d3-75045aa72821" providerId="ADAL" clId="{64EE14C7-E102-4A22-8A02-45F51E9D6E3F}" dt="2023-06-21T10:04:52.430" v="315" actId="1076"/>
          <ac:graphicFrameMkLst>
            <pc:docMk/>
            <pc:sldMk cId="3335504776" sldId="278"/>
            <ac:graphicFrameMk id="14" creationId="{4326FC1F-EE13-7EFC-5E59-17655F6693F2}"/>
          </ac:graphicFrameMkLst>
        </pc:graphicFrameChg>
        <pc:picChg chg="add del mod modCrop">
          <ac:chgData name="Seekings, Amanda" userId="6b110c03-99d0-4cce-a9d3-75045aa72821" providerId="ADAL" clId="{64EE14C7-E102-4A22-8A02-45F51E9D6E3F}" dt="2023-06-21T09:40:18.779" v="171" actId="478"/>
          <ac:picMkLst>
            <pc:docMk/>
            <pc:sldMk cId="3335504776" sldId="278"/>
            <ac:picMk id="8" creationId="{5A689A41-1A38-BCBE-7C78-AC61FC5F6D9B}"/>
          </ac:picMkLst>
        </pc:picChg>
      </pc:sldChg>
      <pc:sldChg chg="addSp delSp modSp add mod addCm delCm modNotesTx">
        <pc:chgData name="Seekings, Amanda" userId="6b110c03-99d0-4cce-a9d3-75045aa72821" providerId="ADAL" clId="{64EE14C7-E102-4A22-8A02-45F51E9D6E3F}" dt="2023-06-26T16:51:35.255" v="2077" actId="20577"/>
        <pc:sldMkLst>
          <pc:docMk/>
          <pc:sldMk cId="3222327784" sldId="279"/>
        </pc:sldMkLst>
        <pc:spChg chg="mod">
          <ac:chgData name="Seekings, Amanda" userId="6b110c03-99d0-4cce-a9d3-75045aa72821" providerId="ADAL" clId="{64EE14C7-E102-4A22-8A02-45F51E9D6E3F}" dt="2023-06-25T20:38:54.502" v="1708" actId="1076"/>
          <ac:spMkLst>
            <pc:docMk/>
            <pc:sldMk cId="3222327784" sldId="279"/>
            <ac:spMk id="2" creationId="{8BDD44AA-39F7-40D6-48C8-C30DAF1D35F7}"/>
          </ac:spMkLst>
        </pc:spChg>
        <pc:spChg chg="del mod">
          <ac:chgData name="Seekings, Amanda" userId="6b110c03-99d0-4cce-a9d3-75045aa72821" providerId="ADAL" clId="{64EE14C7-E102-4A22-8A02-45F51E9D6E3F}" dt="2023-06-25T20:40:46.411" v="1748" actId="478"/>
          <ac:spMkLst>
            <pc:docMk/>
            <pc:sldMk cId="3222327784" sldId="279"/>
            <ac:spMk id="3" creationId="{6E9F5AC0-F1C4-B4E6-635F-7A2229FAB3A8}"/>
          </ac:spMkLst>
        </pc:spChg>
        <pc:spChg chg="add del mod">
          <ac:chgData name="Seekings, Amanda" userId="6b110c03-99d0-4cce-a9d3-75045aa72821" providerId="ADAL" clId="{64EE14C7-E102-4A22-8A02-45F51E9D6E3F}" dt="2023-06-26T16:25:20.373" v="1906" actId="478"/>
          <ac:spMkLst>
            <pc:docMk/>
            <pc:sldMk cId="3222327784" sldId="279"/>
            <ac:spMk id="4" creationId="{19813C53-1BDD-757C-3FF2-04A01091CEFD}"/>
          </ac:spMkLst>
        </pc:spChg>
        <pc:spChg chg="del mod">
          <ac:chgData name="Seekings, Amanda" userId="6b110c03-99d0-4cce-a9d3-75045aa72821" providerId="ADAL" clId="{64EE14C7-E102-4A22-8A02-45F51E9D6E3F}" dt="2023-06-25T20:40:49.365" v="1749" actId="478"/>
          <ac:spMkLst>
            <pc:docMk/>
            <pc:sldMk cId="3222327784" sldId="279"/>
            <ac:spMk id="4" creationId="{4A0BD38A-0B81-A6E0-8B6A-09C1323FE6CB}"/>
          </ac:spMkLst>
        </pc:spChg>
        <pc:spChg chg="mod">
          <ac:chgData name="Seekings, Amanda" userId="6b110c03-99d0-4cce-a9d3-75045aa72821" providerId="ADAL" clId="{64EE14C7-E102-4A22-8A02-45F51E9D6E3F}" dt="2023-06-25T20:38:54.502" v="1708" actId="1076"/>
          <ac:spMkLst>
            <pc:docMk/>
            <pc:sldMk cId="3222327784" sldId="279"/>
            <ac:spMk id="6" creationId="{F5F2C722-93B7-ABCE-509B-D5AC5D4CE9F6}"/>
          </ac:spMkLst>
        </pc:spChg>
        <pc:spChg chg="add mod">
          <ac:chgData name="Seekings, Amanda" userId="6b110c03-99d0-4cce-a9d3-75045aa72821" providerId="ADAL" clId="{64EE14C7-E102-4A22-8A02-45F51E9D6E3F}" dt="2023-06-25T20:41:23.883" v="1780" actId="1036"/>
          <ac:spMkLst>
            <pc:docMk/>
            <pc:sldMk cId="3222327784" sldId="279"/>
            <ac:spMk id="8" creationId="{5864B623-B9D6-F443-4E5C-71462551EE65}"/>
          </ac:spMkLst>
        </pc:spChg>
        <pc:spChg chg="add mod">
          <ac:chgData name="Seekings, Amanda" userId="6b110c03-99d0-4cce-a9d3-75045aa72821" providerId="ADAL" clId="{64EE14C7-E102-4A22-8A02-45F51E9D6E3F}" dt="2023-06-25T20:41:18.860" v="1769" actId="1035"/>
          <ac:spMkLst>
            <pc:docMk/>
            <pc:sldMk cId="3222327784" sldId="279"/>
            <ac:spMk id="9" creationId="{4B2C20A4-66AB-B0DC-4131-817D76F24538}"/>
          </ac:spMkLst>
        </pc:spChg>
        <pc:spChg chg="add mod">
          <ac:chgData name="Seekings, Amanda" userId="6b110c03-99d0-4cce-a9d3-75045aa72821" providerId="ADAL" clId="{64EE14C7-E102-4A22-8A02-45F51E9D6E3F}" dt="2023-06-25T20:44:07.696" v="1819" actId="1076"/>
          <ac:spMkLst>
            <pc:docMk/>
            <pc:sldMk cId="3222327784" sldId="279"/>
            <ac:spMk id="11" creationId="{D8915E70-529C-D39E-B155-367EBA37DF78}"/>
          </ac:spMkLst>
        </pc:spChg>
        <pc:spChg chg="mod">
          <ac:chgData name="Seekings, Amanda" userId="6b110c03-99d0-4cce-a9d3-75045aa72821" providerId="ADAL" clId="{64EE14C7-E102-4A22-8A02-45F51E9D6E3F}" dt="2023-06-26T16:25:21.248" v="1907"/>
          <ac:spMkLst>
            <pc:docMk/>
            <pc:sldMk cId="3222327784" sldId="279"/>
            <ac:spMk id="15" creationId="{F45DCC79-35F6-2035-8F93-057B38ADE1D4}"/>
          </ac:spMkLst>
        </pc:spChg>
        <pc:spChg chg="mod">
          <ac:chgData name="Seekings, Amanda" userId="6b110c03-99d0-4cce-a9d3-75045aa72821" providerId="ADAL" clId="{64EE14C7-E102-4A22-8A02-45F51E9D6E3F}" dt="2023-06-26T16:25:21.248" v="1907"/>
          <ac:spMkLst>
            <pc:docMk/>
            <pc:sldMk cId="3222327784" sldId="279"/>
            <ac:spMk id="16" creationId="{89AFDD3A-D6CB-3D14-9D46-1299E5DBC8D0}"/>
          </ac:spMkLst>
        </pc:spChg>
        <pc:spChg chg="mod">
          <ac:chgData name="Seekings, Amanda" userId="6b110c03-99d0-4cce-a9d3-75045aa72821" providerId="ADAL" clId="{64EE14C7-E102-4A22-8A02-45F51E9D6E3F}" dt="2023-06-26T16:25:21.248" v="1907"/>
          <ac:spMkLst>
            <pc:docMk/>
            <pc:sldMk cId="3222327784" sldId="279"/>
            <ac:spMk id="17" creationId="{AAE74FDB-BD9C-A570-1451-C47C10B429AA}"/>
          </ac:spMkLst>
        </pc:spChg>
        <pc:spChg chg="mod">
          <ac:chgData name="Seekings, Amanda" userId="6b110c03-99d0-4cce-a9d3-75045aa72821" providerId="ADAL" clId="{64EE14C7-E102-4A22-8A02-45F51E9D6E3F}" dt="2023-06-26T16:25:21.248" v="1907"/>
          <ac:spMkLst>
            <pc:docMk/>
            <pc:sldMk cId="3222327784" sldId="279"/>
            <ac:spMk id="18" creationId="{CF210253-E19C-9A05-0C5A-5433E76FE528}"/>
          </ac:spMkLst>
        </pc:spChg>
        <pc:grpChg chg="add mod">
          <ac:chgData name="Seekings, Amanda" userId="6b110c03-99d0-4cce-a9d3-75045aa72821" providerId="ADAL" clId="{64EE14C7-E102-4A22-8A02-45F51E9D6E3F}" dt="2023-06-26T16:25:34.581" v="1909" actId="14100"/>
          <ac:grpSpMkLst>
            <pc:docMk/>
            <pc:sldMk cId="3222327784" sldId="279"/>
            <ac:grpSpMk id="12" creationId="{16A7C098-AE3A-71C3-E858-998A12278374}"/>
          </ac:grpSpMkLst>
        </pc:grpChg>
        <pc:picChg chg="mod">
          <ac:chgData name="Seekings, Amanda" userId="6b110c03-99d0-4cce-a9d3-75045aa72821" providerId="ADAL" clId="{64EE14C7-E102-4A22-8A02-45F51E9D6E3F}" dt="2023-06-25T20:39:07.105" v="1710" actId="1076"/>
          <ac:picMkLst>
            <pc:docMk/>
            <pc:sldMk cId="3222327784" sldId="279"/>
            <ac:picMk id="5" creationId="{7DA9C366-2DF3-4326-AC19-BC916A7BBC16}"/>
          </ac:picMkLst>
        </pc:picChg>
        <pc:picChg chg="mod">
          <ac:chgData name="Seekings, Amanda" userId="6b110c03-99d0-4cce-a9d3-75045aa72821" providerId="ADAL" clId="{64EE14C7-E102-4A22-8A02-45F51E9D6E3F}" dt="2023-06-25T20:41:11.428" v="1756" actId="1038"/>
          <ac:picMkLst>
            <pc:docMk/>
            <pc:sldMk cId="3222327784" sldId="279"/>
            <ac:picMk id="7" creationId="{BE668DA5-1187-4705-9B7F-3EBA44AB4A68}"/>
          </ac:picMkLst>
        </pc:picChg>
        <pc:picChg chg="add del mod">
          <ac:chgData name="Seekings, Amanda" userId="6b110c03-99d0-4cce-a9d3-75045aa72821" providerId="ADAL" clId="{64EE14C7-E102-4A22-8A02-45F51E9D6E3F}" dt="2023-06-26T16:25:18.110" v="1905" actId="478"/>
          <ac:picMkLst>
            <pc:docMk/>
            <pc:sldMk cId="3222327784" sldId="279"/>
            <ac:picMk id="10" creationId="{D3183624-511D-1751-65E2-EA5F5B229069}"/>
          </ac:picMkLst>
        </pc:picChg>
        <pc:picChg chg="mod">
          <ac:chgData name="Seekings, Amanda" userId="6b110c03-99d0-4cce-a9d3-75045aa72821" providerId="ADAL" clId="{64EE14C7-E102-4A22-8A02-45F51E9D6E3F}" dt="2023-06-26T16:25:21.248" v="1907"/>
          <ac:picMkLst>
            <pc:docMk/>
            <pc:sldMk cId="3222327784" sldId="279"/>
            <ac:picMk id="13" creationId="{D68796C7-0664-1ED4-D147-20B9D4D4890E}"/>
          </ac:picMkLst>
        </pc:picChg>
        <pc:picChg chg="mod">
          <ac:chgData name="Seekings, Amanda" userId="6b110c03-99d0-4cce-a9d3-75045aa72821" providerId="ADAL" clId="{64EE14C7-E102-4A22-8A02-45F51E9D6E3F}" dt="2023-06-26T16:25:21.248" v="1907"/>
          <ac:picMkLst>
            <pc:docMk/>
            <pc:sldMk cId="3222327784" sldId="279"/>
            <ac:picMk id="14" creationId="{8386E747-1F7A-EF50-B353-42F848C4264B}"/>
          </ac:picMkLst>
        </pc:picChg>
      </pc:sldChg>
      <pc:sldChg chg="addSp delSp modSp new del mod">
        <pc:chgData name="Seekings, Amanda" userId="6b110c03-99d0-4cce-a9d3-75045aa72821" providerId="ADAL" clId="{64EE14C7-E102-4A22-8A02-45F51E9D6E3F}" dt="2023-06-26T16:25:40.243" v="1910" actId="47"/>
        <pc:sldMkLst>
          <pc:docMk/>
          <pc:sldMk cId="926704298" sldId="280"/>
        </pc:sldMkLst>
        <pc:spChg chg="del">
          <ac:chgData name="Seekings, Amanda" userId="6b110c03-99d0-4cce-a9d3-75045aa72821" providerId="ADAL" clId="{64EE14C7-E102-4A22-8A02-45F51E9D6E3F}" dt="2023-06-26T16:21:38.854" v="1847" actId="478"/>
          <ac:spMkLst>
            <pc:docMk/>
            <pc:sldMk cId="926704298" sldId="280"/>
            <ac:spMk id="2" creationId="{EF98F350-D404-DA4B-9004-155996C2BEC3}"/>
          </ac:spMkLst>
        </pc:spChg>
        <pc:spChg chg="del">
          <ac:chgData name="Seekings, Amanda" userId="6b110c03-99d0-4cce-a9d3-75045aa72821" providerId="ADAL" clId="{64EE14C7-E102-4A22-8A02-45F51E9D6E3F}" dt="2023-06-26T16:21:38.001" v="1846" actId="478"/>
          <ac:spMkLst>
            <pc:docMk/>
            <pc:sldMk cId="926704298" sldId="280"/>
            <ac:spMk id="3" creationId="{677FBD79-DED0-BC54-A3A2-7F9E03160458}"/>
          </ac:spMkLst>
        </pc:spChg>
        <pc:spChg chg="add mod">
          <ac:chgData name="Seekings, Amanda" userId="6b110c03-99d0-4cce-a9d3-75045aa72821" providerId="ADAL" clId="{64EE14C7-E102-4A22-8A02-45F51E9D6E3F}" dt="2023-06-26T16:25:13.934" v="1904" actId="164"/>
          <ac:spMkLst>
            <pc:docMk/>
            <pc:sldMk cId="926704298" sldId="280"/>
            <ac:spMk id="6" creationId="{1E0D0B21-9DC1-95D4-299F-B4AA34111888}"/>
          </ac:spMkLst>
        </pc:spChg>
        <pc:spChg chg="add mod">
          <ac:chgData name="Seekings, Amanda" userId="6b110c03-99d0-4cce-a9d3-75045aa72821" providerId="ADAL" clId="{64EE14C7-E102-4A22-8A02-45F51E9D6E3F}" dt="2023-06-26T16:25:13.934" v="1904" actId="164"/>
          <ac:spMkLst>
            <pc:docMk/>
            <pc:sldMk cId="926704298" sldId="280"/>
            <ac:spMk id="7" creationId="{F222D029-5D9F-3945-E233-8AC6C855A067}"/>
          </ac:spMkLst>
        </pc:spChg>
        <pc:spChg chg="add mod">
          <ac:chgData name="Seekings, Amanda" userId="6b110c03-99d0-4cce-a9d3-75045aa72821" providerId="ADAL" clId="{64EE14C7-E102-4A22-8A02-45F51E9D6E3F}" dt="2023-06-26T16:25:13.934" v="1904" actId="164"/>
          <ac:spMkLst>
            <pc:docMk/>
            <pc:sldMk cId="926704298" sldId="280"/>
            <ac:spMk id="8" creationId="{9CD5F2F1-1AEC-81AF-BDE8-DDA703B229BA}"/>
          </ac:spMkLst>
        </pc:spChg>
        <pc:spChg chg="add mod">
          <ac:chgData name="Seekings, Amanda" userId="6b110c03-99d0-4cce-a9d3-75045aa72821" providerId="ADAL" clId="{64EE14C7-E102-4A22-8A02-45F51E9D6E3F}" dt="2023-06-26T16:25:13.934" v="1904" actId="164"/>
          <ac:spMkLst>
            <pc:docMk/>
            <pc:sldMk cId="926704298" sldId="280"/>
            <ac:spMk id="9" creationId="{1B70FCCD-6E58-F3C4-066C-2769ACA89276}"/>
          </ac:spMkLst>
        </pc:spChg>
        <pc:grpChg chg="add mod">
          <ac:chgData name="Seekings, Amanda" userId="6b110c03-99d0-4cce-a9d3-75045aa72821" providerId="ADAL" clId="{64EE14C7-E102-4A22-8A02-45F51E9D6E3F}" dt="2023-06-26T16:25:13.934" v="1904" actId="164"/>
          <ac:grpSpMkLst>
            <pc:docMk/>
            <pc:sldMk cId="926704298" sldId="280"/>
            <ac:grpSpMk id="10" creationId="{2C8FBEDA-4B8A-DE89-D34F-B36258093075}"/>
          </ac:grpSpMkLst>
        </pc:grpChg>
        <pc:picChg chg="add mod modCrop">
          <ac:chgData name="Seekings, Amanda" userId="6b110c03-99d0-4cce-a9d3-75045aa72821" providerId="ADAL" clId="{64EE14C7-E102-4A22-8A02-45F51E9D6E3F}" dt="2023-06-26T16:25:13.934" v="1904" actId="164"/>
          <ac:picMkLst>
            <pc:docMk/>
            <pc:sldMk cId="926704298" sldId="280"/>
            <ac:picMk id="4" creationId="{00D6DFC9-0320-0B18-9FCE-430C31A69018}"/>
          </ac:picMkLst>
        </pc:picChg>
        <pc:picChg chg="add mod modCrop">
          <ac:chgData name="Seekings, Amanda" userId="6b110c03-99d0-4cce-a9d3-75045aa72821" providerId="ADAL" clId="{64EE14C7-E102-4A22-8A02-45F51E9D6E3F}" dt="2023-06-26T16:25:13.934" v="1904" actId="164"/>
          <ac:picMkLst>
            <pc:docMk/>
            <pc:sldMk cId="926704298" sldId="280"/>
            <ac:picMk id="5" creationId="{97F1744A-8222-81F0-678D-43DF9B863972}"/>
          </ac:picMkLst>
        </pc:picChg>
      </pc:sldChg>
      <pc:sldChg chg="addSp delSp modSp new del mod">
        <pc:chgData name="Seekings, Amanda" userId="6b110c03-99d0-4cce-a9d3-75045aa72821" providerId="ADAL" clId="{64EE14C7-E102-4A22-8A02-45F51E9D6E3F}" dt="2023-06-27T08:22:21.675" v="2136" actId="47"/>
        <pc:sldMkLst>
          <pc:docMk/>
          <pc:sldMk cId="2510933779" sldId="280"/>
        </pc:sldMkLst>
        <pc:spChg chg="del">
          <ac:chgData name="Seekings, Amanda" userId="6b110c03-99d0-4cce-a9d3-75045aa72821" providerId="ADAL" clId="{64EE14C7-E102-4A22-8A02-45F51E9D6E3F}" dt="2023-06-27T08:16:26.106" v="2084" actId="478"/>
          <ac:spMkLst>
            <pc:docMk/>
            <pc:sldMk cId="2510933779" sldId="280"/>
            <ac:spMk id="2" creationId="{C71E545E-D42C-9E6F-BEC5-83B014DBDB52}"/>
          </ac:spMkLst>
        </pc:spChg>
        <pc:spChg chg="del">
          <ac:chgData name="Seekings, Amanda" userId="6b110c03-99d0-4cce-a9d3-75045aa72821" providerId="ADAL" clId="{64EE14C7-E102-4A22-8A02-45F51E9D6E3F}" dt="2023-06-27T08:16:25.488" v="2083" actId="478"/>
          <ac:spMkLst>
            <pc:docMk/>
            <pc:sldMk cId="2510933779" sldId="280"/>
            <ac:spMk id="3" creationId="{858A95FC-B835-14DB-ACC8-5B333A6901E9}"/>
          </ac:spMkLst>
        </pc:spChg>
        <pc:spChg chg="mod topLvl">
          <ac:chgData name="Seekings, Amanda" userId="6b110c03-99d0-4cce-a9d3-75045aa72821" providerId="ADAL" clId="{64EE14C7-E102-4A22-8A02-45F51E9D6E3F}" dt="2023-06-27T08:16:31.863" v="2086" actId="165"/>
          <ac:spMkLst>
            <pc:docMk/>
            <pc:sldMk cId="2510933779" sldId="280"/>
            <ac:spMk id="5" creationId="{1C55D79D-7FB8-5768-A573-A1F0DA4701C6}"/>
          </ac:spMkLst>
        </pc:spChg>
        <pc:spChg chg="mod topLvl">
          <ac:chgData name="Seekings, Amanda" userId="6b110c03-99d0-4cce-a9d3-75045aa72821" providerId="ADAL" clId="{64EE14C7-E102-4A22-8A02-45F51E9D6E3F}" dt="2023-06-27T08:16:31.863" v="2086" actId="165"/>
          <ac:spMkLst>
            <pc:docMk/>
            <pc:sldMk cId="2510933779" sldId="280"/>
            <ac:spMk id="6" creationId="{1A814EB9-819C-B20A-2A13-FCC136521242}"/>
          </ac:spMkLst>
        </pc:spChg>
        <pc:spChg chg="add del mod topLvl">
          <ac:chgData name="Seekings, Amanda" userId="6b110c03-99d0-4cce-a9d3-75045aa72821" providerId="ADAL" clId="{64EE14C7-E102-4A22-8A02-45F51E9D6E3F}" dt="2023-06-27T08:21:40.716" v="2130" actId="21"/>
          <ac:spMkLst>
            <pc:docMk/>
            <pc:sldMk cId="2510933779" sldId="280"/>
            <ac:spMk id="7" creationId="{0630D02D-EBF7-1281-67F1-5154A85861A7}"/>
          </ac:spMkLst>
        </pc:spChg>
        <pc:grpChg chg="add del mod">
          <ac:chgData name="Seekings, Amanda" userId="6b110c03-99d0-4cce-a9d3-75045aa72821" providerId="ADAL" clId="{64EE14C7-E102-4A22-8A02-45F51E9D6E3F}" dt="2023-06-27T08:16:31.863" v="2086" actId="165"/>
          <ac:grpSpMkLst>
            <pc:docMk/>
            <pc:sldMk cId="2510933779" sldId="280"/>
            <ac:grpSpMk id="4" creationId="{94D893CD-210B-B7C7-BE79-1F3BF5434C8F}"/>
          </ac:grpSpMkLst>
        </pc:grpChg>
        <pc:picChg chg="add del mod topLvl modCrop">
          <ac:chgData name="Seekings, Amanda" userId="6b110c03-99d0-4cce-a9d3-75045aa72821" providerId="ADAL" clId="{64EE14C7-E102-4A22-8A02-45F51E9D6E3F}" dt="2023-06-27T08:21:40.716" v="2130" actId="21"/>
          <ac:picMkLst>
            <pc:docMk/>
            <pc:sldMk cId="2510933779" sldId="280"/>
            <ac:picMk id="8" creationId="{BD4D583D-5E40-30B7-74F7-8057924AD199}"/>
          </ac:picMkLst>
        </pc:picChg>
      </pc:sldChg>
      <pc:sldChg chg="addSp delSp modSp new del mod">
        <pc:chgData name="Seekings, Amanda" userId="6b110c03-99d0-4cce-a9d3-75045aa72821" providerId="ADAL" clId="{64EE14C7-E102-4A22-8A02-45F51E9D6E3F}" dt="2023-06-26T16:30:35.918" v="2043" actId="47"/>
        <pc:sldMkLst>
          <pc:docMk/>
          <pc:sldMk cId="4034216082" sldId="280"/>
        </pc:sldMkLst>
        <pc:spChg chg="del">
          <ac:chgData name="Seekings, Amanda" userId="6b110c03-99d0-4cce-a9d3-75045aa72821" providerId="ADAL" clId="{64EE14C7-E102-4A22-8A02-45F51E9D6E3F}" dt="2023-06-26T16:26:46.718" v="1933" actId="478"/>
          <ac:spMkLst>
            <pc:docMk/>
            <pc:sldMk cId="4034216082" sldId="280"/>
            <ac:spMk id="2" creationId="{523D5930-FF91-CA49-7684-40C6DC5E07FE}"/>
          </ac:spMkLst>
        </pc:spChg>
        <pc:spChg chg="del">
          <ac:chgData name="Seekings, Amanda" userId="6b110c03-99d0-4cce-a9d3-75045aa72821" providerId="ADAL" clId="{64EE14C7-E102-4A22-8A02-45F51E9D6E3F}" dt="2023-06-26T16:26:45.552" v="1932" actId="478"/>
          <ac:spMkLst>
            <pc:docMk/>
            <pc:sldMk cId="4034216082" sldId="280"/>
            <ac:spMk id="3" creationId="{3B316911-9C86-9362-E6E9-8B974A680783}"/>
          </ac:spMkLst>
        </pc:spChg>
        <pc:spChg chg="add mod topLvl">
          <ac:chgData name="Seekings, Amanda" userId="6b110c03-99d0-4cce-a9d3-75045aa72821" providerId="ADAL" clId="{64EE14C7-E102-4A22-8A02-45F51E9D6E3F}" dt="2023-06-26T16:30:10.988" v="2035" actId="164"/>
          <ac:spMkLst>
            <pc:docMk/>
            <pc:sldMk cId="4034216082" sldId="280"/>
            <ac:spMk id="6" creationId="{8CD784E7-48B2-AD1A-FB47-5015B180AAA9}"/>
          </ac:spMkLst>
        </pc:spChg>
        <pc:spChg chg="add mod topLvl">
          <ac:chgData name="Seekings, Amanda" userId="6b110c03-99d0-4cce-a9d3-75045aa72821" providerId="ADAL" clId="{64EE14C7-E102-4A22-8A02-45F51E9D6E3F}" dt="2023-06-26T16:30:10.988" v="2035" actId="164"/>
          <ac:spMkLst>
            <pc:docMk/>
            <pc:sldMk cId="4034216082" sldId="280"/>
            <ac:spMk id="7" creationId="{0277ADCB-7482-4040-0DD2-B410254EC5C1}"/>
          </ac:spMkLst>
        </pc:spChg>
        <pc:spChg chg="add mod topLvl">
          <ac:chgData name="Seekings, Amanda" userId="6b110c03-99d0-4cce-a9d3-75045aa72821" providerId="ADAL" clId="{64EE14C7-E102-4A22-8A02-45F51E9D6E3F}" dt="2023-06-26T16:30:10.988" v="2035" actId="164"/>
          <ac:spMkLst>
            <pc:docMk/>
            <pc:sldMk cId="4034216082" sldId="280"/>
            <ac:spMk id="8" creationId="{0E8512B1-5E62-64AA-C6DD-DC5D91226456}"/>
          </ac:spMkLst>
        </pc:spChg>
        <pc:grpChg chg="add del mod">
          <ac:chgData name="Seekings, Amanda" userId="6b110c03-99d0-4cce-a9d3-75045aa72821" providerId="ADAL" clId="{64EE14C7-E102-4A22-8A02-45F51E9D6E3F}" dt="2023-06-26T16:29:07.200" v="2012" actId="165"/>
          <ac:grpSpMkLst>
            <pc:docMk/>
            <pc:sldMk cId="4034216082" sldId="280"/>
            <ac:grpSpMk id="2" creationId="{60469221-0BB4-C84D-AA09-937B5A61A6BE}"/>
          </ac:grpSpMkLst>
        </pc:grpChg>
        <pc:grpChg chg="add mod">
          <ac:chgData name="Seekings, Amanda" userId="6b110c03-99d0-4cce-a9d3-75045aa72821" providerId="ADAL" clId="{64EE14C7-E102-4A22-8A02-45F51E9D6E3F}" dt="2023-06-26T16:30:10.988" v="2035" actId="164"/>
          <ac:grpSpMkLst>
            <pc:docMk/>
            <pc:sldMk cId="4034216082" sldId="280"/>
            <ac:grpSpMk id="5" creationId="{62B95588-A9AF-7F6C-1C85-A90FC817F9C9}"/>
          </ac:grpSpMkLst>
        </pc:grpChg>
        <pc:picChg chg="add mod modCrop">
          <ac:chgData name="Seekings, Amanda" userId="6b110c03-99d0-4cce-a9d3-75045aa72821" providerId="ADAL" clId="{64EE14C7-E102-4A22-8A02-45F51E9D6E3F}" dt="2023-06-26T16:30:10.988" v="2035" actId="164"/>
          <ac:picMkLst>
            <pc:docMk/>
            <pc:sldMk cId="4034216082" sldId="280"/>
            <ac:picMk id="3" creationId="{77509F5D-36D4-A363-D878-5113F62BF094}"/>
          </ac:picMkLst>
        </pc:picChg>
        <pc:picChg chg="add del mod topLvl modCrop">
          <ac:chgData name="Seekings, Amanda" userId="6b110c03-99d0-4cce-a9d3-75045aa72821" providerId="ADAL" clId="{64EE14C7-E102-4A22-8A02-45F51E9D6E3F}" dt="2023-06-26T16:29:09.284" v="2013" actId="478"/>
          <ac:picMkLst>
            <pc:docMk/>
            <pc:sldMk cId="4034216082" sldId="280"/>
            <ac:picMk id="4" creationId="{095D32B6-9799-7718-1F26-BB71F77539C1}"/>
          </ac:picMkLst>
        </pc:picChg>
        <pc:picChg chg="add del mod modCrop">
          <ac:chgData name="Seekings, Amanda" userId="6b110c03-99d0-4cce-a9d3-75045aa72821" providerId="ADAL" clId="{64EE14C7-E102-4A22-8A02-45F51E9D6E3F}" dt="2023-06-26T16:28:02.990" v="2005" actId="478"/>
          <ac:picMkLst>
            <pc:docMk/>
            <pc:sldMk cId="4034216082" sldId="280"/>
            <ac:picMk id="5" creationId="{EB31222A-B986-3086-B244-470EB5DD0C83}"/>
          </ac:picMkLst>
        </pc:picChg>
      </pc:sldChg>
      <pc:sldChg chg="addSp delSp modSp new del mod">
        <pc:chgData name="Seekings, Amanda" userId="6b110c03-99d0-4cce-a9d3-75045aa72821" providerId="ADAL" clId="{64EE14C7-E102-4A22-8A02-45F51E9D6E3F}" dt="2023-06-27T08:22:21.675" v="2136" actId="47"/>
        <pc:sldMkLst>
          <pc:docMk/>
          <pc:sldMk cId="2144238464" sldId="281"/>
        </pc:sldMkLst>
        <pc:spChg chg="del">
          <ac:chgData name="Seekings, Amanda" userId="6b110c03-99d0-4cce-a9d3-75045aa72821" providerId="ADAL" clId="{64EE14C7-E102-4A22-8A02-45F51E9D6E3F}" dt="2023-06-27T08:17:12.343" v="2093" actId="478"/>
          <ac:spMkLst>
            <pc:docMk/>
            <pc:sldMk cId="2144238464" sldId="281"/>
            <ac:spMk id="2" creationId="{CDE1DC1C-76AE-5524-F653-FFD3B282A33E}"/>
          </ac:spMkLst>
        </pc:spChg>
        <pc:spChg chg="del">
          <ac:chgData name="Seekings, Amanda" userId="6b110c03-99d0-4cce-a9d3-75045aa72821" providerId="ADAL" clId="{64EE14C7-E102-4A22-8A02-45F51E9D6E3F}" dt="2023-06-27T08:17:11.325" v="2092" actId="478"/>
          <ac:spMkLst>
            <pc:docMk/>
            <pc:sldMk cId="2144238464" sldId="281"/>
            <ac:spMk id="3" creationId="{4DFD27BF-0A2D-41E4-62C7-FDAB53B07D4F}"/>
          </ac:spMkLst>
        </pc:spChg>
        <pc:spChg chg="mod topLvl">
          <ac:chgData name="Seekings, Amanda" userId="6b110c03-99d0-4cce-a9d3-75045aa72821" providerId="ADAL" clId="{64EE14C7-E102-4A22-8A02-45F51E9D6E3F}" dt="2023-06-27T08:17:09.687" v="2091" actId="165"/>
          <ac:spMkLst>
            <pc:docMk/>
            <pc:sldMk cId="2144238464" sldId="281"/>
            <ac:spMk id="6" creationId="{B07AFF2F-6859-30E8-F315-2E37AA05B97E}"/>
          </ac:spMkLst>
        </pc:spChg>
        <pc:spChg chg="add del mod topLvl">
          <ac:chgData name="Seekings, Amanda" userId="6b110c03-99d0-4cce-a9d3-75045aa72821" providerId="ADAL" clId="{64EE14C7-E102-4A22-8A02-45F51E9D6E3F}" dt="2023-06-27T08:21:52.084" v="2133" actId="21"/>
          <ac:spMkLst>
            <pc:docMk/>
            <pc:sldMk cId="2144238464" sldId="281"/>
            <ac:spMk id="7" creationId="{43F15A28-AC89-3848-2913-672C03052EF3}"/>
          </ac:spMkLst>
        </pc:spChg>
        <pc:spChg chg="mod topLvl">
          <ac:chgData name="Seekings, Amanda" userId="6b110c03-99d0-4cce-a9d3-75045aa72821" providerId="ADAL" clId="{64EE14C7-E102-4A22-8A02-45F51E9D6E3F}" dt="2023-06-27T08:17:09.687" v="2091" actId="165"/>
          <ac:spMkLst>
            <pc:docMk/>
            <pc:sldMk cId="2144238464" sldId="281"/>
            <ac:spMk id="8" creationId="{CC7FD7AC-F750-7ED0-53CA-6142369C43D5}"/>
          </ac:spMkLst>
        </pc:spChg>
        <pc:grpChg chg="add del mod">
          <ac:chgData name="Seekings, Amanda" userId="6b110c03-99d0-4cce-a9d3-75045aa72821" providerId="ADAL" clId="{64EE14C7-E102-4A22-8A02-45F51E9D6E3F}" dt="2023-06-27T08:17:09.687" v="2091" actId="165"/>
          <ac:grpSpMkLst>
            <pc:docMk/>
            <pc:sldMk cId="2144238464" sldId="281"/>
            <ac:grpSpMk id="4" creationId="{CF47AC99-E006-0464-D931-274231154DC0}"/>
          </ac:grpSpMkLst>
        </pc:grpChg>
        <pc:picChg chg="add del mod topLvl modCrop">
          <ac:chgData name="Seekings, Amanda" userId="6b110c03-99d0-4cce-a9d3-75045aa72821" providerId="ADAL" clId="{64EE14C7-E102-4A22-8A02-45F51E9D6E3F}" dt="2023-06-27T08:21:52.084" v="2133" actId="21"/>
          <ac:picMkLst>
            <pc:docMk/>
            <pc:sldMk cId="2144238464" sldId="281"/>
            <ac:picMk id="5" creationId="{1BEE789B-48FE-1924-C7A3-AF758F58F9EE}"/>
          </ac:picMkLst>
        </pc:picChg>
      </pc:sldChg>
      <pc:sldChg chg="addSp delSp modSp new del mod">
        <pc:chgData name="Seekings, Amanda" userId="6b110c03-99d0-4cce-a9d3-75045aa72821" providerId="ADAL" clId="{64EE14C7-E102-4A22-8A02-45F51E9D6E3F}" dt="2023-06-27T08:22:21.675" v="2136" actId="47"/>
        <pc:sldMkLst>
          <pc:docMk/>
          <pc:sldMk cId="3407997598" sldId="282"/>
        </pc:sldMkLst>
        <pc:spChg chg="del">
          <ac:chgData name="Seekings, Amanda" userId="6b110c03-99d0-4cce-a9d3-75045aa72821" providerId="ADAL" clId="{64EE14C7-E102-4A22-8A02-45F51E9D6E3F}" dt="2023-06-27T08:18:06.743" v="2098" actId="478"/>
          <ac:spMkLst>
            <pc:docMk/>
            <pc:sldMk cId="3407997598" sldId="282"/>
            <ac:spMk id="2" creationId="{56257AE5-7A69-F00F-C414-2E09CEACFACB}"/>
          </ac:spMkLst>
        </pc:spChg>
        <pc:spChg chg="del">
          <ac:chgData name="Seekings, Amanda" userId="6b110c03-99d0-4cce-a9d3-75045aa72821" providerId="ADAL" clId="{64EE14C7-E102-4A22-8A02-45F51E9D6E3F}" dt="2023-06-27T08:18:05.337" v="2097" actId="478"/>
          <ac:spMkLst>
            <pc:docMk/>
            <pc:sldMk cId="3407997598" sldId="282"/>
            <ac:spMk id="3" creationId="{A44665C6-3E23-E025-7B97-6D480BF8A096}"/>
          </ac:spMkLst>
        </pc:spChg>
        <pc:spChg chg="mod topLvl">
          <ac:chgData name="Seekings, Amanda" userId="6b110c03-99d0-4cce-a9d3-75045aa72821" providerId="ADAL" clId="{64EE14C7-E102-4A22-8A02-45F51E9D6E3F}" dt="2023-06-27T08:18:13.340" v="2100" actId="165"/>
          <ac:spMkLst>
            <pc:docMk/>
            <pc:sldMk cId="3407997598" sldId="282"/>
            <ac:spMk id="6" creationId="{23CB0CEC-9AD5-75F2-1B5D-93C0C895D2FB}"/>
          </ac:spMkLst>
        </pc:spChg>
        <pc:spChg chg="mod topLvl">
          <ac:chgData name="Seekings, Amanda" userId="6b110c03-99d0-4cce-a9d3-75045aa72821" providerId="ADAL" clId="{64EE14C7-E102-4A22-8A02-45F51E9D6E3F}" dt="2023-06-27T08:18:13.340" v="2100" actId="165"/>
          <ac:spMkLst>
            <pc:docMk/>
            <pc:sldMk cId="3407997598" sldId="282"/>
            <ac:spMk id="7" creationId="{7A5131D0-1BED-9155-FE7E-8A58AA857DF8}"/>
          </ac:spMkLst>
        </pc:spChg>
        <pc:spChg chg="add del mod topLvl">
          <ac:chgData name="Seekings, Amanda" userId="6b110c03-99d0-4cce-a9d3-75045aa72821" providerId="ADAL" clId="{64EE14C7-E102-4A22-8A02-45F51E9D6E3F}" dt="2023-06-27T08:19:04.100" v="2110" actId="21"/>
          <ac:spMkLst>
            <pc:docMk/>
            <pc:sldMk cId="3407997598" sldId="282"/>
            <ac:spMk id="8" creationId="{651B42E5-7C84-0618-DA89-D23DA3981063}"/>
          </ac:spMkLst>
        </pc:spChg>
        <pc:grpChg chg="add del mod">
          <ac:chgData name="Seekings, Amanda" userId="6b110c03-99d0-4cce-a9d3-75045aa72821" providerId="ADAL" clId="{64EE14C7-E102-4A22-8A02-45F51E9D6E3F}" dt="2023-06-27T08:18:13.340" v="2100" actId="165"/>
          <ac:grpSpMkLst>
            <pc:docMk/>
            <pc:sldMk cId="3407997598" sldId="282"/>
            <ac:grpSpMk id="4" creationId="{01DC4C14-C61D-117F-C27F-DD3D141C9F2F}"/>
          </ac:grpSpMkLst>
        </pc:grpChg>
        <pc:picChg chg="add del mod topLvl modCrop">
          <ac:chgData name="Seekings, Amanda" userId="6b110c03-99d0-4cce-a9d3-75045aa72821" providerId="ADAL" clId="{64EE14C7-E102-4A22-8A02-45F51E9D6E3F}" dt="2023-06-27T08:19:04.100" v="2110" actId="21"/>
          <ac:picMkLst>
            <pc:docMk/>
            <pc:sldMk cId="3407997598" sldId="282"/>
            <ac:picMk id="5" creationId="{8C39263E-D96B-FBEF-0E83-905FB7317B19}"/>
          </ac:picMkLst>
        </pc:picChg>
      </pc:sldChg>
      <pc:sldChg chg="add del">
        <pc:chgData name="Seekings, Amanda" userId="6b110c03-99d0-4cce-a9d3-75045aa72821" providerId="ADAL" clId="{64EE14C7-E102-4A22-8A02-45F51E9D6E3F}" dt="2023-06-27T08:18:59.979" v="2108"/>
        <pc:sldMkLst>
          <pc:docMk/>
          <pc:sldMk cId="1118547087" sldId="283"/>
        </pc:sldMkLst>
      </pc:sldChg>
    </pc:docChg>
  </pc:docChgLst>
  <pc:docChgLst>
    <pc:chgData name="Seekings, Amanda" userId="S::amanda.seekings_apha.gov.uk#ext#@alumni.onmicrosoft.com::b524fe07-63b5-4882-b3a3-c0217ea1c4e1" providerId="AD" clId="Web-{0FC144DE-76CC-82C8-3817-1AF88F4ACEDC}"/>
    <pc:docChg chg="modSld">
      <pc:chgData name="Seekings, Amanda" userId="S::amanda.seekings_apha.gov.uk#ext#@alumni.onmicrosoft.com::b524fe07-63b5-4882-b3a3-c0217ea1c4e1" providerId="AD" clId="Web-{0FC144DE-76CC-82C8-3817-1AF88F4ACEDC}" dt="2023-06-25T21:39:33.653" v="2" actId="1076"/>
      <pc:docMkLst>
        <pc:docMk/>
      </pc:docMkLst>
      <pc:sldChg chg="modSp">
        <pc:chgData name="Seekings, Amanda" userId="S::amanda.seekings_apha.gov.uk#ext#@alumni.onmicrosoft.com::b524fe07-63b5-4882-b3a3-c0217ea1c4e1" providerId="AD" clId="Web-{0FC144DE-76CC-82C8-3817-1AF88F4ACEDC}" dt="2023-06-25T21:39:33.653" v="2" actId="1076"/>
        <pc:sldMkLst>
          <pc:docMk/>
          <pc:sldMk cId="1506255048" sldId="262"/>
        </pc:sldMkLst>
        <pc:spChg chg="mod">
          <ac:chgData name="Seekings, Amanda" userId="S::amanda.seekings_apha.gov.uk#ext#@alumni.onmicrosoft.com::b524fe07-63b5-4882-b3a3-c0217ea1c4e1" providerId="AD" clId="Web-{0FC144DE-76CC-82C8-3817-1AF88F4ACEDC}" dt="2023-06-25T21:39:29.965" v="1" actId="1076"/>
          <ac:spMkLst>
            <pc:docMk/>
            <pc:sldMk cId="1506255048" sldId="262"/>
            <ac:spMk id="5" creationId="{5F8CF04E-E72B-7F98-D8A8-E9804E5BF514}"/>
          </ac:spMkLst>
        </pc:spChg>
        <pc:picChg chg="mod">
          <ac:chgData name="Seekings, Amanda" userId="S::amanda.seekings_apha.gov.uk#ext#@alumni.onmicrosoft.com::b524fe07-63b5-4882-b3a3-c0217ea1c4e1" providerId="AD" clId="Web-{0FC144DE-76CC-82C8-3817-1AF88F4ACEDC}" dt="2023-06-25T21:39:33.653" v="2" actId="1076"/>
          <ac:picMkLst>
            <pc:docMk/>
            <pc:sldMk cId="1506255048" sldId="262"/>
            <ac:picMk id="12" creationId="{00000000-0000-0000-0000-000000000000}"/>
          </ac:picMkLst>
        </pc:picChg>
      </pc:sldChg>
    </pc:docChg>
  </pc:docChgLst>
  <pc:docChgLst>
    <pc:chgData name="Seekings, Amanda" userId="S::amanda.seekings@apha.gov.uk::6b110c03-99d0-4cce-a9d3-75045aa72821" providerId="AD" clId="Web-{3E1F6D6C-E868-2B7E-0A82-70F9C41A3AD5}"/>
    <pc:docChg chg="addSld modSld sldOrd">
      <pc:chgData name="Seekings, Amanda" userId="S::amanda.seekings@apha.gov.uk::6b110c03-99d0-4cce-a9d3-75045aa72821" providerId="AD" clId="Web-{3E1F6D6C-E868-2B7E-0A82-70F9C41A3AD5}" dt="2023-06-07T14:42:16.830" v="33"/>
      <pc:docMkLst>
        <pc:docMk/>
      </pc:docMkLst>
      <pc:sldChg chg="addSp delSp modSp new">
        <pc:chgData name="Seekings, Amanda" userId="S::amanda.seekings@apha.gov.uk::6b110c03-99d0-4cce-a9d3-75045aa72821" providerId="AD" clId="Web-{3E1F6D6C-E868-2B7E-0A82-70F9C41A3AD5}" dt="2023-06-07T14:37:03.794" v="21" actId="1076"/>
        <pc:sldMkLst>
          <pc:docMk/>
          <pc:sldMk cId="560265744" sldId="274"/>
        </pc:sldMkLst>
        <pc:spChg chg="del">
          <ac:chgData name="Seekings, Amanda" userId="S::amanda.seekings@apha.gov.uk::6b110c03-99d0-4cce-a9d3-75045aa72821" providerId="AD" clId="Web-{3E1F6D6C-E868-2B7E-0A82-70F9C41A3AD5}" dt="2023-06-07T14:35:57.039" v="4"/>
          <ac:spMkLst>
            <pc:docMk/>
            <pc:sldMk cId="560265744" sldId="274"/>
            <ac:spMk id="2" creationId="{ADEEFFC2-B4D9-936F-4102-DEFA56CE10E9}"/>
          </ac:spMkLst>
        </pc:spChg>
        <pc:spChg chg="del">
          <ac:chgData name="Seekings, Amanda" userId="S::amanda.seekings@apha.gov.uk::6b110c03-99d0-4cce-a9d3-75045aa72821" providerId="AD" clId="Web-{3E1F6D6C-E868-2B7E-0A82-70F9C41A3AD5}" dt="2023-06-07T14:35:54.352" v="3"/>
          <ac:spMkLst>
            <pc:docMk/>
            <pc:sldMk cId="560265744" sldId="274"/>
            <ac:spMk id="3" creationId="{8C800251-B362-CD8A-1637-2FDB900C9425}"/>
          </ac:spMkLst>
        </pc:spChg>
        <pc:spChg chg="add mod">
          <ac:chgData name="Seekings, Amanda" userId="S::amanda.seekings@apha.gov.uk::6b110c03-99d0-4cce-a9d3-75045aa72821" providerId="AD" clId="Web-{3E1F6D6C-E868-2B7E-0A82-70F9C41A3AD5}" dt="2023-06-07T14:37:03.794" v="21" actId="1076"/>
          <ac:spMkLst>
            <pc:docMk/>
            <pc:sldMk cId="560265744" sldId="274"/>
            <ac:spMk id="5" creationId="{CCAD3194-6055-0ABB-9304-AA6293E975B8}"/>
          </ac:spMkLst>
        </pc:spChg>
        <pc:picChg chg="add mod ord">
          <ac:chgData name="Seekings, Amanda" userId="S::amanda.seekings@apha.gov.uk::6b110c03-99d0-4cce-a9d3-75045aa72821" providerId="AD" clId="Web-{3E1F6D6C-E868-2B7E-0A82-70F9C41A3AD5}" dt="2023-06-07T14:36:01.383" v="6" actId="14100"/>
          <ac:picMkLst>
            <pc:docMk/>
            <pc:sldMk cId="560265744" sldId="274"/>
            <ac:picMk id="4" creationId="{695F7956-05D9-AFEA-3EE3-2E133DD19011}"/>
          </ac:picMkLst>
        </pc:picChg>
      </pc:sldChg>
      <pc:sldChg chg="addSp delSp modSp new">
        <pc:chgData name="Seekings, Amanda" userId="S::amanda.seekings@apha.gov.uk::6b110c03-99d0-4cce-a9d3-75045aa72821" providerId="AD" clId="Web-{3E1F6D6C-E868-2B7E-0A82-70F9C41A3AD5}" dt="2023-06-07T14:37:18.326" v="26" actId="1076"/>
        <pc:sldMkLst>
          <pc:docMk/>
          <pc:sldMk cId="3220592849" sldId="275"/>
        </pc:sldMkLst>
        <pc:spChg chg="del">
          <ac:chgData name="Seekings, Amanda" userId="S::amanda.seekings@apha.gov.uk::6b110c03-99d0-4cce-a9d3-75045aa72821" providerId="AD" clId="Web-{3E1F6D6C-E868-2B7E-0A82-70F9C41A3AD5}" dt="2023-06-07T14:36:08.634" v="8"/>
          <ac:spMkLst>
            <pc:docMk/>
            <pc:sldMk cId="3220592849" sldId="275"/>
            <ac:spMk id="2" creationId="{33A04EC1-D31C-3D46-0423-15A1A466322D}"/>
          </ac:spMkLst>
        </pc:spChg>
        <pc:spChg chg="del">
          <ac:chgData name="Seekings, Amanda" userId="S::amanda.seekings@apha.gov.uk::6b110c03-99d0-4cce-a9d3-75045aa72821" providerId="AD" clId="Web-{3E1F6D6C-E868-2B7E-0A82-70F9C41A3AD5}" dt="2023-06-07T14:36:07.556" v="7"/>
          <ac:spMkLst>
            <pc:docMk/>
            <pc:sldMk cId="3220592849" sldId="275"/>
            <ac:spMk id="3" creationId="{4DC94257-10D6-19E5-5302-0452D2B5EF7A}"/>
          </ac:spMkLst>
        </pc:spChg>
        <pc:spChg chg="add mod">
          <ac:chgData name="Seekings, Amanda" userId="S::amanda.seekings@apha.gov.uk::6b110c03-99d0-4cce-a9d3-75045aa72821" providerId="AD" clId="Web-{3E1F6D6C-E868-2B7E-0A82-70F9C41A3AD5}" dt="2023-06-07T14:37:18.326" v="26" actId="1076"/>
          <ac:spMkLst>
            <pc:docMk/>
            <pc:sldMk cId="3220592849" sldId="275"/>
            <ac:spMk id="5" creationId="{4F6A0BF2-C891-C9E8-72D8-6C8CBBE9ED96}"/>
          </ac:spMkLst>
        </pc:spChg>
        <pc:picChg chg="add mod">
          <ac:chgData name="Seekings, Amanda" userId="S::amanda.seekings@apha.gov.uk::6b110c03-99d0-4cce-a9d3-75045aa72821" providerId="AD" clId="Web-{3E1F6D6C-E868-2B7E-0A82-70F9C41A3AD5}" dt="2023-06-07T14:36:51.277" v="18" actId="1076"/>
          <ac:picMkLst>
            <pc:docMk/>
            <pc:sldMk cId="3220592849" sldId="275"/>
            <ac:picMk id="4" creationId="{8D48DEFB-F0C0-BCC9-3C0A-7333A7B58A9D}"/>
          </ac:picMkLst>
        </pc:picChg>
      </pc:sldChg>
      <pc:sldChg chg="addSp delSp modSp new ord">
        <pc:chgData name="Seekings, Amanda" userId="S::amanda.seekings@apha.gov.uk::6b110c03-99d0-4cce-a9d3-75045aa72821" providerId="AD" clId="Web-{3E1F6D6C-E868-2B7E-0A82-70F9C41A3AD5}" dt="2023-06-07T14:42:16.830" v="33"/>
        <pc:sldMkLst>
          <pc:docMk/>
          <pc:sldMk cId="1348938306" sldId="276"/>
        </pc:sldMkLst>
        <pc:spChg chg="del">
          <ac:chgData name="Seekings, Amanda" userId="S::amanda.seekings@apha.gov.uk::6b110c03-99d0-4cce-a9d3-75045aa72821" providerId="AD" clId="Web-{3E1F6D6C-E868-2B7E-0A82-70F9C41A3AD5}" dt="2023-06-07T14:36:33.401" v="11"/>
          <ac:spMkLst>
            <pc:docMk/>
            <pc:sldMk cId="1348938306" sldId="276"/>
            <ac:spMk id="2" creationId="{E091590F-E1CB-0C77-0674-2AB7D0B50921}"/>
          </ac:spMkLst>
        </pc:spChg>
        <pc:spChg chg="del">
          <ac:chgData name="Seekings, Amanda" userId="S::amanda.seekings@apha.gov.uk::6b110c03-99d0-4cce-a9d3-75045aa72821" providerId="AD" clId="Web-{3E1F6D6C-E868-2B7E-0A82-70F9C41A3AD5}" dt="2023-06-07T14:36:32.276" v="10"/>
          <ac:spMkLst>
            <pc:docMk/>
            <pc:sldMk cId="1348938306" sldId="276"/>
            <ac:spMk id="3" creationId="{04EAC0C0-B62A-A5DC-1BBD-92672B863D17}"/>
          </ac:spMkLst>
        </pc:spChg>
        <pc:spChg chg="add mod">
          <ac:chgData name="Seekings, Amanda" userId="S::amanda.seekings@apha.gov.uk::6b110c03-99d0-4cce-a9d3-75045aa72821" providerId="AD" clId="Web-{3E1F6D6C-E868-2B7E-0A82-70F9C41A3AD5}" dt="2023-06-07T14:37:41.374" v="32" actId="1076"/>
          <ac:spMkLst>
            <pc:docMk/>
            <pc:sldMk cId="1348938306" sldId="276"/>
            <ac:spMk id="5" creationId="{CBD89F64-A483-61C0-183F-7FBF17F961C4}"/>
          </ac:spMkLst>
        </pc:spChg>
        <pc:picChg chg="add mod">
          <ac:chgData name="Seekings, Amanda" userId="S::amanda.seekings@apha.gov.uk::6b110c03-99d0-4cce-a9d3-75045aa72821" providerId="AD" clId="Web-{3E1F6D6C-E868-2B7E-0A82-70F9C41A3AD5}" dt="2023-06-07T14:37:37.812" v="30" actId="1076"/>
          <ac:picMkLst>
            <pc:docMk/>
            <pc:sldMk cId="1348938306" sldId="276"/>
            <ac:picMk id="4" creationId="{4953EB30-B85F-37C3-76E7-BC8F41D62574}"/>
          </ac:picMkLst>
        </pc:picChg>
      </pc:sldChg>
    </pc:docChg>
  </pc:docChgLst>
  <pc:docChgLst>
    <pc:chgData name="Slomka, Marek" userId="b5697613-81d3-4318-a926-46b10f876ab5" providerId="ADAL" clId="{803EE655-89FB-4FCD-9BE1-B4C79834F293}"/>
    <pc:docChg chg="undo custSel addSld delSld modSld">
      <pc:chgData name="Slomka, Marek" userId="b5697613-81d3-4318-a926-46b10f876ab5" providerId="ADAL" clId="{803EE655-89FB-4FCD-9BE1-B4C79834F293}" dt="2023-09-21T16:17:21.333" v="4853" actId="20577"/>
      <pc:docMkLst>
        <pc:docMk/>
      </pc:docMkLst>
      <pc:sldChg chg="modNotes">
        <pc:chgData name="Slomka, Marek" userId="b5697613-81d3-4318-a926-46b10f876ab5" providerId="ADAL" clId="{803EE655-89FB-4FCD-9BE1-B4C79834F293}" dt="2023-08-17T17:06:26.178" v="1151" actId="20577"/>
        <pc:sldMkLst>
          <pc:docMk/>
          <pc:sldMk cId="1209839087" sldId="257"/>
        </pc:sldMkLst>
      </pc:sldChg>
      <pc:sldChg chg="modSp modNotes modNotesTx">
        <pc:chgData name="Slomka, Marek" userId="b5697613-81d3-4318-a926-46b10f876ab5" providerId="ADAL" clId="{803EE655-89FB-4FCD-9BE1-B4C79834F293}" dt="2023-09-21T11:48:59.712" v="4851" actId="20577"/>
        <pc:sldMkLst>
          <pc:docMk/>
          <pc:sldMk cId="1506255048" sldId="262"/>
        </pc:sldMkLst>
        <pc:graphicFrameChg chg="mod">
          <ac:chgData name="Slomka, Marek" userId="b5697613-81d3-4318-a926-46b10f876ab5" providerId="ADAL" clId="{803EE655-89FB-4FCD-9BE1-B4C79834F293}" dt="2023-08-18T09:58:20.660" v="2091"/>
          <ac:graphicFrameMkLst>
            <pc:docMk/>
            <pc:sldMk cId="1506255048" sldId="262"/>
            <ac:graphicFrameMk id="9" creationId="{DF81FD1B-CCB5-4339-A453-2DD544F43141}"/>
          </ac:graphicFrameMkLst>
        </pc:graphicFrameChg>
      </pc:sldChg>
      <pc:sldChg chg="modNotesTx">
        <pc:chgData name="Slomka, Marek" userId="b5697613-81d3-4318-a926-46b10f876ab5" providerId="ADAL" clId="{803EE655-89FB-4FCD-9BE1-B4C79834F293}" dt="2023-09-04T16:56:09.080" v="4647" actId="20577"/>
        <pc:sldMkLst>
          <pc:docMk/>
          <pc:sldMk cId="918538571" sldId="263"/>
        </pc:sldMkLst>
      </pc:sldChg>
      <pc:sldChg chg="modNotes modNotesTx">
        <pc:chgData name="Slomka, Marek" userId="b5697613-81d3-4318-a926-46b10f876ab5" providerId="ADAL" clId="{803EE655-89FB-4FCD-9BE1-B4C79834F293}" dt="2023-09-21T16:17:21.333" v="4853" actId="20577"/>
        <pc:sldMkLst>
          <pc:docMk/>
          <pc:sldMk cId="3646838560" sldId="264"/>
        </pc:sldMkLst>
      </pc:sldChg>
      <pc:sldChg chg="modNotesTx">
        <pc:chgData name="Slomka, Marek" userId="b5697613-81d3-4318-a926-46b10f876ab5" providerId="ADAL" clId="{803EE655-89FB-4FCD-9BE1-B4C79834F293}" dt="2023-09-21T11:50:01.214" v="4852"/>
        <pc:sldMkLst>
          <pc:docMk/>
          <pc:sldMk cId="3612318088" sldId="266"/>
        </pc:sldMkLst>
      </pc:sldChg>
      <pc:sldChg chg="modSp modNotes modNotesTx">
        <pc:chgData name="Slomka, Marek" userId="b5697613-81d3-4318-a926-46b10f876ab5" providerId="ADAL" clId="{803EE655-89FB-4FCD-9BE1-B4C79834F293}" dt="2023-09-20T20:32:04.147" v="4767" actId="6549"/>
        <pc:sldMkLst>
          <pc:docMk/>
          <pc:sldMk cId="1557565970" sldId="272"/>
        </pc:sldMkLst>
        <pc:graphicFrameChg chg="mod">
          <ac:chgData name="Slomka, Marek" userId="b5697613-81d3-4318-a926-46b10f876ab5" providerId="ADAL" clId="{803EE655-89FB-4FCD-9BE1-B4C79834F293}" dt="2023-09-13T21:18:10.649" v="4703"/>
          <ac:graphicFrameMkLst>
            <pc:docMk/>
            <pc:sldMk cId="1557565970" sldId="272"/>
            <ac:graphicFrameMk id="4" creationId="{CF856BDA-AB7E-C9AC-CBB4-6C77BD1DDB85}"/>
          </ac:graphicFrameMkLst>
        </pc:graphicFrameChg>
      </pc:sldChg>
      <pc:sldChg chg="addSp modSp mod modNotes modNotesTx">
        <pc:chgData name="Slomka, Marek" userId="b5697613-81d3-4318-a926-46b10f876ab5" providerId="ADAL" clId="{803EE655-89FB-4FCD-9BE1-B4C79834F293}" dt="2023-09-20T17:34:49.208" v="4766" actId="1038"/>
        <pc:sldMkLst>
          <pc:docMk/>
          <pc:sldMk cId="354898960" sldId="273"/>
        </pc:sldMkLst>
        <pc:spChg chg="add mod">
          <ac:chgData name="Slomka, Marek" userId="b5697613-81d3-4318-a926-46b10f876ab5" providerId="ADAL" clId="{803EE655-89FB-4FCD-9BE1-B4C79834F293}" dt="2023-09-20T17:34:49.208" v="4766" actId="1038"/>
          <ac:spMkLst>
            <pc:docMk/>
            <pc:sldMk cId="354898960" sldId="273"/>
            <ac:spMk id="17" creationId="{B8EDB27E-6212-B1CD-37F3-FD67097D7D4E}"/>
          </ac:spMkLst>
        </pc:spChg>
      </pc:sldChg>
      <pc:sldChg chg="modNotes modNotesTx">
        <pc:chgData name="Slomka, Marek" userId="b5697613-81d3-4318-a926-46b10f876ab5" providerId="ADAL" clId="{803EE655-89FB-4FCD-9BE1-B4C79834F293}" dt="2023-09-04T13:37:12.893" v="4466" actId="20577"/>
        <pc:sldMkLst>
          <pc:docMk/>
          <pc:sldMk cId="3335504776" sldId="278"/>
        </pc:sldMkLst>
      </pc:sldChg>
      <pc:sldChg chg="modSp mod modNotesTx">
        <pc:chgData name="Slomka, Marek" userId="b5697613-81d3-4318-a926-46b10f876ab5" providerId="ADAL" clId="{803EE655-89FB-4FCD-9BE1-B4C79834F293}" dt="2023-09-20T16:28:49.219" v="4743" actId="1076"/>
        <pc:sldMkLst>
          <pc:docMk/>
          <pc:sldMk cId="3222327784" sldId="279"/>
        </pc:sldMkLst>
        <pc:graphicFrameChg chg="mod">
          <ac:chgData name="Slomka, Marek" userId="b5697613-81d3-4318-a926-46b10f876ab5" providerId="ADAL" clId="{803EE655-89FB-4FCD-9BE1-B4C79834F293}" dt="2023-09-20T16:28:49.219" v="4743" actId="1076"/>
          <ac:graphicFrameMkLst>
            <pc:docMk/>
            <pc:sldMk cId="3222327784" sldId="279"/>
            <ac:graphicFrameMk id="10" creationId="{AA5D9963-E260-CB4A-7F05-665AF77B22A3}"/>
          </ac:graphicFrameMkLst>
        </pc:graphicFrameChg>
      </pc:sldChg>
      <pc:sldChg chg="new del">
        <pc:chgData name="Slomka, Marek" userId="b5697613-81d3-4318-a926-46b10f876ab5" providerId="ADAL" clId="{803EE655-89FB-4FCD-9BE1-B4C79834F293}" dt="2023-09-04T13:35:56.309" v="4462" actId="680"/>
        <pc:sldMkLst>
          <pc:docMk/>
          <pc:sldMk cId="1040039639" sldId="280"/>
        </pc:sldMkLst>
      </pc:sldChg>
    </pc:docChg>
  </pc:docChgLst>
  <pc:docChgLst>
    <pc:chgData name="Seekings, Amanda" userId="S::amanda.seekings_apha.gov.uk#ext#@alumni.onmicrosoft.com::b524fe07-63b5-4882-b3a3-c0217ea1c4e1" providerId="AD" clId="Web-{129F2432-6CF5-98DD-93A5-542036B416CA}"/>
    <pc:docChg chg="modSld sldOrd">
      <pc:chgData name="Seekings, Amanda" userId="S::amanda.seekings_apha.gov.uk#ext#@alumni.onmicrosoft.com::b524fe07-63b5-4882-b3a3-c0217ea1c4e1" providerId="AD" clId="Web-{129F2432-6CF5-98DD-93A5-542036B416CA}" dt="2023-06-23T15:54:46.449" v="8"/>
      <pc:docMkLst>
        <pc:docMk/>
      </pc:docMkLst>
      <pc:sldChg chg="ord">
        <pc:chgData name="Seekings, Amanda" userId="S::amanda.seekings_apha.gov.uk#ext#@alumni.onmicrosoft.com::b524fe07-63b5-4882-b3a3-c0217ea1c4e1" providerId="AD" clId="Web-{129F2432-6CF5-98DD-93A5-542036B416CA}" dt="2023-06-23T15:52:29.477" v="0"/>
        <pc:sldMkLst>
          <pc:docMk/>
          <pc:sldMk cId="3891349692" sldId="269"/>
        </pc:sldMkLst>
      </pc:sldChg>
      <pc:sldChg chg="modNotes">
        <pc:chgData name="Seekings, Amanda" userId="S::amanda.seekings_apha.gov.uk#ext#@alumni.onmicrosoft.com::b524fe07-63b5-4882-b3a3-c0217ea1c4e1" providerId="AD" clId="Web-{129F2432-6CF5-98DD-93A5-542036B416CA}" dt="2023-06-23T15:54:46.449" v="8"/>
        <pc:sldMkLst>
          <pc:docMk/>
          <pc:sldMk cId="1557565970" sldId="272"/>
        </pc:sldMkLst>
      </pc:sldChg>
    </pc:docChg>
  </pc:docChgLst>
  <pc:docChgLst>
    <pc:chgData name="Slomka, Marek" userId="b5697613-81d3-4318-a926-46b10f876ab5" providerId="ADAL" clId="{AD104C41-A6E1-4B32-8F5F-E264042463CE}"/>
    <pc:docChg chg="custSel addSld delSld modSld">
      <pc:chgData name="Slomka, Marek" userId="b5697613-81d3-4318-a926-46b10f876ab5" providerId="ADAL" clId="{AD104C41-A6E1-4B32-8F5F-E264042463CE}" dt="2023-09-21T22:08:34.223" v="514" actId="27636"/>
      <pc:docMkLst>
        <pc:docMk/>
      </pc:docMkLst>
      <pc:sldChg chg="modSp mod modNotesTx">
        <pc:chgData name="Slomka, Marek" userId="b5697613-81d3-4318-a926-46b10f876ab5" providerId="ADAL" clId="{AD104C41-A6E1-4B32-8F5F-E264042463CE}" dt="2023-09-21T22:07:24.265" v="507" actId="20577"/>
        <pc:sldMkLst>
          <pc:docMk/>
          <pc:sldMk cId="1209839087" sldId="257"/>
        </pc:sldMkLst>
        <pc:spChg chg="mod">
          <ac:chgData name="Slomka, Marek" userId="b5697613-81d3-4318-a926-46b10f876ab5" providerId="ADAL" clId="{AD104C41-A6E1-4B32-8F5F-E264042463CE}" dt="2023-09-21T22:05:41.738" v="481" actId="1037"/>
          <ac:spMkLst>
            <pc:docMk/>
            <pc:sldMk cId="1209839087" sldId="257"/>
            <ac:spMk id="10" creationId="{172CE76D-038A-4261-94B3-A883AEFA32B4}"/>
          </ac:spMkLst>
        </pc:spChg>
        <pc:spChg chg="mod">
          <ac:chgData name="Slomka, Marek" userId="b5697613-81d3-4318-a926-46b10f876ab5" providerId="ADAL" clId="{AD104C41-A6E1-4B32-8F5F-E264042463CE}" dt="2023-09-21T22:05:47.803" v="506" actId="1037"/>
          <ac:spMkLst>
            <pc:docMk/>
            <pc:sldMk cId="1209839087" sldId="257"/>
            <ac:spMk id="11" creationId="{22173988-D994-4326-AAFF-7D96CDDD625A}"/>
          </ac:spMkLst>
        </pc:spChg>
      </pc:sldChg>
      <pc:sldChg chg="del">
        <pc:chgData name="Slomka, Marek" userId="b5697613-81d3-4318-a926-46b10f876ab5" providerId="ADAL" clId="{AD104C41-A6E1-4B32-8F5F-E264042463CE}" dt="2023-09-21T18:52:23.805" v="0" actId="47"/>
        <pc:sldMkLst>
          <pc:docMk/>
          <pc:sldMk cId="1506255048" sldId="262"/>
        </pc:sldMkLst>
      </pc:sldChg>
      <pc:sldChg chg="del">
        <pc:chgData name="Slomka, Marek" userId="b5697613-81d3-4318-a926-46b10f876ab5" providerId="ADAL" clId="{AD104C41-A6E1-4B32-8F5F-E264042463CE}" dt="2023-09-21T18:52:23.805" v="0" actId="47"/>
        <pc:sldMkLst>
          <pc:docMk/>
          <pc:sldMk cId="918538571" sldId="263"/>
        </pc:sldMkLst>
      </pc:sldChg>
      <pc:sldChg chg="del">
        <pc:chgData name="Slomka, Marek" userId="b5697613-81d3-4318-a926-46b10f876ab5" providerId="ADAL" clId="{AD104C41-A6E1-4B32-8F5F-E264042463CE}" dt="2023-09-21T18:52:23.805" v="0" actId="47"/>
        <pc:sldMkLst>
          <pc:docMk/>
          <pc:sldMk cId="3646838560" sldId="264"/>
        </pc:sldMkLst>
      </pc:sldChg>
      <pc:sldChg chg="del">
        <pc:chgData name="Slomka, Marek" userId="b5697613-81d3-4318-a926-46b10f876ab5" providerId="ADAL" clId="{AD104C41-A6E1-4B32-8F5F-E264042463CE}" dt="2023-09-21T18:52:23.805" v="0" actId="47"/>
        <pc:sldMkLst>
          <pc:docMk/>
          <pc:sldMk cId="3612318088" sldId="266"/>
        </pc:sldMkLst>
      </pc:sldChg>
      <pc:sldChg chg="modNotesTx">
        <pc:chgData name="Slomka, Marek" userId="b5697613-81d3-4318-a926-46b10f876ab5" providerId="ADAL" clId="{AD104C41-A6E1-4B32-8F5F-E264042463CE}" dt="2023-09-21T22:08:04.943" v="510" actId="20577"/>
        <pc:sldMkLst>
          <pc:docMk/>
          <pc:sldMk cId="1557565970" sldId="272"/>
        </pc:sldMkLst>
      </pc:sldChg>
      <pc:sldChg chg="modNotesTx">
        <pc:chgData name="Slomka, Marek" userId="b5697613-81d3-4318-a926-46b10f876ab5" providerId="ADAL" clId="{AD104C41-A6E1-4B32-8F5F-E264042463CE}" dt="2023-09-21T22:07:36.656" v="508" actId="20577"/>
        <pc:sldMkLst>
          <pc:docMk/>
          <pc:sldMk cId="354898960" sldId="273"/>
        </pc:sldMkLst>
      </pc:sldChg>
      <pc:sldChg chg="del">
        <pc:chgData name="Slomka, Marek" userId="b5697613-81d3-4318-a926-46b10f876ab5" providerId="ADAL" clId="{AD104C41-A6E1-4B32-8F5F-E264042463CE}" dt="2023-09-21T18:52:23.805" v="0" actId="47"/>
        <pc:sldMkLst>
          <pc:docMk/>
          <pc:sldMk cId="3335504776" sldId="278"/>
        </pc:sldMkLst>
      </pc:sldChg>
      <pc:sldChg chg="modNotesTx">
        <pc:chgData name="Slomka, Marek" userId="b5697613-81d3-4318-a926-46b10f876ab5" providerId="ADAL" clId="{AD104C41-A6E1-4B32-8F5F-E264042463CE}" dt="2023-09-21T22:07:45.162" v="509" actId="20577"/>
        <pc:sldMkLst>
          <pc:docMk/>
          <pc:sldMk cId="3222327784" sldId="279"/>
        </pc:sldMkLst>
      </pc:sldChg>
      <pc:sldChg chg="delSp modSp new mod">
        <pc:chgData name="Slomka, Marek" userId="b5697613-81d3-4318-a926-46b10f876ab5" providerId="ADAL" clId="{AD104C41-A6E1-4B32-8F5F-E264042463CE}" dt="2023-09-21T22:05:02.612" v="444" actId="20577"/>
        <pc:sldMkLst>
          <pc:docMk/>
          <pc:sldMk cId="4160274378" sldId="280"/>
        </pc:sldMkLst>
        <pc:spChg chg="del">
          <ac:chgData name="Slomka, Marek" userId="b5697613-81d3-4318-a926-46b10f876ab5" providerId="ADAL" clId="{AD104C41-A6E1-4B32-8F5F-E264042463CE}" dt="2023-09-21T21:44:59.151" v="6" actId="478"/>
          <ac:spMkLst>
            <pc:docMk/>
            <pc:sldMk cId="4160274378" sldId="280"/>
            <ac:spMk id="2" creationId="{D771A58F-E0A3-A1C9-1E91-FD347E1DA2FA}"/>
          </ac:spMkLst>
        </pc:spChg>
        <pc:spChg chg="mod">
          <ac:chgData name="Slomka, Marek" userId="b5697613-81d3-4318-a926-46b10f876ab5" providerId="ADAL" clId="{AD104C41-A6E1-4B32-8F5F-E264042463CE}" dt="2023-09-21T22:05:02.612" v="444" actId="20577"/>
          <ac:spMkLst>
            <pc:docMk/>
            <pc:sldMk cId="4160274378" sldId="280"/>
            <ac:spMk id="3" creationId="{81EB01E9-B875-0F85-95A1-1A640EFB8228}"/>
          </ac:spMkLst>
        </pc:spChg>
      </pc:sldChg>
      <pc:sldChg chg="delSp modSp new mod">
        <pc:chgData name="Slomka, Marek" userId="b5697613-81d3-4318-a926-46b10f876ab5" providerId="ADAL" clId="{AD104C41-A6E1-4B32-8F5F-E264042463CE}" dt="2023-09-21T22:03:23.282" v="406" actId="6549"/>
        <pc:sldMkLst>
          <pc:docMk/>
          <pc:sldMk cId="181846705" sldId="281"/>
        </pc:sldMkLst>
        <pc:spChg chg="del">
          <ac:chgData name="Slomka, Marek" userId="b5697613-81d3-4318-a926-46b10f876ab5" providerId="ADAL" clId="{AD104C41-A6E1-4B32-8F5F-E264042463CE}" dt="2023-09-21T21:48:28.949" v="38" actId="478"/>
          <ac:spMkLst>
            <pc:docMk/>
            <pc:sldMk cId="181846705" sldId="281"/>
            <ac:spMk id="2" creationId="{E6D5537E-B316-BE56-C7CF-31D9E388E81F}"/>
          </ac:spMkLst>
        </pc:spChg>
        <pc:spChg chg="mod">
          <ac:chgData name="Slomka, Marek" userId="b5697613-81d3-4318-a926-46b10f876ab5" providerId="ADAL" clId="{AD104C41-A6E1-4B32-8F5F-E264042463CE}" dt="2023-09-21T22:03:23.282" v="406" actId="6549"/>
          <ac:spMkLst>
            <pc:docMk/>
            <pc:sldMk cId="181846705" sldId="281"/>
            <ac:spMk id="3" creationId="{17BBACA1-634D-7A2A-3AA2-745263FBB284}"/>
          </ac:spMkLst>
        </pc:spChg>
      </pc:sldChg>
      <pc:sldChg chg="delSp modSp new mod">
        <pc:chgData name="Slomka, Marek" userId="b5697613-81d3-4318-a926-46b10f876ab5" providerId="ADAL" clId="{AD104C41-A6E1-4B32-8F5F-E264042463CE}" dt="2023-09-21T21:58:20.687" v="372" actId="20577"/>
        <pc:sldMkLst>
          <pc:docMk/>
          <pc:sldMk cId="1049922620" sldId="282"/>
        </pc:sldMkLst>
        <pc:spChg chg="del">
          <ac:chgData name="Slomka, Marek" userId="b5697613-81d3-4318-a926-46b10f876ab5" providerId="ADAL" clId="{AD104C41-A6E1-4B32-8F5F-E264042463CE}" dt="2023-09-21T21:53:01.570" v="190" actId="478"/>
          <ac:spMkLst>
            <pc:docMk/>
            <pc:sldMk cId="1049922620" sldId="282"/>
            <ac:spMk id="2" creationId="{60456948-B52B-DE00-E0FE-6B82EDB0C7EB}"/>
          </ac:spMkLst>
        </pc:spChg>
        <pc:spChg chg="mod">
          <ac:chgData name="Slomka, Marek" userId="b5697613-81d3-4318-a926-46b10f876ab5" providerId="ADAL" clId="{AD104C41-A6E1-4B32-8F5F-E264042463CE}" dt="2023-09-21T21:58:20.687" v="372" actId="20577"/>
          <ac:spMkLst>
            <pc:docMk/>
            <pc:sldMk cId="1049922620" sldId="282"/>
            <ac:spMk id="3" creationId="{AF9E62BE-87BA-C33B-F1D9-00E389F32800}"/>
          </ac:spMkLst>
        </pc:spChg>
      </pc:sldChg>
      <pc:sldChg chg="delSp modSp new mod">
        <pc:chgData name="Slomka, Marek" userId="b5697613-81d3-4318-a926-46b10f876ab5" providerId="ADAL" clId="{AD104C41-A6E1-4B32-8F5F-E264042463CE}" dt="2023-09-21T22:08:34.223" v="514" actId="27636"/>
        <pc:sldMkLst>
          <pc:docMk/>
          <pc:sldMk cId="248765492" sldId="283"/>
        </pc:sldMkLst>
        <pc:spChg chg="del">
          <ac:chgData name="Slomka, Marek" userId="b5697613-81d3-4318-a926-46b10f876ab5" providerId="ADAL" clId="{AD104C41-A6E1-4B32-8F5F-E264042463CE}" dt="2023-09-21T21:59:08.967" v="374" actId="478"/>
          <ac:spMkLst>
            <pc:docMk/>
            <pc:sldMk cId="248765492" sldId="283"/>
            <ac:spMk id="2" creationId="{1BD47E7A-293B-B83B-81B8-45602E404C0D}"/>
          </ac:spMkLst>
        </pc:spChg>
        <pc:spChg chg="mod">
          <ac:chgData name="Slomka, Marek" userId="b5697613-81d3-4318-a926-46b10f876ab5" providerId="ADAL" clId="{AD104C41-A6E1-4B32-8F5F-E264042463CE}" dt="2023-09-21T22:08:34.223" v="514" actId="27636"/>
          <ac:spMkLst>
            <pc:docMk/>
            <pc:sldMk cId="248765492" sldId="283"/>
            <ac:spMk id="3" creationId="{D8E65092-C0B9-7D34-CAF0-252226C81390}"/>
          </ac:spMkLst>
        </pc:spChg>
      </pc:sldChg>
    </pc:docChg>
  </pc:docChgLst>
  <pc:docChgLst>
    <pc:chgData name="Amanda Seekings" userId="6b110c03-99d0-4cce-a9d3-75045aa72821" providerId="ADAL" clId="{F6593C7C-B30F-45EF-8698-8F7D8F8F845E}"/>
    <pc:docChg chg="modSld">
      <pc:chgData name="Amanda Seekings" userId="6b110c03-99d0-4cce-a9d3-75045aa72821" providerId="ADAL" clId="{F6593C7C-B30F-45EF-8698-8F7D8F8F845E}" dt="2023-08-18T10:38:07.725" v="101"/>
      <pc:docMkLst>
        <pc:docMk/>
      </pc:docMkLst>
      <pc:sldChg chg="modSp">
        <pc:chgData name="Amanda Seekings" userId="6b110c03-99d0-4cce-a9d3-75045aa72821" providerId="ADAL" clId="{F6593C7C-B30F-45EF-8698-8F7D8F8F845E}" dt="2023-08-18T10:38:07.725" v="101"/>
        <pc:sldMkLst>
          <pc:docMk/>
          <pc:sldMk cId="1506255048" sldId="262"/>
        </pc:sldMkLst>
        <pc:graphicFrameChg chg="mod">
          <ac:chgData name="Amanda Seekings" userId="6b110c03-99d0-4cce-a9d3-75045aa72821" providerId="ADAL" clId="{F6593C7C-B30F-45EF-8698-8F7D8F8F845E}" dt="2023-08-18T10:37:18.681" v="99"/>
          <ac:graphicFrameMkLst>
            <pc:docMk/>
            <pc:sldMk cId="1506255048" sldId="262"/>
            <ac:graphicFrameMk id="8" creationId="{2B27E51B-CCC1-49C6-B165-0ADEED6EEBC7}"/>
          </ac:graphicFrameMkLst>
        </pc:graphicFrameChg>
        <pc:graphicFrameChg chg="mod">
          <ac:chgData name="Amanda Seekings" userId="6b110c03-99d0-4cce-a9d3-75045aa72821" providerId="ADAL" clId="{F6593C7C-B30F-45EF-8698-8F7D8F8F845E}" dt="2023-08-18T10:38:07.725" v="101"/>
          <ac:graphicFrameMkLst>
            <pc:docMk/>
            <pc:sldMk cId="1506255048" sldId="262"/>
            <ac:graphicFrameMk id="11" creationId="{9D31A8CC-4156-42A8-B8B4-99FA71D20708}"/>
          </ac:graphicFrameMkLst>
        </pc:graphicFrameChg>
      </pc:sldChg>
      <pc:sldChg chg="modSp mod">
        <pc:chgData name="Amanda Seekings" userId="6b110c03-99d0-4cce-a9d3-75045aa72821" providerId="ADAL" clId="{F6593C7C-B30F-45EF-8698-8F7D8F8F845E}" dt="2023-08-18T10:26:13.273" v="29" actId="1038"/>
        <pc:sldMkLst>
          <pc:docMk/>
          <pc:sldMk cId="3646838560" sldId="264"/>
        </pc:sldMkLst>
        <pc:graphicFrameChg chg="mod">
          <ac:chgData name="Amanda Seekings" userId="6b110c03-99d0-4cce-a9d3-75045aa72821" providerId="ADAL" clId="{F6593C7C-B30F-45EF-8698-8F7D8F8F845E}" dt="2023-08-18T10:26:13.273" v="29" actId="1038"/>
          <ac:graphicFrameMkLst>
            <pc:docMk/>
            <pc:sldMk cId="3646838560" sldId="264"/>
            <ac:graphicFrameMk id="12" creationId="{DD4D74AF-C01A-4849-981F-5E6EF36A3298}"/>
          </ac:graphicFrameMkLst>
        </pc:graphicFrameChg>
      </pc:sldChg>
      <pc:sldChg chg="modSp mod">
        <pc:chgData name="Amanda Seekings" userId="6b110c03-99d0-4cce-a9d3-75045aa72821" providerId="ADAL" clId="{F6593C7C-B30F-45EF-8698-8F7D8F8F845E}" dt="2023-08-18T10:29:06.210" v="96" actId="1038"/>
        <pc:sldMkLst>
          <pc:docMk/>
          <pc:sldMk cId="3612318088" sldId="266"/>
        </pc:sldMkLst>
        <pc:graphicFrameChg chg="mod">
          <ac:chgData name="Amanda Seekings" userId="6b110c03-99d0-4cce-a9d3-75045aa72821" providerId="ADAL" clId="{F6593C7C-B30F-45EF-8698-8F7D8F8F845E}" dt="2023-08-18T10:29:06.210" v="96" actId="1038"/>
          <ac:graphicFrameMkLst>
            <pc:docMk/>
            <pc:sldMk cId="3612318088" sldId="266"/>
            <ac:graphicFrameMk id="6" creationId="{9DC69F2E-B89E-48D2-A280-B97EFE0F2F2E}"/>
          </ac:graphicFrameMkLst>
        </pc:graphicFrameChg>
        <pc:graphicFrameChg chg="mod">
          <ac:chgData name="Amanda Seekings" userId="6b110c03-99d0-4cce-a9d3-75045aa72821" providerId="ADAL" clId="{F6593C7C-B30F-45EF-8698-8F7D8F8F845E}" dt="2023-08-18T10:29:02.002" v="94" actId="1037"/>
          <ac:graphicFrameMkLst>
            <pc:docMk/>
            <pc:sldMk cId="3612318088" sldId="266"/>
            <ac:graphicFrameMk id="7" creationId="{344D34D7-F7B8-4900-AD0F-BB77742FFBCC}"/>
          </ac:graphicFrameMkLst>
        </pc:graphicFrameChg>
      </pc:sldChg>
      <pc:sldChg chg="modSp mod">
        <pc:chgData name="Amanda Seekings" userId="6b110c03-99d0-4cce-a9d3-75045aa72821" providerId="ADAL" clId="{F6593C7C-B30F-45EF-8698-8F7D8F8F845E}" dt="2023-08-18T10:28:19.250" v="83" actId="1037"/>
        <pc:sldMkLst>
          <pc:docMk/>
          <pc:sldMk cId="3335504776" sldId="278"/>
        </pc:sldMkLst>
        <pc:graphicFrameChg chg="mod">
          <ac:chgData name="Amanda Seekings" userId="6b110c03-99d0-4cce-a9d3-75045aa72821" providerId="ADAL" clId="{F6593C7C-B30F-45EF-8698-8F7D8F8F845E}" dt="2023-08-18T10:28:08.593" v="75" actId="1037"/>
          <ac:graphicFrameMkLst>
            <pc:docMk/>
            <pc:sldMk cId="3335504776" sldId="278"/>
            <ac:graphicFrameMk id="4" creationId="{AF3AD0A0-FBF9-40AC-99B2-689E22FF800F}"/>
          </ac:graphicFrameMkLst>
        </pc:graphicFrameChg>
        <pc:graphicFrameChg chg="mod">
          <ac:chgData name="Amanda Seekings" userId="6b110c03-99d0-4cce-a9d3-75045aa72821" providerId="ADAL" clId="{F6593C7C-B30F-45EF-8698-8F7D8F8F845E}" dt="2023-08-18T10:28:19.250" v="83" actId="1037"/>
          <ac:graphicFrameMkLst>
            <pc:docMk/>
            <pc:sldMk cId="3335504776" sldId="278"/>
            <ac:graphicFrameMk id="14" creationId="{4326FC1F-EE13-7EFC-5E59-17655F6693F2}"/>
          </ac:graphicFrameMkLst>
        </pc:graphicFrameChg>
      </pc:sldChg>
    </pc:docChg>
  </pc:docChgLst>
  <pc:docChgLst>
    <pc:chgData name="Seekings, Amanda" userId="6b110c03-99d0-4cce-a9d3-75045aa72821" providerId="ADAL" clId="{F6593C7C-B30F-45EF-8698-8F7D8F8F845E}"/>
    <pc:docChg chg="custSel addSld delSld modSld">
      <pc:chgData name="Seekings, Amanda" userId="6b110c03-99d0-4cce-a9d3-75045aa72821" providerId="ADAL" clId="{F6593C7C-B30F-45EF-8698-8F7D8F8F845E}" dt="2023-08-16T21:04:21.932" v="149" actId="47"/>
      <pc:docMkLst>
        <pc:docMk/>
      </pc:docMkLst>
      <pc:sldChg chg="modSp mod">
        <pc:chgData name="Seekings, Amanda" userId="6b110c03-99d0-4cce-a9d3-75045aa72821" providerId="ADAL" clId="{F6593C7C-B30F-45EF-8698-8F7D8F8F845E}" dt="2023-08-16T17:29:44.725" v="119" actId="1038"/>
        <pc:sldMkLst>
          <pc:docMk/>
          <pc:sldMk cId="1209839087" sldId="257"/>
        </pc:sldMkLst>
        <pc:spChg chg="mod">
          <ac:chgData name="Seekings, Amanda" userId="6b110c03-99d0-4cce-a9d3-75045aa72821" providerId="ADAL" clId="{F6593C7C-B30F-45EF-8698-8F7D8F8F845E}" dt="2023-08-16T12:15:44.895" v="16" actId="1076"/>
          <ac:spMkLst>
            <pc:docMk/>
            <pc:sldMk cId="1209839087" sldId="257"/>
            <ac:spMk id="4" creationId="{D76BD509-7718-46EE-A66A-DC9B9483A587}"/>
          </ac:spMkLst>
        </pc:spChg>
        <pc:spChg chg="mod">
          <ac:chgData name="Seekings, Amanda" userId="6b110c03-99d0-4cce-a9d3-75045aa72821" providerId="ADAL" clId="{F6593C7C-B30F-45EF-8698-8F7D8F8F845E}" dt="2023-08-16T12:23:30.683" v="33" actId="1076"/>
          <ac:spMkLst>
            <pc:docMk/>
            <pc:sldMk cId="1209839087" sldId="257"/>
            <ac:spMk id="5" creationId="{32E33FDE-D4AF-4906-AD87-5359E1BC7D03}"/>
          </ac:spMkLst>
        </pc:spChg>
        <pc:spChg chg="mod">
          <ac:chgData name="Seekings, Amanda" userId="6b110c03-99d0-4cce-a9d3-75045aa72821" providerId="ADAL" clId="{F6593C7C-B30F-45EF-8698-8F7D8F8F845E}" dt="2023-08-16T12:23:54.924" v="81" actId="1038"/>
          <ac:spMkLst>
            <pc:docMk/>
            <pc:sldMk cId="1209839087" sldId="257"/>
            <ac:spMk id="12" creationId="{2C03DA60-DDC6-4F2D-B689-3967EF79EAEB}"/>
          </ac:spMkLst>
        </pc:spChg>
        <pc:spChg chg="mod">
          <ac:chgData name="Seekings, Amanda" userId="6b110c03-99d0-4cce-a9d3-75045aa72821" providerId="ADAL" clId="{F6593C7C-B30F-45EF-8698-8F7D8F8F845E}" dt="2023-08-16T12:23:54.924" v="81" actId="1038"/>
          <ac:spMkLst>
            <pc:docMk/>
            <pc:sldMk cId="1209839087" sldId="257"/>
            <ac:spMk id="13" creationId="{165FBBE3-BDDD-4F79-9E08-3973684B8FB5}"/>
          </ac:spMkLst>
        </pc:spChg>
        <pc:spChg chg="mod">
          <ac:chgData name="Seekings, Amanda" userId="6b110c03-99d0-4cce-a9d3-75045aa72821" providerId="ADAL" clId="{F6593C7C-B30F-45EF-8698-8F7D8F8F845E}" dt="2023-08-16T17:29:44.725" v="119" actId="1038"/>
          <ac:spMkLst>
            <pc:docMk/>
            <pc:sldMk cId="1209839087" sldId="257"/>
            <ac:spMk id="16" creationId="{094BC58E-5FA3-48BB-B937-19C38D961DF1}"/>
          </ac:spMkLst>
        </pc:spChg>
        <pc:spChg chg="mod">
          <ac:chgData name="Seekings, Amanda" userId="6b110c03-99d0-4cce-a9d3-75045aa72821" providerId="ADAL" clId="{F6593C7C-B30F-45EF-8698-8F7D8F8F845E}" dt="2023-08-16T17:29:41.720" v="113" actId="1037"/>
          <ac:spMkLst>
            <pc:docMk/>
            <pc:sldMk cId="1209839087" sldId="257"/>
            <ac:spMk id="17" creationId="{01BAE922-24EB-4998-BB76-20C7D8A09EDC}"/>
          </ac:spMkLst>
        </pc:spChg>
        <pc:graphicFrameChg chg="mod">
          <ac:chgData name="Seekings, Amanda" userId="6b110c03-99d0-4cce-a9d3-75045aa72821" providerId="ADAL" clId="{F6593C7C-B30F-45EF-8698-8F7D8F8F845E}" dt="2023-08-16T12:23:47.915" v="35" actId="1076"/>
          <ac:graphicFrameMkLst>
            <pc:docMk/>
            <pc:sldMk cId="1209839087" sldId="257"/>
            <ac:graphicFrameMk id="6" creationId="{CE9859CE-3631-4663-9813-DB27948291AA}"/>
          </ac:graphicFrameMkLst>
        </pc:graphicFrameChg>
        <pc:graphicFrameChg chg="mod">
          <ac:chgData name="Seekings, Amanda" userId="6b110c03-99d0-4cce-a9d3-75045aa72821" providerId="ADAL" clId="{F6593C7C-B30F-45EF-8698-8F7D8F8F845E}" dt="2023-08-16T12:16:10.554" v="21"/>
          <ac:graphicFrameMkLst>
            <pc:docMk/>
            <pc:sldMk cId="1209839087" sldId="257"/>
            <ac:graphicFrameMk id="7" creationId="{812DBF8F-8191-4E62-BFF4-A85EE328D02E}"/>
          </ac:graphicFrameMkLst>
        </pc:graphicFrameChg>
        <pc:graphicFrameChg chg="mod">
          <ac:chgData name="Seekings, Amanda" userId="6b110c03-99d0-4cce-a9d3-75045aa72821" providerId="ADAL" clId="{F6593C7C-B30F-45EF-8698-8F7D8F8F845E}" dt="2023-08-16T17:29:30.830" v="99" actId="1076"/>
          <ac:graphicFrameMkLst>
            <pc:docMk/>
            <pc:sldMk cId="1209839087" sldId="257"/>
            <ac:graphicFrameMk id="8" creationId="{346B696E-763F-4EFE-8D82-1D85E3EE4625}"/>
          </ac:graphicFrameMkLst>
        </pc:graphicFrameChg>
        <pc:graphicFrameChg chg="mod">
          <ac:chgData name="Seekings, Amanda" userId="6b110c03-99d0-4cce-a9d3-75045aa72821" providerId="ADAL" clId="{F6593C7C-B30F-45EF-8698-8F7D8F8F845E}" dt="2023-08-16T17:29:35.185" v="100" actId="1076"/>
          <ac:graphicFrameMkLst>
            <pc:docMk/>
            <pc:sldMk cId="1209839087" sldId="257"/>
            <ac:graphicFrameMk id="9" creationId="{E15500F2-57E8-4A67-BABA-AE8CD4E4D848}"/>
          </ac:graphicFrameMkLst>
        </pc:graphicFrameChg>
      </pc:sldChg>
      <pc:sldChg chg="modSp">
        <pc:chgData name="Seekings, Amanda" userId="6b110c03-99d0-4cce-a9d3-75045aa72821" providerId="ADAL" clId="{F6593C7C-B30F-45EF-8698-8F7D8F8F845E}" dt="2023-08-16T12:05:38.514" v="4"/>
        <pc:sldMkLst>
          <pc:docMk/>
          <pc:sldMk cId="1557565970" sldId="272"/>
        </pc:sldMkLst>
        <pc:graphicFrameChg chg="mod">
          <ac:chgData name="Seekings, Amanda" userId="6b110c03-99d0-4cce-a9d3-75045aa72821" providerId="ADAL" clId="{F6593C7C-B30F-45EF-8698-8F7D8F8F845E}" dt="2023-08-16T12:05:38.514" v="4"/>
          <ac:graphicFrameMkLst>
            <pc:docMk/>
            <pc:sldMk cId="1557565970" sldId="272"/>
            <ac:graphicFrameMk id="10" creationId="{70AD9239-CE67-DA7C-405D-F02C94F92776}"/>
          </ac:graphicFrameMkLst>
        </pc:graphicFrameChg>
      </pc:sldChg>
      <pc:sldChg chg="addSp delSp modSp mod">
        <pc:chgData name="Seekings, Amanda" userId="6b110c03-99d0-4cce-a9d3-75045aa72821" providerId="ADAL" clId="{F6593C7C-B30F-45EF-8698-8F7D8F8F845E}" dt="2023-08-16T21:04:05.047" v="148" actId="1038"/>
        <pc:sldMkLst>
          <pc:docMk/>
          <pc:sldMk cId="3222327784" sldId="279"/>
        </pc:sldMkLst>
        <pc:spChg chg="mod">
          <ac:chgData name="Seekings, Amanda" userId="6b110c03-99d0-4cce-a9d3-75045aa72821" providerId="ADAL" clId="{F6593C7C-B30F-45EF-8698-8F7D8F8F845E}" dt="2023-08-16T21:04:05.047" v="148" actId="1038"/>
          <ac:spMkLst>
            <pc:docMk/>
            <pc:sldMk cId="3222327784" sldId="279"/>
            <ac:spMk id="8" creationId="{5864B623-B9D6-F443-4E5C-71462551EE65}"/>
          </ac:spMkLst>
        </pc:spChg>
        <pc:spChg chg="mod">
          <ac:chgData name="Seekings, Amanda" userId="6b110c03-99d0-4cce-a9d3-75045aa72821" providerId="ADAL" clId="{F6593C7C-B30F-45EF-8698-8F7D8F8F845E}" dt="2023-08-16T21:04:05.047" v="148" actId="1038"/>
          <ac:spMkLst>
            <pc:docMk/>
            <pc:sldMk cId="3222327784" sldId="279"/>
            <ac:spMk id="9" creationId="{4B2C20A4-66AB-B0DC-4131-817D76F24538}"/>
          </ac:spMkLst>
        </pc:spChg>
        <pc:graphicFrameChg chg="add del mod">
          <ac:chgData name="Seekings, Amanda" userId="6b110c03-99d0-4cce-a9d3-75045aa72821" providerId="ADAL" clId="{F6593C7C-B30F-45EF-8698-8F7D8F8F845E}" dt="2023-08-16T21:02:42.272" v="128" actId="478"/>
          <ac:graphicFrameMkLst>
            <pc:docMk/>
            <pc:sldMk cId="3222327784" sldId="279"/>
            <ac:graphicFrameMk id="3" creationId="{E03C0CE2-14B2-97BB-2DE5-77B8FEBFF88B}"/>
          </ac:graphicFrameMkLst>
        </pc:graphicFrameChg>
        <pc:graphicFrameChg chg="add del mod">
          <ac:chgData name="Seekings, Amanda" userId="6b110c03-99d0-4cce-a9d3-75045aa72821" providerId="ADAL" clId="{F6593C7C-B30F-45EF-8698-8F7D8F8F845E}" dt="2023-08-16T21:03:27.818" v="131" actId="478"/>
          <ac:graphicFrameMkLst>
            <pc:docMk/>
            <pc:sldMk cId="3222327784" sldId="279"/>
            <ac:graphicFrameMk id="4" creationId="{7F286CCF-B0F2-98AC-7E69-D7617221EB62}"/>
          </ac:graphicFrameMkLst>
        </pc:graphicFrameChg>
        <pc:graphicFrameChg chg="add mod ord">
          <ac:chgData name="Seekings, Amanda" userId="6b110c03-99d0-4cce-a9d3-75045aa72821" providerId="ADAL" clId="{F6593C7C-B30F-45EF-8698-8F7D8F8F845E}" dt="2023-08-16T21:03:59.590" v="136" actId="167"/>
          <ac:graphicFrameMkLst>
            <pc:docMk/>
            <pc:sldMk cId="3222327784" sldId="279"/>
            <ac:graphicFrameMk id="10" creationId="{AA5D9963-E260-CB4A-7F05-665AF77B22A3}"/>
          </ac:graphicFrameMkLst>
        </pc:graphicFrameChg>
        <pc:picChg chg="del">
          <ac:chgData name="Seekings, Amanda" userId="6b110c03-99d0-4cce-a9d3-75045aa72821" providerId="ADAL" clId="{F6593C7C-B30F-45EF-8698-8F7D8F8F845E}" dt="2023-08-16T21:02:16.862" v="122" actId="478"/>
          <ac:picMkLst>
            <pc:docMk/>
            <pc:sldMk cId="3222327784" sldId="279"/>
            <ac:picMk id="5" creationId="{7DA9C366-2DF3-4326-AC19-BC916A7BBC16}"/>
          </ac:picMkLst>
        </pc:picChg>
        <pc:picChg chg="del">
          <ac:chgData name="Seekings, Amanda" userId="6b110c03-99d0-4cce-a9d3-75045aa72821" providerId="ADAL" clId="{F6593C7C-B30F-45EF-8698-8F7D8F8F845E}" dt="2023-08-16T21:02:21.515" v="123" actId="478"/>
          <ac:picMkLst>
            <pc:docMk/>
            <pc:sldMk cId="3222327784" sldId="279"/>
            <ac:picMk id="7" creationId="{BE668DA5-1187-4705-9B7F-3EBA44AB4A68}"/>
          </ac:picMkLst>
        </pc:picChg>
      </pc:sldChg>
      <pc:sldChg chg="addSp modSp new del">
        <pc:chgData name="Seekings, Amanda" userId="6b110c03-99d0-4cce-a9d3-75045aa72821" providerId="ADAL" clId="{F6593C7C-B30F-45EF-8698-8F7D8F8F845E}" dt="2023-08-16T21:04:21.932" v="149" actId="47"/>
        <pc:sldMkLst>
          <pc:docMk/>
          <pc:sldMk cId="1043092118" sldId="280"/>
        </pc:sldMkLst>
        <pc:graphicFrameChg chg="add mod">
          <ac:chgData name="Seekings, Amanda" userId="6b110c03-99d0-4cce-a9d3-75045aa72821" providerId="ADAL" clId="{F6593C7C-B30F-45EF-8698-8F7D8F8F845E}" dt="2023-08-16T21:02:09.686" v="121"/>
          <ac:graphicFrameMkLst>
            <pc:docMk/>
            <pc:sldMk cId="1043092118" sldId="280"/>
            <ac:graphicFrameMk id="4" creationId="{F0A132CA-CB9E-86ED-DD23-26ADD95D068E}"/>
          </ac:graphicFrameMkLst>
        </pc:graphicFrameChg>
      </pc:sldChg>
    </pc:docChg>
  </pc:docChgLst>
  <pc:docChgLst>
    <pc:chgData name="Seekings, Amanda" userId="S::amanda.seekings_apha.gov.uk#ext#@alumni.onmicrosoft.com::b524fe07-63b5-4882-b3a3-c0217ea1c4e1" providerId="AD" clId="Web-{E945FABA-A100-8A72-389E-C9C91E4731BF}"/>
    <pc:docChg chg="addSld delSld">
      <pc:chgData name="Seekings, Amanda" userId="S::amanda.seekings_apha.gov.uk#ext#@alumni.onmicrosoft.com::b524fe07-63b5-4882-b3a3-c0217ea1c4e1" providerId="AD" clId="Web-{E945FABA-A100-8A72-389E-C9C91E4731BF}" dt="2023-07-27T09:17:53.218" v="1"/>
      <pc:docMkLst>
        <pc:docMk/>
      </pc:docMkLst>
      <pc:sldChg chg="add del">
        <pc:chgData name="Seekings, Amanda" userId="S::amanda.seekings_apha.gov.uk#ext#@alumni.onmicrosoft.com::b524fe07-63b5-4882-b3a3-c0217ea1c4e1" providerId="AD" clId="Web-{E945FABA-A100-8A72-389E-C9C91E4731BF}" dt="2023-07-27T09:17:53.218" v="1"/>
        <pc:sldMkLst>
          <pc:docMk/>
          <pc:sldMk cId="1209839087" sldId="257"/>
        </pc:sldMkLst>
      </pc:sldChg>
    </pc:docChg>
  </pc:docChgLst>
  <pc:docChgLst>
    <pc:chgData name="Slomka, Marek" userId="b5697613-81d3-4318-a926-46b10f876ab5" providerId="ADAL" clId="{8E8F3F35-4A9D-49F9-B331-12EA037C5C74}"/>
    <pc:docChg chg="undo custSel modSld">
      <pc:chgData name="Slomka, Marek" userId="b5697613-81d3-4318-a926-46b10f876ab5" providerId="ADAL" clId="{8E8F3F35-4A9D-49F9-B331-12EA037C5C74}" dt="2023-06-08T13:53:20.962" v="456" actId="20577"/>
      <pc:docMkLst>
        <pc:docMk/>
      </pc:docMkLst>
      <pc:sldChg chg="addSp delSp modSp mod">
        <pc:chgData name="Slomka, Marek" userId="b5697613-81d3-4318-a926-46b10f876ab5" providerId="ADAL" clId="{8E8F3F35-4A9D-49F9-B331-12EA037C5C74}" dt="2023-06-06T16:23:12.947" v="129" actId="478"/>
        <pc:sldMkLst>
          <pc:docMk/>
          <pc:sldMk cId="3646838560" sldId="264"/>
        </pc:sldMkLst>
        <pc:spChg chg="add del mod">
          <ac:chgData name="Slomka, Marek" userId="b5697613-81d3-4318-a926-46b10f876ab5" providerId="ADAL" clId="{8E8F3F35-4A9D-49F9-B331-12EA037C5C74}" dt="2023-06-06T16:23:12.947" v="129" actId="478"/>
          <ac:spMkLst>
            <pc:docMk/>
            <pc:sldMk cId="3646838560" sldId="264"/>
            <ac:spMk id="2" creationId="{E71785CD-AE73-50E2-03A2-3DB6458AC75E}"/>
          </ac:spMkLst>
        </pc:spChg>
      </pc:sldChg>
      <pc:sldChg chg="addSp modSp mod">
        <pc:chgData name="Slomka, Marek" userId="b5697613-81d3-4318-a926-46b10f876ab5" providerId="ADAL" clId="{8E8F3F35-4A9D-49F9-B331-12EA037C5C74}" dt="2023-06-08T13:53:20.962" v="456" actId="20577"/>
        <pc:sldMkLst>
          <pc:docMk/>
          <pc:sldMk cId="3612318088" sldId="266"/>
        </pc:sldMkLst>
        <pc:spChg chg="add mod">
          <ac:chgData name="Slomka, Marek" userId="b5697613-81d3-4318-a926-46b10f876ab5" providerId="ADAL" clId="{8E8F3F35-4A9D-49F9-B331-12EA037C5C74}" dt="2023-06-08T13:53:20.962" v="456" actId="20577"/>
          <ac:spMkLst>
            <pc:docMk/>
            <pc:sldMk cId="3612318088" sldId="266"/>
            <ac:spMk id="8" creationId="{49860035-3601-9325-D979-851C3FC9ADE7}"/>
          </ac:spMkLst>
        </pc:spChg>
      </pc:sldChg>
      <pc:sldChg chg="addSp modSp mod modNotesTx">
        <pc:chgData name="Slomka, Marek" userId="b5697613-81d3-4318-a926-46b10f876ab5" providerId="ADAL" clId="{8E8F3F35-4A9D-49F9-B331-12EA037C5C74}" dt="2023-06-06T16:31:07.408" v="239" actId="692"/>
        <pc:sldMkLst>
          <pc:docMk/>
          <pc:sldMk cId="1324013386" sldId="267"/>
        </pc:sldMkLst>
        <pc:spChg chg="add mod">
          <ac:chgData name="Slomka, Marek" userId="b5697613-81d3-4318-a926-46b10f876ab5" providerId="ADAL" clId="{8E8F3F35-4A9D-49F9-B331-12EA037C5C74}" dt="2023-06-06T16:31:07.408" v="239" actId="692"/>
          <ac:spMkLst>
            <pc:docMk/>
            <pc:sldMk cId="1324013386" sldId="267"/>
            <ac:spMk id="8" creationId="{FB1FF65B-DE19-BE88-F70D-933FB6AC1E59}"/>
          </ac:spMkLst>
        </pc:spChg>
      </pc:sldChg>
    </pc:docChg>
  </pc:docChgLst>
  <pc:docChgLst>
    <pc:chgData name="Slomka, Marek" userId="b5697613-81d3-4318-a926-46b10f876ab5" providerId="ADAL" clId="{15258A00-AF41-44FB-AEC0-878C7387709E}"/>
    <pc:docChg chg="undo redo custSel modSld sldOrd">
      <pc:chgData name="Slomka, Marek" userId="b5697613-81d3-4318-a926-46b10f876ab5" providerId="ADAL" clId="{15258A00-AF41-44FB-AEC0-878C7387709E}" dt="2023-08-01T21:46:52.506" v="2200" actId="20577"/>
      <pc:docMkLst>
        <pc:docMk/>
      </pc:docMkLst>
      <pc:sldChg chg="modNotesTx">
        <pc:chgData name="Slomka, Marek" userId="b5697613-81d3-4318-a926-46b10f876ab5" providerId="ADAL" clId="{15258A00-AF41-44FB-AEC0-878C7387709E}" dt="2023-08-01T17:51:13.657" v="458" actId="20577"/>
        <pc:sldMkLst>
          <pc:docMk/>
          <pc:sldMk cId="1209839087" sldId="257"/>
        </pc:sldMkLst>
      </pc:sldChg>
      <pc:sldChg chg="modNotesTx">
        <pc:chgData name="Slomka, Marek" userId="b5697613-81d3-4318-a926-46b10f876ab5" providerId="ADAL" clId="{15258A00-AF41-44FB-AEC0-878C7387709E}" dt="2023-08-01T17:42:50.247" v="159" actId="20577"/>
        <pc:sldMkLst>
          <pc:docMk/>
          <pc:sldMk cId="1506255048" sldId="262"/>
        </pc:sldMkLst>
      </pc:sldChg>
      <pc:sldChg chg="modNotesTx">
        <pc:chgData name="Slomka, Marek" userId="b5697613-81d3-4318-a926-46b10f876ab5" providerId="ADAL" clId="{15258A00-AF41-44FB-AEC0-878C7387709E}" dt="2023-08-01T21:06:40.647" v="1812" actId="20577"/>
        <pc:sldMkLst>
          <pc:docMk/>
          <pc:sldMk cId="3646838560" sldId="264"/>
        </pc:sldMkLst>
      </pc:sldChg>
      <pc:sldChg chg="ord modNotesTx">
        <pc:chgData name="Slomka, Marek" userId="b5697613-81d3-4318-a926-46b10f876ab5" providerId="ADAL" clId="{15258A00-AF41-44FB-AEC0-878C7387709E}" dt="2023-08-01T20:55:18.519" v="1762" actId="20577"/>
        <pc:sldMkLst>
          <pc:docMk/>
          <pc:sldMk cId="3612318088" sldId="266"/>
        </pc:sldMkLst>
      </pc:sldChg>
      <pc:sldChg chg="addSp delSp modSp mod modNotesTx">
        <pc:chgData name="Slomka, Marek" userId="b5697613-81d3-4318-a926-46b10f876ab5" providerId="ADAL" clId="{15258A00-AF41-44FB-AEC0-878C7387709E}" dt="2023-08-01T21:46:52.506" v="2200" actId="20577"/>
        <pc:sldMkLst>
          <pc:docMk/>
          <pc:sldMk cId="1557565970" sldId="272"/>
        </pc:sldMkLst>
        <pc:spChg chg="add del mod">
          <ac:chgData name="Slomka, Marek" userId="b5697613-81d3-4318-a926-46b10f876ab5" providerId="ADAL" clId="{15258A00-AF41-44FB-AEC0-878C7387709E}" dt="2023-08-01T20:48:31.847" v="1736" actId="478"/>
          <ac:spMkLst>
            <pc:docMk/>
            <pc:sldMk cId="1557565970" sldId="272"/>
            <ac:spMk id="2" creationId="{1FBB65A1-D4FB-F179-2035-E7E0E0301019}"/>
          </ac:spMkLst>
        </pc:spChg>
        <pc:graphicFrameChg chg="mod">
          <ac:chgData name="Slomka, Marek" userId="b5697613-81d3-4318-a926-46b10f876ab5" providerId="ADAL" clId="{15258A00-AF41-44FB-AEC0-878C7387709E}" dt="2023-08-01T20:25:27.102" v="1214"/>
          <ac:graphicFrameMkLst>
            <pc:docMk/>
            <pc:sldMk cId="1557565970" sldId="272"/>
            <ac:graphicFrameMk id="10" creationId="{70AD9239-CE67-DA7C-405D-F02C94F92776}"/>
          </ac:graphicFrameMkLst>
        </pc:graphicFrameChg>
      </pc:sldChg>
      <pc:sldChg chg="modNotesTx">
        <pc:chgData name="Slomka, Marek" userId="b5697613-81d3-4318-a926-46b10f876ab5" providerId="ADAL" clId="{15258A00-AF41-44FB-AEC0-878C7387709E}" dt="2023-08-01T17:53:58.763" v="497" actId="20577"/>
        <pc:sldMkLst>
          <pc:docMk/>
          <pc:sldMk cId="354898960" sldId="273"/>
        </pc:sldMkLst>
      </pc:sldChg>
      <pc:sldChg chg="modNotesTx">
        <pc:chgData name="Slomka, Marek" userId="b5697613-81d3-4318-a926-46b10f876ab5" providerId="ADAL" clId="{15258A00-AF41-44FB-AEC0-878C7387709E}" dt="2023-08-01T17:37:43.974" v="94" actId="20577"/>
        <pc:sldMkLst>
          <pc:docMk/>
          <pc:sldMk cId="3335504776" sldId="278"/>
        </pc:sldMkLst>
      </pc:sldChg>
      <pc:sldChg chg="modNotesTx">
        <pc:chgData name="Slomka, Marek" userId="b5697613-81d3-4318-a926-46b10f876ab5" providerId="ADAL" clId="{15258A00-AF41-44FB-AEC0-878C7387709E}" dt="2023-08-01T18:00:00.607" v="710" actId="20577"/>
        <pc:sldMkLst>
          <pc:docMk/>
          <pc:sldMk cId="3222327784" sldId="27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5F4D54-B583-4D57-B024-7AE18805B339}" type="datetimeFigureOut">
              <a:rPr lang="en-GB" smtClean="0"/>
              <a:t>21/09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FD4317-D493-4FDD-9005-F112AC7682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11943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sz="1200" b="0" i="0" u="none" strike="noStrike" baseline="0" dirty="0">
              <a:solidFill>
                <a:srgbClr val="000000"/>
              </a:solidFill>
              <a:latin typeface="+mn-lt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FD4317-D493-4FDD-9005-F112AC76828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677888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FD4317-D493-4FDD-9005-F112AC768284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056931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FD4317-D493-4FDD-9005-F112AC768284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505782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FD4317-D493-4FDD-9005-F112AC768284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859849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FD4317-D493-4FDD-9005-F112AC768284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36033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E0C7A7-E0A6-4982-AE9C-62C1D0BD3C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D6D70E6-8EE8-4A40-8D30-DA28644378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D1B8F6-E4EA-4A6C-8D0B-3A3AD8B7F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45811-7C0E-4CCC-9226-A592A8DAB860}" type="datetimeFigureOut">
              <a:rPr lang="en-GB" smtClean="0"/>
              <a:t>21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E24036-7D69-4E0F-87FE-29C37EF42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3C0004-A886-45FA-954A-DC3E0CE31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ACDAA-B16E-4353-B041-E3EB61AB1C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0976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701810-A7C8-4688-97AB-E3FA8DBC2D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D4EBF5E-F586-4858-91A8-B74E10925C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8046E4-32C4-4752-8704-741FAEF2F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45811-7C0E-4CCC-9226-A592A8DAB860}" type="datetimeFigureOut">
              <a:rPr lang="en-GB" smtClean="0"/>
              <a:t>21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D5B825-5218-4A53-A78F-0B145B9F3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6DB6D7-36EC-48F6-BA97-71961261BE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ACDAA-B16E-4353-B041-E3EB61AB1C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190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BD38730-2D24-46FD-9709-649F8BE870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4EAA63-7D8F-45B7-A7F3-B64814016D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85B3DD-75FB-4630-AD69-5317755EA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45811-7C0E-4CCC-9226-A592A8DAB860}" type="datetimeFigureOut">
              <a:rPr lang="en-GB" smtClean="0"/>
              <a:t>21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9F7A21-3A69-4994-B2A2-37A708C7EE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55AF24-90AA-47C8-95A0-8282286B6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ACDAA-B16E-4353-B041-E3EB61AB1C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12507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4F6409-B769-424E-8A04-00DFB59BF8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841244-B1C4-4C35-8151-08A3DBE917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DAA103-6EED-400D-A726-00E9A723C3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45811-7C0E-4CCC-9226-A592A8DAB860}" type="datetimeFigureOut">
              <a:rPr lang="en-GB" smtClean="0"/>
              <a:t>21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F46D86-FBD8-4BD5-91B2-8B3F41CA8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E6ACC3-DBAA-4EC0-9C59-4359F33CBE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ACDAA-B16E-4353-B041-E3EB61AB1C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0115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E4AA60-0AFC-4152-8789-F7613917AE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7BA6E6-8B7A-4142-86F5-92596E22D2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6FC824-21E5-440C-850E-C9E64EE61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45811-7C0E-4CCC-9226-A592A8DAB860}" type="datetimeFigureOut">
              <a:rPr lang="en-GB" smtClean="0"/>
              <a:t>21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787F20-A235-4EC0-AA7A-188D6B79D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A8051A-139E-4B67-B0CA-68C3DA5813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ACDAA-B16E-4353-B041-E3EB61AB1C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00637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AB703B-2F32-4B00-89ED-3DCA19D5F8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9E9659-7822-44D9-9D6C-C65E7D0E63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C5EDA7-1CEE-4FF9-AB6F-E21EFAADFA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E3574C-EC81-4F46-8508-E4201FB9F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45811-7C0E-4CCC-9226-A592A8DAB860}" type="datetimeFigureOut">
              <a:rPr lang="en-GB" smtClean="0"/>
              <a:t>21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D4CECB-7E7C-4415-B802-A520A6B9CA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6379D3-7B26-4737-9EE9-4D1F03F018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ACDAA-B16E-4353-B041-E3EB61AB1C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3139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17129-D2D6-495D-AF39-C995CF56A9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3383ED-BDF2-4373-809C-C73D7B6666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57D73D-BD95-4420-9940-987F4646F0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B464543-8288-4959-A1C7-7416C9D6C0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2392FE2-4CB7-40B6-9520-FCF874BCD2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43F5A77-8F1E-436C-9CC2-C21C4315A0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45811-7C0E-4CCC-9226-A592A8DAB860}" type="datetimeFigureOut">
              <a:rPr lang="en-GB" smtClean="0"/>
              <a:t>21/09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C60A859-54E5-4516-865A-03BCC4DF3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6358CAB-81F9-4B80-9E9F-B368D12344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ACDAA-B16E-4353-B041-E3EB61AB1C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9312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F69926-76D6-447C-AE88-434E028A2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1977CB7-F552-4559-8B0E-63D0A0D4AA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45811-7C0E-4CCC-9226-A592A8DAB860}" type="datetimeFigureOut">
              <a:rPr lang="en-GB" smtClean="0"/>
              <a:t>21/09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AE59545-A14E-4DF8-B8CC-5DAEBD6C3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DE7B3A3-A6C1-4978-967D-65EF5A89E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ACDAA-B16E-4353-B041-E3EB61AB1C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22627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172F218-06E4-43EE-9C76-F84CF71D7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45811-7C0E-4CCC-9226-A592A8DAB860}" type="datetimeFigureOut">
              <a:rPr lang="en-GB" smtClean="0"/>
              <a:t>21/09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E07A838-EC3F-4CEB-A5B5-C30127AD9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214B25B-6539-4793-B3EF-BD2140B8A9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ACDAA-B16E-4353-B041-E3EB61AB1C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9042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B42641-D16C-424D-AED5-896551F0EE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982626-7D6D-4A01-8484-D1A91C8E5F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797E68-EDC3-4E80-BA57-5D0944A6E4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2E8CC9-EB04-499A-B9DB-4C7BC5E4E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45811-7C0E-4CCC-9226-A592A8DAB860}" type="datetimeFigureOut">
              <a:rPr lang="en-GB" smtClean="0"/>
              <a:t>21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A6702D-155C-402F-9531-EACF6A2D4C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F83796-F1A9-4FAB-AE91-B8F08629A5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ACDAA-B16E-4353-B041-E3EB61AB1C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3275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A24DB4-4C0B-4ADA-932F-68B1DBA44A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2481472-7A59-4FAC-BB39-539F5F7536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B5E4D7-219E-42D2-9DEF-FC2D6D3205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39743E-34A8-471F-AB22-FE6CBAA886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45811-7C0E-4CCC-9226-A592A8DAB860}" type="datetimeFigureOut">
              <a:rPr lang="en-GB" smtClean="0"/>
              <a:t>21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57D9D5-5159-488E-A715-6EEB6C53E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81A118-E886-4EE6-9AA1-2C27F92E5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ACDAA-B16E-4353-B041-E3EB61AB1C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3127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7C0E7BD-5EDA-4143-94D8-2B1BFF1229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69B703-B3D7-42EF-A815-EB9EADED20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91D645-D024-49E4-A66C-B06D585FAB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045811-7C0E-4CCC-9226-A592A8DAB860}" type="datetimeFigureOut">
              <a:rPr lang="en-GB" smtClean="0"/>
              <a:t>21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2A9D6A-CF09-41DA-AC3D-01C34C0F89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245FF9-2CD7-4A7D-9B15-FABF9A0AD7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2ACDAA-B16E-4353-B041-E3EB61AB1C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0490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jpeg"/><Relationship Id="rId4" Type="http://schemas.openxmlformats.org/officeDocument/2006/relationships/image" Target="../media/image8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8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10.em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ktangel 7">
            <a:extLst>
              <a:ext uri="{FF2B5EF4-FFF2-40B4-BE49-F238E27FC236}">
                <a16:creationId xmlns:a16="http://schemas.microsoft.com/office/drawing/2014/main" id="{D76BD509-7718-46EE-A66A-DC9B9483A587}"/>
              </a:ext>
            </a:extLst>
          </p:cNvPr>
          <p:cNvSpPr/>
          <p:nvPr/>
        </p:nvSpPr>
        <p:spPr>
          <a:xfrm rot="16200000">
            <a:off x="-367838" y="1882399"/>
            <a:ext cx="104345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/>
              <a:t>H5N8-2021   </a:t>
            </a:r>
          </a:p>
        </p:txBody>
      </p:sp>
      <p:sp>
        <p:nvSpPr>
          <p:cNvPr id="5" name="Rektangel 63">
            <a:extLst>
              <a:ext uri="{FF2B5EF4-FFF2-40B4-BE49-F238E27FC236}">
                <a16:creationId xmlns:a16="http://schemas.microsoft.com/office/drawing/2014/main" id="{32E33FDE-D4AF-4906-AD87-5359E1BC7D03}"/>
              </a:ext>
            </a:extLst>
          </p:cNvPr>
          <p:cNvSpPr/>
          <p:nvPr/>
        </p:nvSpPr>
        <p:spPr>
          <a:xfrm rot="16200000">
            <a:off x="-393695" y="4955276"/>
            <a:ext cx="10951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sz="1400"/>
              <a:t>H5N1-2021  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CE9859CE-3631-4663-9813-DB27948291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2104962"/>
              </p:ext>
            </p:extLst>
          </p:nvPr>
        </p:nvGraphicFramePr>
        <p:xfrm>
          <a:off x="371560" y="4063496"/>
          <a:ext cx="6007100" cy="2644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7279783" imgH="3203210" progId="Prism8.Document">
                  <p:embed/>
                </p:oleObj>
              </mc:Choice>
              <mc:Fallback>
                <p:oleObj name="Prism 8" r:id="rId3" imgW="7279783" imgH="3203210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CE9859CE-3631-4663-9813-DB27948291A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1560" y="4063496"/>
                        <a:ext cx="6007100" cy="2644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812DBF8F-8191-4E62-BFF4-A85EE328D0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62907"/>
              </p:ext>
            </p:extLst>
          </p:nvPr>
        </p:nvGraphicFramePr>
        <p:xfrm>
          <a:off x="396875" y="1028700"/>
          <a:ext cx="6007100" cy="2593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7307154" imgH="3194206" progId="Prism8.Document">
                  <p:embed/>
                </p:oleObj>
              </mc:Choice>
              <mc:Fallback>
                <p:oleObj name="Prism 8" r:id="rId5" imgW="7307154" imgH="3194206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812DBF8F-8191-4E62-BFF4-A85EE328D02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6875" y="1028700"/>
                        <a:ext cx="6007100" cy="2593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346B696E-763F-4EFE-8D82-1D85E3EE46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0014028"/>
              </p:ext>
            </p:extLst>
          </p:nvPr>
        </p:nvGraphicFramePr>
        <p:xfrm>
          <a:off x="6475969" y="3950552"/>
          <a:ext cx="6231746" cy="257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7737156" imgH="3194206" progId="Prism8.Document">
                  <p:embed/>
                </p:oleObj>
              </mc:Choice>
              <mc:Fallback>
                <p:oleObj name="Prism 8" r:id="rId7" imgW="7737156" imgH="3194206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346B696E-763F-4EFE-8D82-1D85E3EE462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475969" y="3950552"/>
                        <a:ext cx="6231746" cy="257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E15500F2-57E8-4A67-BABA-AE8CD4E4D8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5337382"/>
              </p:ext>
            </p:extLst>
          </p:nvPr>
        </p:nvGraphicFramePr>
        <p:xfrm>
          <a:off x="6475969" y="932011"/>
          <a:ext cx="5638800" cy="2581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6996357" imgH="3205500" progId="Prism8.Document">
                  <p:embed/>
                </p:oleObj>
              </mc:Choice>
              <mc:Fallback>
                <p:oleObj name="Prism 8" r:id="rId9" imgW="6996357" imgH="3205500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E15500F2-57E8-4A67-BABA-AE8CD4E4D84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475969" y="932011"/>
                        <a:ext cx="5638800" cy="2581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172CE76D-038A-4261-94B3-A883AEFA32B4}"/>
              </a:ext>
            </a:extLst>
          </p:cNvPr>
          <p:cNvSpPr txBox="1"/>
          <p:nvPr/>
        </p:nvSpPr>
        <p:spPr>
          <a:xfrm>
            <a:off x="806383" y="274792"/>
            <a:ext cx="17789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Pheasant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2173988-D994-4326-AAFF-7D96CDDD625A}"/>
              </a:ext>
            </a:extLst>
          </p:cNvPr>
          <p:cNvSpPr txBox="1"/>
          <p:nvPr/>
        </p:nvSpPr>
        <p:spPr>
          <a:xfrm>
            <a:off x="6973076" y="301698"/>
            <a:ext cx="17789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Partridge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C03DA60-DDC6-4F2D-B689-3967EF79EAEB}"/>
              </a:ext>
            </a:extLst>
          </p:cNvPr>
          <p:cNvSpPr txBox="1"/>
          <p:nvPr/>
        </p:nvSpPr>
        <p:spPr>
          <a:xfrm>
            <a:off x="252040" y="661482"/>
            <a:ext cx="48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a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65FBBE3-BDDD-4F79-9E08-3973684B8FB5}"/>
              </a:ext>
            </a:extLst>
          </p:cNvPr>
          <p:cNvSpPr txBox="1"/>
          <p:nvPr/>
        </p:nvSpPr>
        <p:spPr>
          <a:xfrm>
            <a:off x="252040" y="3669232"/>
            <a:ext cx="48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b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94BC58E-5FA3-48BB-B937-19C38D961DF1}"/>
              </a:ext>
            </a:extLst>
          </p:cNvPr>
          <p:cNvSpPr txBox="1"/>
          <p:nvPr/>
        </p:nvSpPr>
        <p:spPr>
          <a:xfrm>
            <a:off x="6203597" y="510235"/>
            <a:ext cx="48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c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1BAE922-24EB-4998-BB76-20C7D8A09EDC}"/>
              </a:ext>
            </a:extLst>
          </p:cNvPr>
          <p:cNvSpPr txBox="1"/>
          <p:nvPr/>
        </p:nvSpPr>
        <p:spPr>
          <a:xfrm>
            <a:off x="6354881" y="3591410"/>
            <a:ext cx="48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d)</a:t>
            </a:r>
          </a:p>
        </p:txBody>
      </p:sp>
    </p:spTree>
    <p:extLst>
      <p:ext uri="{BB962C8B-B14F-4D97-AF65-F5344CB8AC3E}">
        <p14:creationId xmlns:p14="http://schemas.microsoft.com/office/powerpoint/2010/main" val="12098390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EB01E9-B875-0F85-95A1-1A640EFB82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4349" y="444695"/>
            <a:ext cx="11627496" cy="4351338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sz="2000" b="1" dirty="0">
                <a:latin typeface="+mn-lt"/>
              </a:rPr>
              <a:t>Fig. S1. Pathogenesis time-course investigation of H5N8-2021 and H5N1-2021 </a:t>
            </a:r>
            <a:r>
              <a:rPr lang="en-GB" sz="2000" b="1" dirty="0" err="1">
                <a:latin typeface="+mn-lt"/>
              </a:rPr>
              <a:t>vRNA</a:t>
            </a:r>
            <a:r>
              <a:rPr lang="en-GB" sz="2000" b="1" dirty="0">
                <a:latin typeface="+mn-lt"/>
              </a:rPr>
              <a:t> loads in organs from (a-b) pheasants and (c-d) partridges.</a:t>
            </a:r>
          </a:p>
          <a:p>
            <a:pPr marL="0" indent="0">
              <a:buNone/>
            </a:pPr>
            <a:r>
              <a:rPr lang="en-GB" sz="2000" dirty="0"/>
              <a:t>Birds were </a:t>
            </a:r>
            <a:r>
              <a:rPr lang="en-GB" sz="2000" dirty="0">
                <a:latin typeface="+mn-lt"/>
              </a:rPr>
              <a:t>inoculated directly with high-doses of the respective viruses. Viral RNA levels are indicated for organs following (a, c) H5N8-2021 and (b-d) H5N1-2021 inoculations, indicating organs sampled at 1, 2 or 3 dpi. All pheasants were apparently healthy at the time of culling, except H5N8-2021 infected #2024 (severe </a:t>
            </a:r>
            <a:r>
              <a:rPr lang="en-GB" sz="2000" dirty="0"/>
              <a:t>clinical signs at 3 dpi, </a:t>
            </a:r>
            <a:r>
              <a:rPr lang="en-GB" sz="2000" dirty="0">
                <a:latin typeface="+mn-lt"/>
              </a:rPr>
              <a:t>therefore promptly euthanised) and H5N1-2021 infected #2047 and #2048 which were found dead at 3 dpi, with no obvious signs observed earlier which suggested sudden death for both.  </a:t>
            </a:r>
            <a:r>
              <a:rPr lang="en-GB" sz="2000" b="0" i="0" u="none" strike="noStrike" baseline="0" dirty="0">
                <a:solidFill>
                  <a:srgbClr val="000000"/>
                </a:solidFill>
                <a:latin typeface="+mn-lt"/>
              </a:rPr>
              <a:t>The positive cut-off for the M-gene RRT-PCR is indicated by the broken horizontal line, with the viral RNA levels denoted as log</a:t>
            </a:r>
            <a:r>
              <a:rPr lang="en-GB" sz="2000" b="0" i="0" u="none" strike="noStrike" baseline="-25000" dirty="0">
                <a:solidFill>
                  <a:srgbClr val="000000"/>
                </a:solidFill>
                <a:latin typeface="+mn-lt"/>
              </a:rPr>
              <a:t>10</a:t>
            </a:r>
            <a:r>
              <a:rPr lang="en-GB" sz="2000" b="0" i="0" u="none" strike="noStrike" baseline="0" dirty="0">
                <a:solidFill>
                  <a:srgbClr val="000000"/>
                </a:solidFill>
                <a:latin typeface="+mn-lt"/>
              </a:rPr>
              <a:t> relative equivalent units (REUs). Individual pheasant identifiers enable direct comparisons to histopathological changes and virus-specific IHC staining, summarised Fig. S3.    </a:t>
            </a:r>
          </a:p>
          <a:p>
            <a:pPr marL="0" indent="0">
              <a:buNone/>
            </a:pP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41602743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B8F2B01-764C-20EA-98B2-DD4E69642E0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726"/>
          <a:stretch/>
        </p:blipFill>
        <p:spPr>
          <a:xfrm>
            <a:off x="127010" y="722079"/>
            <a:ext cx="4888630" cy="380706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714E8B2-AEB6-48CE-43E3-C7CB8A1E22D5}"/>
              </a:ext>
            </a:extLst>
          </p:cNvPr>
          <p:cNvSpPr txBox="1"/>
          <p:nvPr/>
        </p:nvSpPr>
        <p:spPr>
          <a:xfrm>
            <a:off x="5830371" y="3113117"/>
            <a:ext cx="3765884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/>
              <a:t>c) H5N1-202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6DC1167-866C-E6CF-23CB-D2705AA42B19}"/>
              </a:ext>
            </a:extLst>
          </p:cNvPr>
          <p:cNvSpPr txBox="1"/>
          <p:nvPr/>
        </p:nvSpPr>
        <p:spPr>
          <a:xfrm>
            <a:off x="5901677" y="272689"/>
            <a:ext cx="3910475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/>
              <a:t>b) H5N8-2021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5E987FCD-A44C-0D49-5936-EC194E7B562F}"/>
              </a:ext>
            </a:extLst>
          </p:cNvPr>
          <p:cNvGrpSpPr/>
          <p:nvPr/>
        </p:nvGrpSpPr>
        <p:grpSpPr>
          <a:xfrm>
            <a:off x="5830371" y="640083"/>
            <a:ext cx="5076133" cy="2331373"/>
            <a:chOff x="-172232" y="1444896"/>
            <a:chExt cx="6197848" cy="2987572"/>
          </a:xfrm>
        </p:grpSpPr>
        <p:pic>
          <p:nvPicPr>
            <p:cNvPr id="6" name="Picture 4" descr="Background pattern&#10;&#10;Description automatically generated">
              <a:extLst>
                <a:ext uri="{FF2B5EF4-FFF2-40B4-BE49-F238E27FC236}">
                  <a16:creationId xmlns:a16="http://schemas.microsoft.com/office/drawing/2014/main" id="{3A770CA1-7CA0-E40D-84AE-858D236C36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068" b="64585"/>
            <a:stretch/>
          </p:blipFill>
          <p:spPr>
            <a:xfrm>
              <a:off x="357826" y="1444896"/>
              <a:ext cx="5667790" cy="155548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3BBDE6A-5AB7-BC9F-3270-35D9C9590ECF}"/>
                </a:ext>
              </a:extLst>
            </p:cNvPr>
            <p:cNvSpPr txBox="1"/>
            <p:nvPr/>
          </p:nvSpPr>
          <p:spPr>
            <a:xfrm rot="16200000">
              <a:off x="-425763" y="2109668"/>
              <a:ext cx="96872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/>
                <a:t>D0 Pheasant</a:t>
              </a:r>
            </a:p>
            <a:p>
              <a:pPr algn="ctr"/>
              <a:r>
                <a:rPr lang="en-GB" sz="1200"/>
                <a:t>#2016</a:t>
              </a:r>
            </a:p>
          </p:txBody>
        </p:sp>
        <p:pic>
          <p:nvPicPr>
            <p:cNvPr id="8" name="Picture 7" descr="Background pattern&#10;&#10;Description automatically generated">
              <a:extLst>
                <a:ext uri="{FF2B5EF4-FFF2-40B4-BE49-F238E27FC236}">
                  <a16:creationId xmlns:a16="http://schemas.microsoft.com/office/drawing/2014/main" id="{3DD2EBE2-0C55-11A9-7E99-1C541742D4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068" t="67394"/>
            <a:stretch/>
          </p:blipFill>
          <p:spPr>
            <a:xfrm>
              <a:off x="357826" y="3000376"/>
              <a:ext cx="5667790" cy="1432092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D4147AE-D002-E7D7-B8F4-73F49924E8D0}"/>
                </a:ext>
              </a:extLst>
            </p:cNvPr>
            <p:cNvSpPr txBox="1"/>
            <p:nvPr/>
          </p:nvSpPr>
          <p:spPr>
            <a:xfrm rot="16200000">
              <a:off x="-375107" y="3524850"/>
              <a:ext cx="8674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/>
                <a:t>R2 Chicken</a:t>
              </a:r>
            </a:p>
            <a:p>
              <a:pPr algn="ctr"/>
              <a:r>
                <a:rPr lang="en-GB" sz="1200"/>
                <a:t>#2194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AF652DF3-099B-E123-1430-38B8750414D7}"/>
              </a:ext>
            </a:extLst>
          </p:cNvPr>
          <p:cNvGrpSpPr/>
          <p:nvPr/>
        </p:nvGrpSpPr>
        <p:grpSpPr>
          <a:xfrm>
            <a:off x="5789551" y="3468756"/>
            <a:ext cx="5126892" cy="3355472"/>
            <a:chOff x="5982001" y="1444893"/>
            <a:chExt cx="6192289" cy="4340854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4CDED69-8C28-D9C4-1AE3-17C952652E7D}"/>
                </a:ext>
              </a:extLst>
            </p:cNvPr>
            <p:cNvSpPr txBox="1"/>
            <p:nvPr/>
          </p:nvSpPr>
          <p:spPr>
            <a:xfrm rot="16200000">
              <a:off x="5729692" y="2147374"/>
              <a:ext cx="1003993" cy="461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/>
                <a:t> D0 Pheasant</a:t>
              </a:r>
            </a:p>
            <a:p>
              <a:pPr algn="ctr"/>
              <a:r>
                <a:rPr lang="en-GB" sz="1200"/>
                <a:t>#2042</a:t>
              </a:r>
            </a:p>
          </p:txBody>
        </p:sp>
        <p:pic>
          <p:nvPicPr>
            <p:cNvPr id="12" name="Picture 4" descr="A picture containing background pattern&#10;&#10;Description automatically generated">
              <a:extLst>
                <a:ext uri="{FF2B5EF4-FFF2-40B4-BE49-F238E27FC236}">
                  <a16:creationId xmlns:a16="http://schemas.microsoft.com/office/drawing/2014/main" id="{C1914BFB-786C-DA42-BD17-430246A0F7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118" b="64802"/>
            <a:stretch/>
          </p:blipFill>
          <p:spPr>
            <a:xfrm>
              <a:off x="6505357" y="1444893"/>
              <a:ext cx="5668933" cy="1545958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B6CCE99-F4BA-B3D8-9F03-D7C00355D2C4}"/>
                </a:ext>
              </a:extLst>
            </p:cNvPr>
            <p:cNvSpPr txBox="1"/>
            <p:nvPr/>
          </p:nvSpPr>
          <p:spPr>
            <a:xfrm rot="16200000">
              <a:off x="5761113" y="3526651"/>
              <a:ext cx="941156" cy="461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/>
                <a:t>R2a Chicken</a:t>
              </a:r>
            </a:p>
            <a:p>
              <a:pPr algn="ctr"/>
              <a:r>
                <a:rPr lang="en-GB" sz="1200"/>
                <a:t>#2201</a:t>
              </a:r>
            </a:p>
          </p:txBody>
        </p:sp>
        <p:pic>
          <p:nvPicPr>
            <p:cNvPr id="14" name="Picture 4" descr="A picture containing background pattern&#10;&#10;Description automatically generated">
              <a:extLst>
                <a:ext uri="{FF2B5EF4-FFF2-40B4-BE49-F238E27FC236}">
                  <a16:creationId xmlns:a16="http://schemas.microsoft.com/office/drawing/2014/main" id="{964C6CE1-598D-63E7-EFE3-31C921AF05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118" t="67995"/>
            <a:stretch/>
          </p:blipFill>
          <p:spPr>
            <a:xfrm>
              <a:off x="6505355" y="2990851"/>
              <a:ext cx="5668933" cy="1405711"/>
            </a:xfrm>
            <a:prstGeom prst="rect">
              <a:avLst/>
            </a:prstGeom>
          </p:spPr>
        </p:pic>
        <p:pic>
          <p:nvPicPr>
            <p:cNvPr id="15" name="Picture 14" descr="Background pattern&#10;&#10;Description automatically generated">
              <a:extLst>
                <a:ext uri="{FF2B5EF4-FFF2-40B4-BE49-F238E27FC236}">
                  <a16:creationId xmlns:a16="http://schemas.microsoft.com/office/drawing/2014/main" id="{6D903488-D6ED-54C8-6EFA-02FFFC9559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068" t="35451" b="32920"/>
            <a:stretch/>
          </p:blipFill>
          <p:spPr>
            <a:xfrm>
              <a:off x="6505355" y="4396562"/>
              <a:ext cx="5667790" cy="1389185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6BB22C4-A13F-EDA2-608A-7A871D6A821A}"/>
                </a:ext>
              </a:extLst>
            </p:cNvPr>
            <p:cNvSpPr txBox="1"/>
            <p:nvPr/>
          </p:nvSpPr>
          <p:spPr>
            <a:xfrm rot="16200000">
              <a:off x="5835069" y="4804767"/>
              <a:ext cx="755528" cy="461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/>
                <a:t>Partridge</a:t>
              </a:r>
            </a:p>
            <a:p>
              <a:pPr algn="ctr"/>
              <a:r>
                <a:rPr lang="en-GB" sz="1200"/>
                <a:t>#2166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2AA77D4F-FA6B-2CF6-17B3-2732D392C078}"/>
              </a:ext>
            </a:extLst>
          </p:cNvPr>
          <p:cNvSpPr txBox="1"/>
          <p:nvPr/>
        </p:nvSpPr>
        <p:spPr>
          <a:xfrm>
            <a:off x="127010" y="220858"/>
            <a:ext cx="27755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/>
              <a:t>a) Gross pathology</a:t>
            </a:r>
            <a:endParaRPr lang="en-GB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8EDB27E-6212-B1CD-37F3-FD67097D7D4E}"/>
              </a:ext>
            </a:extLst>
          </p:cNvPr>
          <p:cNvSpPr txBox="1"/>
          <p:nvPr/>
        </p:nvSpPr>
        <p:spPr>
          <a:xfrm>
            <a:off x="151074" y="1089396"/>
            <a:ext cx="91440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1-3 dpi</a:t>
            </a:r>
          </a:p>
        </p:txBody>
      </p:sp>
    </p:spTree>
    <p:extLst>
      <p:ext uri="{BB962C8B-B14F-4D97-AF65-F5344CB8AC3E}">
        <p14:creationId xmlns:p14="http://schemas.microsoft.com/office/powerpoint/2010/main" val="3548989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BBACA1-634D-7A2A-3AA2-745263FBB2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2359" y="519338"/>
            <a:ext cx="11607281" cy="1887959"/>
          </a:xfrm>
        </p:spPr>
        <p:txBody>
          <a:bodyPr/>
          <a:lstStyle/>
          <a:p>
            <a:pPr marL="0" indent="0">
              <a:buNone/>
            </a:pPr>
            <a:r>
              <a:rPr lang="en-GB" sz="20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. S2.  Gross pathology at </a:t>
            </a:r>
            <a:r>
              <a:rPr lang="en-GB" sz="2000" b="1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st-mortem</a:t>
            </a:r>
            <a:r>
              <a:rPr lang="en-GB" sz="20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histopathological changes and viral antigen detection by IHC staining. </a:t>
            </a:r>
          </a:p>
          <a:p>
            <a:pPr marL="0" indent="0">
              <a:buNone/>
            </a:pPr>
            <a:r>
              <a:rPr lang="en-GB" sz="20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</a:t>
            </a:r>
            <a:r>
              <a:rPr lang="en-GB" sz="20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ross lesions observed in the pheasant and chicken mortalities; </a:t>
            </a:r>
            <a:r>
              <a:rPr lang="en-GB" sz="20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uth</a:t>
            </a:r>
            <a:r>
              <a:rPr lang="en-GB" sz="20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euthanised; F. Dead = found dead. </a:t>
            </a:r>
            <a:r>
              <a:rPr lang="en-GB" sz="2000" dirty="0"/>
              <a:t>Histopathological changes and virus-specific IHC (inset) staining in heart, lung and spleen tissues are shown for pheasants, partridges and chickens infected with (b) H5N8-2021 and (c) H5N1-2021, after sampling at clinical endpoints. Black arrows indicate areas of necrosis.</a:t>
            </a:r>
          </a:p>
          <a:p>
            <a:pPr marL="0" indent="0">
              <a:buNone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18467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AA5D9963-E260-CB4A-7F05-665AF77B22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0047092"/>
              </p:ext>
            </p:extLst>
          </p:nvPr>
        </p:nvGraphicFramePr>
        <p:xfrm>
          <a:off x="30914" y="508110"/>
          <a:ext cx="6948707" cy="5837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8976743" imgH="7540107" progId="Prism8.Document">
                  <p:embed/>
                </p:oleObj>
              </mc:Choice>
              <mc:Fallback>
                <p:oleObj name="Prism 8" r:id="rId3" imgW="8976743" imgH="7540107" progId="Prism8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AA5D9963-E260-CB4A-7F05-665AF77B22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914" y="508110"/>
                        <a:ext cx="6948707" cy="5837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BDD44AA-39F7-40D6-48C8-C30DAF1D35F7}"/>
              </a:ext>
            </a:extLst>
          </p:cNvPr>
          <p:cNvSpPr txBox="1"/>
          <p:nvPr/>
        </p:nvSpPr>
        <p:spPr>
          <a:xfrm>
            <a:off x="0" y="3609725"/>
            <a:ext cx="48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5F2C722-93B7-ABCE-509B-D5AC5D4CE9F6}"/>
              </a:ext>
            </a:extLst>
          </p:cNvPr>
          <p:cNvSpPr txBox="1"/>
          <p:nvPr/>
        </p:nvSpPr>
        <p:spPr>
          <a:xfrm>
            <a:off x="0" y="361450"/>
            <a:ext cx="48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a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864B623-B9D6-F443-4E5C-71462551EE65}"/>
              </a:ext>
            </a:extLst>
          </p:cNvPr>
          <p:cNvSpPr txBox="1"/>
          <p:nvPr/>
        </p:nvSpPr>
        <p:spPr>
          <a:xfrm>
            <a:off x="3802791" y="340225"/>
            <a:ext cx="48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c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B2C20A4-66AB-B0DC-4131-817D76F24538}"/>
              </a:ext>
            </a:extLst>
          </p:cNvPr>
          <p:cNvSpPr txBox="1"/>
          <p:nvPr/>
        </p:nvSpPr>
        <p:spPr>
          <a:xfrm>
            <a:off x="3549832" y="3657598"/>
            <a:ext cx="4159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d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8915E70-529C-D39E-B155-367EBA37DF78}"/>
              </a:ext>
            </a:extLst>
          </p:cNvPr>
          <p:cNvSpPr txBox="1"/>
          <p:nvPr/>
        </p:nvSpPr>
        <p:spPr>
          <a:xfrm>
            <a:off x="7293626" y="338118"/>
            <a:ext cx="48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e)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16A7C098-AE3A-71C3-E858-998A12278374}"/>
              </a:ext>
            </a:extLst>
          </p:cNvPr>
          <p:cNvGrpSpPr/>
          <p:nvPr/>
        </p:nvGrpSpPr>
        <p:grpSpPr>
          <a:xfrm>
            <a:off x="7031485" y="909672"/>
            <a:ext cx="5123228" cy="5033928"/>
            <a:chOff x="1755891" y="636512"/>
            <a:chExt cx="5235579" cy="5017916"/>
          </a:xfrm>
        </p:grpSpPr>
        <p:pic>
          <p:nvPicPr>
            <p:cNvPr id="13" name="Picture 4" descr="A picture containing map&#10;&#10;Description automatically generated">
              <a:extLst>
                <a:ext uri="{FF2B5EF4-FFF2-40B4-BE49-F238E27FC236}">
                  <a16:creationId xmlns:a16="http://schemas.microsoft.com/office/drawing/2014/main" id="{D68796C7-0664-1ED4-D147-20B9D4D489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681"/>
            <a:stretch/>
          </p:blipFill>
          <p:spPr>
            <a:xfrm>
              <a:off x="2271860" y="636513"/>
              <a:ext cx="4719610" cy="5017915"/>
            </a:xfrm>
            <a:prstGeom prst="rect">
              <a:avLst/>
            </a:prstGeom>
          </p:spPr>
        </p:pic>
        <p:pic>
          <p:nvPicPr>
            <p:cNvPr id="14" name="Picture 13" descr="A picture containing map&#10;&#10;Description automatically generated">
              <a:extLst>
                <a:ext uri="{FF2B5EF4-FFF2-40B4-BE49-F238E27FC236}">
                  <a16:creationId xmlns:a16="http://schemas.microsoft.com/office/drawing/2014/main" id="{8386E747-1F7A-EF50-B353-42F848C426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91981"/>
            <a:stretch/>
          </p:blipFill>
          <p:spPr>
            <a:xfrm>
              <a:off x="1755891" y="636512"/>
              <a:ext cx="409968" cy="5017915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45DCC79-35F6-2035-8F93-057B38ADE1D4}"/>
                </a:ext>
              </a:extLst>
            </p:cNvPr>
            <p:cNvSpPr txBox="1"/>
            <p:nvPr/>
          </p:nvSpPr>
          <p:spPr>
            <a:xfrm rot="16200000">
              <a:off x="1948025" y="1238234"/>
              <a:ext cx="5853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/>
                <a:t>#2024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9AFDD3A-D6CB-3D14-9D46-1299E5DBC8D0}"/>
                </a:ext>
              </a:extLst>
            </p:cNvPr>
            <p:cNvSpPr txBox="1"/>
            <p:nvPr/>
          </p:nvSpPr>
          <p:spPr>
            <a:xfrm rot="16200000">
              <a:off x="1945538" y="2463591"/>
              <a:ext cx="5853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/>
                <a:t>#2048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AE74FDB-BD9C-A570-1451-C47C10B429AA}"/>
                </a:ext>
              </a:extLst>
            </p:cNvPr>
            <p:cNvSpPr txBox="1"/>
            <p:nvPr/>
          </p:nvSpPr>
          <p:spPr>
            <a:xfrm rot="16200000">
              <a:off x="1929829" y="3692346"/>
              <a:ext cx="5853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/>
                <a:t>#2149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F210253-E19C-9A05-0C5A-5433E76FE528}"/>
                </a:ext>
              </a:extLst>
            </p:cNvPr>
            <p:cNvSpPr txBox="1"/>
            <p:nvPr/>
          </p:nvSpPr>
          <p:spPr>
            <a:xfrm rot="16200000">
              <a:off x="1945539" y="4897714"/>
              <a:ext cx="5853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/>
                <a:t>#216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223277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9E62BE-87BA-C33B-F1D9-00E389F328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35599" y="388711"/>
            <a:ext cx="11720802" cy="4351338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sz="2000" b="1" dirty="0"/>
              <a:t>Fig. S3.  Pathogenesis investigation: Histopathological changes and </a:t>
            </a:r>
            <a:r>
              <a:rPr lang="en-GB" sz="20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iral antigen detection by IHC staining in pheasants and partridges infected with H5N8-2021 and H5N1-2021.</a:t>
            </a:r>
            <a:endParaRPr lang="en-GB" sz="2000" b="1" dirty="0"/>
          </a:p>
          <a:p>
            <a:pPr marL="0" indent="0">
              <a:buNone/>
            </a:pPr>
            <a:r>
              <a:rPr lang="en-GB" sz="2000" dirty="0"/>
              <a:t>(a, c) Histopathology and (b, d) virus-specific immunohistochemistry scores for pheasants (a-b) and partridges (c-d) directly inoculated with both viruses, where black fields indicated tissue specimens which were not tested. Inoculated birds are distinguished by the NA subtype (N8 = H5N8-2021; N1 = H5N1-2021) and include uninfected controls (</a:t>
            </a:r>
            <a:r>
              <a:rPr lang="en-GB" sz="2000" dirty="0" err="1"/>
              <a:t>Uninf</a:t>
            </a:r>
            <a:r>
              <a:rPr lang="en-GB" sz="2000" dirty="0"/>
              <a:t>), sampled at 1, 2 and 3 dpi during the pathogenesis time-course investigation. Histopathological changes and IHC staining in the feathers includes the calami and associated follicles. (e) Representative virus-specific IHC staining in the heart, brain and kidney tissues from the pathogenesis time-course experiment in pheasants and partridges directly infected with H5N8-2021 and H5N1-2021, sampled at 3 days post-infection. The black arrow indicates low level positive staining in the kidney from partridge #2163 infected with H5N1-2021.</a:t>
            </a:r>
          </a:p>
        </p:txBody>
      </p:sp>
    </p:spTree>
    <p:extLst>
      <p:ext uri="{BB962C8B-B14F-4D97-AF65-F5344CB8AC3E}">
        <p14:creationId xmlns:p14="http://schemas.microsoft.com/office/powerpoint/2010/main" val="10499226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F856BDA-AB7E-C9AC-CBB4-6C77BD1DDB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9315584"/>
              </p:ext>
            </p:extLst>
          </p:nvPr>
        </p:nvGraphicFramePr>
        <p:xfrm>
          <a:off x="197872" y="761556"/>
          <a:ext cx="7291388" cy="3011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7738596" imgH="3194206" progId="Prism8.Document">
                  <p:embed/>
                </p:oleObj>
              </mc:Choice>
              <mc:Fallback>
                <p:oleObj name="Prism 8" r:id="rId3" imgW="7738596" imgH="3194206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F856BDA-AB7E-C9AC-CBB4-6C77BD1DDB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7872" y="761556"/>
                        <a:ext cx="7291388" cy="3011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ECB01A6D-7951-C6D8-7FCE-D8CE8489EA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879064"/>
              </p:ext>
            </p:extLst>
          </p:nvPr>
        </p:nvGraphicFramePr>
        <p:xfrm>
          <a:off x="7489260" y="382966"/>
          <a:ext cx="3973513" cy="6078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5368183" imgH="8220876" progId="Prism8.Document">
                  <p:embed/>
                </p:oleObj>
              </mc:Choice>
              <mc:Fallback>
                <p:oleObj name="Prism 8" r:id="rId5" imgW="5368183" imgH="8220876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ECB01A6D-7951-C6D8-7FCE-D8CE8489EA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489260" y="382966"/>
                        <a:ext cx="3973513" cy="6078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70AD9239-CE67-DA7C-405D-F02C94F927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7046937"/>
              </p:ext>
            </p:extLst>
          </p:nvPr>
        </p:nvGraphicFramePr>
        <p:xfrm>
          <a:off x="328613" y="3881438"/>
          <a:ext cx="6718300" cy="2851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7528277" imgH="3194206" progId="Prism8.Document">
                  <p:embed/>
                </p:oleObj>
              </mc:Choice>
              <mc:Fallback>
                <p:oleObj name="Prism 8" r:id="rId7" imgW="7528277" imgH="3194206" progId="Prism8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70AD9239-CE67-DA7C-405D-F02C94F9277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28613" y="3881438"/>
                        <a:ext cx="6718300" cy="2851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2D32BB12-E1DC-1EF2-5987-67B105D71F09}"/>
              </a:ext>
            </a:extLst>
          </p:cNvPr>
          <p:cNvSpPr txBox="1"/>
          <p:nvPr/>
        </p:nvSpPr>
        <p:spPr>
          <a:xfrm>
            <a:off x="7247116" y="361450"/>
            <a:ext cx="48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c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EF2C36D-3FF6-0432-6115-EE1ABAC00DC4}"/>
              </a:ext>
            </a:extLst>
          </p:cNvPr>
          <p:cNvSpPr txBox="1"/>
          <p:nvPr/>
        </p:nvSpPr>
        <p:spPr>
          <a:xfrm>
            <a:off x="197872" y="3640974"/>
            <a:ext cx="48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b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E8C946-ACE7-5F01-23A7-E66963242091}"/>
              </a:ext>
            </a:extLst>
          </p:cNvPr>
          <p:cNvSpPr txBox="1"/>
          <p:nvPr/>
        </p:nvSpPr>
        <p:spPr>
          <a:xfrm>
            <a:off x="7247116" y="3689238"/>
            <a:ext cx="48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d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47BF6B1-33D9-5619-EED2-33E737820841}"/>
              </a:ext>
            </a:extLst>
          </p:cNvPr>
          <p:cNvSpPr txBox="1"/>
          <p:nvPr/>
        </p:nvSpPr>
        <p:spPr>
          <a:xfrm>
            <a:off x="432311" y="361450"/>
            <a:ext cx="48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a)</a:t>
            </a:r>
          </a:p>
        </p:txBody>
      </p:sp>
    </p:spTree>
    <p:extLst>
      <p:ext uri="{BB962C8B-B14F-4D97-AF65-F5344CB8AC3E}">
        <p14:creationId xmlns:p14="http://schemas.microsoft.com/office/powerpoint/2010/main" val="15575659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E65092-C0B9-7D34-CAF0-252226C813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72715" y="365793"/>
            <a:ext cx="11710737" cy="4351338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sz="2000" b="1" dirty="0"/>
              <a:t>Fig. S4. Analysis of partridge tissues following deaths caused by H5N8-2021 and H5N1-2021 infections. </a:t>
            </a:r>
          </a:p>
          <a:p>
            <a:pPr marL="0" indent="0">
              <a:buNone/>
            </a:pPr>
            <a:r>
              <a:rPr lang="en-GB" sz="2000" dirty="0"/>
              <a:t>(a) Organ </a:t>
            </a:r>
            <a:r>
              <a:rPr lang="en-GB" sz="2000" dirty="0" err="1"/>
              <a:t>vRNA</a:t>
            </a:r>
            <a:r>
              <a:rPr lang="en-GB" sz="2000" dirty="0"/>
              <a:t> loads in the two H5N8-2021 infected (after direct inoculation) partridges which died but did </a:t>
            </a:r>
            <a:r>
              <a:rPr lang="en-GB" sz="2000" u="sng" dirty="0"/>
              <a:t>not</a:t>
            </a:r>
            <a:r>
              <a:rPr lang="en-GB" sz="2000" dirty="0"/>
              <a:t> shed H5N8-2021 during the MID</a:t>
            </a:r>
            <a:r>
              <a:rPr lang="en-GB" sz="2000" baseline="-25000" dirty="0"/>
              <a:t>50</a:t>
            </a:r>
            <a:r>
              <a:rPr lang="en-GB" sz="2000" dirty="0"/>
              <a:t> investigation in the high-dose pen (partridges # 2142 and 2140, see Figure 3a and b); and the one H5N8-2021 infected R1 partridge (which also died and did not shed H5N8-2021) from transmission chain B.1 (partridge #2106, see Figure 5a and b). (b) Organ </a:t>
            </a:r>
            <a:r>
              <a:rPr lang="en-GB" sz="2000" dirty="0" err="1"/>
              <a:t>vRNA</a:t>
            </a:r>
            <a:r>
              <a:rPr lang="en-GB" sz="2000" dirty="0"/>
              <a:t> loads in five H5N1-2021 infected partridges which did shed the virus and died during the MID</a:t>
            </a:r>
            <a:r>
              <a:rPr lang="en-GB" sz="2000" baseline="-25000" dirty="0"/>
              <a:t>50</a:t>
            </a:r>
            <a:r>
              <a:rPr lang="en-GB" sz="2000" dirty="0"/>
              <a:t> investigation in the high-dose pen, with black and blue symbols indicating D0 and R1 partridges respectively (D0 partridges # 2166 and 2164, R1 partridges # 2123, 2120 and 2125; see Figure 3c and d); and green symbols indicating the </a:t>
            </a:r>
            <a:r>
              <a:rPr lang="en-GB" sz="2000" dirty="0">
                <a:solidFill>
                  <a:schemeClr val="tx1"/>
                </a:solidFill>
              </a:rPr>
              <a:t>one H5N1-2021 infected R1 partridge (# 2111) from transmission chain B.2 which also died (see Figure 5d).  (c) Histopathology and (d) virus-specific IHC scores for tissues from partridges infected with H5N8-2021 and H5N1-2021 (as indicated), obtained from the high-dose MID</a:t>
            </a:r>
            <a:r>
              <a:rPr lang="en-GB" sz="2000" baseline="-25000" dirty="0">
                <a:solidFill>
                  <a:schemeClr val="tx1"/>
                </a:solidFill>
              </a:rPr>
              <a:t>50</a:t>
            </a:r>
            <a:r>
              <a:rPr lang="en-GB" sz="2000" dirty="0">
                <a:solidFill>
                  <a:schemeClr val="tx1"/>
                </a:solidFill>
              </a:rPr>
              <a:t> investigations </a:t>
            </a:r>
            <a:r>
              <a:rPr lang="en-GB" sz="2000" b="0" i="0" dirty="0">
                <a:solidFill>
                  <a:schemeClr val="tx1"/>
                </a:solidFill>
              </a:rPr>
              <a:t>(H5N8-2021: D0 partridges # 2142 and 2140; H5N1-2021: D0 partridges # 2166 and 2165, R1 partridges # 2123 and 2120), and the transmission chains (H5N8-2021: R1 partridge # 2106; H5N1-2021: R1 partridge # 2111). </a:t>
            </a:r>
            <a:r>
              <a:rPr lang="en-GB" sz="2000" dirty="0"/>
              <a:t>Histopathological changes and IHC staining in the feathers includes the calami and associated follicles. Black fields in (c) and (d) indicate tissue specimens which were not tested.</a:t>
            </a:r>
            <a:endParaRPr lang="en-GB" sz="2000" b="0" i="0" dirty="0">
              <a:solidFill>
                <a:schemeClr val="tx1"/>
              </a:solidFill>
            </a:endParaRPr>
          </a:p>
          <a:p>
            <a:pPr marL="0" indent="0">
              <a:buNone/>
            </a:pP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248765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662745e8-e224-48e8-a2e3-254862b8c2f5">
      <Value>6</Value>
      <Value>5</Value>
      <Value>3</Value>
      <Value>2</Value>
      <Value>1</Value>
    </TaxCatchAll>
    <cf401361b24e474cb011be6eb76c0e76 xmlns="662745e8-e224-48e8-a2e3-254862b8c2f5">
      <Terms xmlns="http://schemas.microsoft.com/office/infopath/2007/PartnerControls">
        <TermInfo xmlns="http://schemas.microsoft.com/office/infopath/2007/PartnerControls">
          <TermName xmlns="http://schemas.microsoft.com/office/infopath/2007/PartnerControls">Crown</TermName>
          <TermId xmlns="http://schemas.microsoft.com/office/infopath/2007/PartnerControls">69589897-2828-4761-976e-717fd8e631c9</TermId>
        </TermInfo>
      </Terms>
    </cf401361b24e474cb011be6eb76c0e76>
    <k85d23755b3a46b5a51451cf336b2e9b xmlns="662745e8-e224-48e8-a2e3-254862b8c2f5">
      <Terms xmlns="http://schemas.microsoft.com/office/infopath/2007/PartnerControls"/>
    </k85d23755b3a46b5a51451cf336b2e9b>
    <Topic xmlns="662745e8-e224-48e8-a2e3-254862b8c2f5">VI6 - Outputs</Topic>
    <HOMigrated xmlns="662745e8-e224-48e8-a2e3-254862b8c2f5">false</HOMigrated>
    <ddeb1fd0a9ad4436a96525d34737dc44 xmlns="662745e8-e224-48e8-a2e3-254862b8c2f5">
      <Terms xmlns="http://schemas.microsoft.com/office/infopath/2007/PartnerControls">
        <TermInfo xmlns="http://schemas.microsoft.com/office/infopath/2007/PartnerControls">
          <TermName xmlns="http://schemas.microsoft.com/office/infopath/2007/PartnerControls">Internal APHA</TermName>
          <TermId xmlns="http://schemas.microsoft.com/office/infopath/2007/PartnerControls">c4c48635-cc8c-496b-abb6-4a15e2e963ca</TermId>
        </TermInfo>
      </Terms>
    </ddeb1fd0a9ad4436a96525d34737dc44>
    <lae2bfa7b6474897ab4a53f76ea236c7 xmlns="662745e8-e224-48e8-a2e3-254862b8c2f5">
      <Terms xmlns="http://schemas.microsoft.com/office/infopath/2007/PartnerControls">
        <TermInfo xmlns="http://schemas.microsoft.com/office/infopath/2007/PartnerControls">
          <TermName xmlns="http://schemas.microsoft.com/office/infopath/2007/PartnerControls">Official</TermName>
          <TermId xmlns="http://schemas.microsoft.com/office/infopath/2007/PartnerControls">14c80daa-741b-422c-9722-f71693c9ede4</TermId>
        </TermInfo>
      </Terms>
    </lae2bfa7b6474897ab4a53f76ea236c7>
    <fe59e9859d6a491389c5b03567f5dda5 xmlns="662745e8-e224-48e8-a2e3-254862b8c2f5">
      <Terms xmlns="http://schemas.microsoft.com/office/infopath/2007/PartnerControls">
        <TermInfo xmlns="http://schemas.microsoft.com/office/infopath/2007/PartnerControls">
          <TermName xmlns="http://schemas.microsoft.com/office/infopath/2007/PartnerControls">APHA</TermName>
          <TermId xmlns="http://schemas.microsoft.com/office/infopath/2007/PartnerControls">8cfe9d61-c27f-47b7-a138-543088555a27</TermId>
        </TermInfo>
      </Terms>
    </fe59e9859d6a491389c5b03567f5dda5>
    <Team xmlns="662745e8-e224-48e8-a2e3-254862b8c2f5">Virology</Team>
    <n7493b4506bf40e28c373b1e51a33445 xmlns="662745e8-e224-48e8-a2e3-254862b8c2f5">
      <Terms xmlns="http://schemas.microsoft.com/office/infopath/2007/PartnerControls">
        <TermInfo xmlns="http://schemas.microsoft.com/office/infopath/2007/PartnerControls">
          <TermName xmlns="http://schemas.microsoft.com/office/infopath/2007/PartnerControls">Team</TermName>
          <TermId xmlns="http://schemas.microsoft.com/office/infopath/2007/PartnerControls">ff0485df-0575-416f-802f-e999165821b7</TermId>
        </TermInfo>
      </Terms>
    </n7493b4506bf40e28c373b1e51a33445>
    <Date xmlns="2a9c46a1-a1df-4fee-bf10-75b443130e4b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efra document" ma:contentTypeID="0x010100A5BF1C78D9F64B679A5EBDE1C6598EBC010036DCBB282D0B6744BB95C07F4C50F1A1" ma:contentTypeVersion="29" ma:contentTypeDescription="Create a new document." ma:contentTypeScope="" ma:versionID="5cdb1216019797d55aa2c491faf8f29f">
  <xsd:schema xmlns:xsd="http://www.w3.org/2001/XMLSchema" xmlns:xs="http://www.w3.org/2001/XMLSchema" xmlns:p="http://schemas.microsoft.com/office/2006/metadata/properties" xmlns:ns2="662745e8-e224-48e8-a2e3-254862b8c2f5" xmlns:ns3="2a9c46a1-a1df-4fee-bf10-75b443130e4b" xmlns:ns4="555ed169-aac3-430e-bb04-17c1227728d7" targetNamespace="http://schemas.microsoft.com/office/2006/metadata/properties" ma:root="true" ma:fieldsID="180871872dacb393c69eeeb759969758" ns2:_="" ns3:_="" ns4:_="">
    <xsd:import namespace="662745e8-e224-48e8-a2e3-254862b8c2f5"/>
    <xsd:import namespace="2a9c46a1-a1df-4fee-bf10-75b443130e4b"/>
    <xsd:import namespace="555ed169-aac3-430e-bb04-17c1227728d7"/>
    <xsd:element name="properties">
      <xsd:complexType>
        <xsd:sequence>
          <xsd:element name="documentManagement">
            <xsd:complexType>
              <xsd:all>
                <xsd:element ref="ns2:lae2bfa7b6474897ab4a53f76ea236c7" minOccurs="0"/>
                <xsd:element ref="ns2:TaxCatchAll" minOccurs="0"/>
                <xsd:element ref="ns2:TaxCatchAllLabel" minOccurs="0"/>
                <xsd:element ref="ns2:cf401361b24e474cb011be6eb76c0e76" minOccurs="0"/>
                <xsd:element ref="ns2:n7493b4506bf40e28c373b1e51a33445" minOccurs="0"/>
                <xsd:element ref="ns2:HOMigrated" minOccurs="0"/>
                <xsd:element ref="ns2:k85d23755b3a46b5a51451cf336b2e9b" minOccurs="0"/>
                <xsd:element ref="ns2:Team" minOccurs="0"/>
                <xsd:element ref="ns2:Topic" minOccurs="0"/>
                <xsd:element ref="ns2:ddeb1fd0a9ad4436a96525d34737dc44" minOccurs="0"/>
                <xsd:element ref="ns2:fe59e9859d6a491389c5b03567f5dda5" minOccurs="0"/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4:SharedWithUsers" minOccurs="0"/>
                <xsd:element ref="ns4:SharedWithDetails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Dat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62745e8-e224-48e8-a2e3-254862b8c2f5" elementFormDefault="qualified">
    <xsd:import namespace="http://schemas.microsoft.com/office/2006/documentManagement/types"/>
    <xsd:import namespace="http://schemas.microsoft.com/office/infopath/2007/PartnerControls"/>
    <xsd:element name="lae2bfa7b6474897ab4a53f76ea236c7" ma:index="8" ma:taxonomy="true" ma:internalName="lae2bfa7b6474897ab4a53f76ea236c7" ma:taxonomyFieldName="HOGovernmentSecurityClassification" ma:displayName="Government Security Classification" ma:readOnly="false" ma:default="2;#Official|14c80daa-741b-422c-9722-f71693c9ede4" ma:fieldId="{5ae2bfa7-b647-4897-ab4a-53f76ea236c7}" ma:sspId="d1117845-93f6-4da3-abaa-fcb4fa669c78" ma:termSetId="56209604-fc17-4ace-9b7b-f45f0f17d50b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TaxCatchAll" ma:index="9" nillable="true" ma:displayName="Taxonomy Catch All Column" ma:hidden="true" ma:list="{554f39ce-6154-43a8-868f-95aa0103ebc3}" ma:internalName="TaxCatchAll" ma:showField="CatchAllData" ma:web="555ed169-aac3-430e-bb04-17c1227728d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TaxCatchAllLabel" ma:index="10" nillable="true" ma:displayName="Taxonomy Catch All Column1" ma:hidden="true" ma:list="{554f39ce-6154-43a8-868f-95aa0103ebc3}" ma:internalName="TaxCatchAllLabel" ma:readOnly="true" ma:showField="CatchAllDataLabel" ma:web="555ed169-aac3-430e-bb04-17c1227728d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cf401361b24e474cb011be6eb76c0e76" ma:index="12" ma:taxonomy="true" ma:internalName="cf401361b24e474cb011be6eb76c0e76" ma:taxonomyFieldName="HOCopyrightLevel" ma:displayName="Copyright level" ma:readOnly="false" ma:default="1;#Crown|69589897-2828-4761-976e-717fd8e631c9" ma:fieldId="{cf401361-b24e-474c-b011-be6eb76c0e76}" ma:sspId="d1117845-93f6-4da3-abaa-fcb4fa669c78" ma:termSetId="bdd694c6-7266-48f2-93d6-d15992cd203e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n7493b4506bf40e28c373b1e51a33445" ma:index="14" nillable="true" ma:taxonomy="true" ma:internalName="n7493b4506bf40e28c373b1e51a33445" ma:taxonomyFieldName="HOSiteType" ma:displayName="Site type" ma:default="6;#Team|ff0485df-0575-416f-802f-e999165821b7" ma:fieldId="{77493b45-06bf-40e2-8c37-3b1e51a33445}" ma:sspId="d1117845-93f6-4da3-abaa-fcb4fa669c78" ma:termSetId="4518b03a-1a05-49af-8bf2-e5548589f21b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HOMigrated" ma:index="16" nillable="true" ma:displayName="Migrated" ma:default="0" ma:internalName="HOMigrated">
      <xsd:simpleType>
        <xsd:restriction base="dms:Boolean"/>
      </xsd:simpleType>
    </xsd:element>
    <xsd:element name="k85d23755b3a46b5a51451cf336b2e9b" ma:index="17" nillable="true" ma:taxonomy="true" ma:internalName="k85d23755b3a46b5a51451cf336b2e9b" ma:taxonomyFieldName="InformationType" ma:displayName="Information Type" ma:fieldId="{485d2375-5b3a-46b5-a514-51cf336b2e9b}" ma:sspId="d1117845-93f6-4da3-abaa-fcb4fa669c78" ma:termSetId="75cb3767-2327-4339-b999-281b3f58ac0a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Team" ma:index="19" nillable="true" ma:displayName="Team" ma:default="Virology" ma:internalName="Team">
      <xsd:simpleType>
        <xsd:restriction base="dms:Text"/>
      </xsd:simpleType>
    </xsd:element>
    <xsd:element name="Topic" ma:index="20" nillable="true" ma:displayName="Topic" ma:default="VI6 - Outputs" ma:internalName="Topic">
      <xsd:simpleType>
        <xsd:restriction base="dms:Text"/>
      </xsd:simpleType>
    </xsd:element>
    <xsd:element name="ddeb1fd0a9ad4436a96525d34737dc44" ma:index="21" nillable="true" ma:taxonomy="true" ma:internalName="ddeb1fd0a9ad4436a96525d34737dc44" ma:taxonomyFieldName="Distribution" ma:displayName="Distribution" ma:default="5;#Internal APHA|c4c48635-cc8c-496b-abb6-4a15e2e963ca" ma:fieldId="{ddeb1fd0-a9ad-4436-a965-25d34737dc44}" ma:sspId="d1117845-93f6-4da3-abaa-fcb4fa669c78" ma:termSetId="9c8b5dbf-8bad-46e4-8055-6e01c16178d6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fe59e9859d6a491389c5b03567f5dda5" ma:index="23" nillable="true" ma:taxonomy="true" ma:internalName="fe59e9859d6a491389c5b03567f5dda5" ma:taxonomyFieldName="OrganisationalUnit" ma:displayName="Organisational Unit" ma:default="3;#APHA|8cfe9d61-c27f-47b7-a138-543088555a27" ma:fieldId="{fe59e985-9d6a-4913-89c5-b03567f5dda5}" ma:sspId="d1117845-93f6-4da3-abaa-fcb4fa669c78" ma:termSetId="55eb802e-fbca-455b-a7d2-d5919d4ea3d2" ma:anchorId="00000000-0000-0000-0000-000000000000" ma:open="fals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a9c46a1-a1df-4fee-bf10-75b443130e4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25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26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27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GenerationTime" ma:index="3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31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32" nillable="true" ma:displayName="MediaLengthInSeconds" ma:hidden="true" ma:internalName="MediaLengthInSeconds" ma:readOnly="true">
      <xsd:simpleType>
        <xsd:restriction base="dms:Unknown"/>
      </xsd:simpleType>
    </xsd:element>
    <xsd:element name="Date" ma:index="33" nillable="true" ma:displayName="Date" ma:format="DateOnly" ma:internalName="Date">
      <xsd:simpleType>
        <xsd:restriction base="dms:DateTim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55ed169-aac3-430e-bb04-17c1227728d7" elementFormDefault="qualified">
    <xsd:import namespace="http://schemas.microsoft.com/office/2006/documentManagement/types"/>
    <xsd:import namespace="http://schemas.microsoft.com/office/infopath/2007/PartnerControls"/>
    <xsd:element name="SharedWithUsers" ma:index="2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4.xml><?xml version="1.0" encoding="utf-8"?>
<?mso-contentType ?>
<SharedContentType xmlns="Microsoft.SharePoint.Taxonomy.ContentTypeSync" SourceId="d1117845-93f6-4da3-abaa-fcb4fa669c78" ContentTypeId="0x010100A5BF1C78D9F64B679A5EBDE1C6598EBC01" PreviousValue="false" LastSyncTimeStamp="2022-12-23T12:39:58.22Z"/>
</file>

<file path=customXml/itemProps1.xml><?xml version="1.0" encoding="utf-8"?>
<ds:datastoreItem xmlns:ds="http://schemas.openxmlformats.org/officeDocument/2006/customXml" ds:itemID="{65ADC0E7-158C-4E7D-AA70-28FC4BD5BD63}">
  <ds:schemaRefs>
    <ds:schemaRef ds:uri="4b91dfef-73db-4f4b-971d-e549e6c0583a"/>
    <ds:schemaRef ds:uri="662745e8-e224-48e8-a2e3-254862b8c2f5"/>
    <ds:schemaRef ds:uri="d0badc19-de2b-4803-95df-a83d4f784947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  <ds:schemaRef ds:uri="2a9c46a1-a1df-4fee-bf10-75b443130e4b"/>
  </ds:schemaRefs>
</ds:datastoreItem>
</file>

<file path=customXml/itemProps2.xml><?xml version="1.0" encoding="utf-8"?>
<ds:datastoreItem xmlns:ds="http://schemas.openxmlformats.org/officeDocument/2006/customXml" ds:itemID="{83FE75BB-7CD3-416A-8BB7-D5FE1F675EE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62745e8-e224-48e8-a2e3-254862b8c2f5"/>
    <ds:schemaRef ds:uri="2a9c46a1-a1df-4fee-bf10-75b443130e4b"/>
    <ds:schemaRef ds:uri="555ed169-aac3-430e-bb04-17c1227728d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C333E9B6-6DAA-42B2-BB44-2F470AC5363C}">
  <ds:schemaRefs>
    <ds:schemaRef ds:uri="http://schemas.microsoft.com/sharepoint/v3/contenttype/forms"/>
  </ds:schemaRefs>
</ds:datastoreItem>
</file>

<file path=customXml/itemProps4.xml><?xml version="1.0" encoding="utf-8"?>
<ds:datastoreItem xmlns:ds="http://schemas.openxmlformats.org/officeDocument/2006/customXml" ds:itemID="{36C32C6F-1D43-4F13-8AC5-9AB19B7FF743}">
  <ds:schemaRefs>
    <ds:schemaRef ds:uri="Microsoft.SharePoint.Taxonomy.ContentTypeSync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0</TotalTime>
  <Words>810</Words>
  <Application>Microsoft Office PowerPoint</Application>
  <PresentationFormat>Widescreen</PresentationFormat>
  <Paragraphs>48</Paragraphs>
  <Slides>8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ekings, Amanda</dc:creator>
  <cp:lastModifiedBy>Slomka, Marek</cp:lastModifiedBy>
  <cp:revision>1</cp:revision>
  <dcterms:created xsi:type="dcterms:W3CDTF">2022-03-22T16:06:39Z</dcterms:created>
  <dcterms:modified xsi:type="dcterms:W3CDTF">2023-09-21T22:08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6a2630e2-1ac5-455e-8217-0156b1936a76_Enabled">
    <vt:lpwstr>true</vt:lpwstr>
  </property>
  <property fmtid="{D5CDD505-2E9C-101B-9397-08002B2CF9AE}" pid="3" name="MSIP_Label_6a2630e2-1ac5-455e-8217-0156b1936a76_SetDate">
    <vt:lpwstr>2022-05-30T06:48:48Z</vt:lpwstr>
  </property>
  <property fmtid="{D5CDD505-2E9C-101B-9397-08002B2CF9AE}" pid="4" name="MSIP_Label_6a2630e2-1ac5-455e-8217-0156b1936a76_Method">
    <vt:lpwstr>Standard</vt:lpwstr>
  </property>
  <property fmtid="{D5CDD505-2E9C-101B-9397-08002B2CF9AE}" pid="5" name="MSIP_Label_6a2630e2-1ac5-455e-8217-0156b1936a76_Name">
    <vt:lpwstr>Notclass</vt:lpwstr>
  </property>
  <property fmtid="{D5CDD505-2E9C-101B-9397-08002B2CF9AE}" pid="6" name="MSIP_Label_6a2630e2-1ac5-455e-8217-0156b1936a76_SiteId">
    <vt:lpwstr>a3927f91-cda1-4696-af89-8c9f1ceffa91</vt:lpwstr>
  </property>
  <property fmtid="{D5CDD505-2E9C-101B-9397-08002B2CF9AE}" pid="7" name="MSIP_Label_6a2630e2-1ac5-455e-8217-0156b1936a76_ActionId">
    <vt:lpwstr>65c0f21d-9726-4572-80a4-faf211da803c</vt:lpwstr>
  </property>
  <property fmtid="{D5CDD505-2E9C-101B-9397-08002B2CF9AE}" pid="8" name="MSIP_Label_6a2630e2-1ac5-455e-8217-0156b1936a76_ContentBits">
    <vt:lpwstr>0</vt:lpwstr>
  </property>
  <property fmtid="{D5CDD505-2E9C-101B-9397-08002B2CF9AE}" pid="9" name="MediaServiceImageTags">
    <vt:lpwstr/>
  </property>
  <property fmtid="{D5CDD505-2E9C-101B-9397-08002B2CF9AE}" pid="10" name="InformationType">
    <vt:lpwstr/>
  </property>
  <property fmtid="{D5CDD505-2E9C-101B-9397-08002B2CF9AE}" pid="11" name="Distribution">
    <vt:lpwstr>5;#Internal APHA|c4c48635-cc8c-496b-abb6-4a15e2e963ca</vt:lpwstr>
  </property>
  <property fmtid="{D5CDD505-2E9C-101B-9397-08002B2CF9AE}" pid="12" name="HOCopyrightLevel">
    <vt:lpwstr>1;#Crown|69589897-2828-4761-976e-717fd8e631c9</vt:lpwstr>
  </property>
  <property fmtid="{D5CDD505-2E9C-101B-9397-08002B2CF9AE}" pid="13" name="HOGovernmentSecurityClassification">
    <vt:lpwstr>2;#Official|14c80daa-741b-422c-9722-f71693c9ede4</vt:lpwstr>
  </property>
  <property fmtid="{D5CDD505-2E9C-101B-9397-08002B2CF9AE}" pid="14" name="HOSiteType">
    <vt:lpwstr>6;#Team|ff0485df-0575-416f-802f-e999165821b7</vt:lpwstr>
  </property>
  <property fmtid="{D5CDD505-2E9C-101B-9397-08002B2CF9AE}" pid="15" name="OrganisationalUnit">
    <vt:lpwstr>3;#APHA|8cfe9d61-c27f-47b7-a138-543088555a27</vt:lpwstr>
  </property>
  <property fmtid="{D5CDD505-2E9C-101B-9397-08002B2CF9AE}" pid="16" name="ContentTypeId">
    <vt:lpwstr>0x010100A5BF1C78D9F64B679A5EBDE1C6598EBC010036DCBB282D0B6744BB95C07F4C50F1A1</vt:lpwstr>
  </property>
</Properties>
</file>